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62" r:id="rId2"/>
    <p:sldId id="263" r:id="rId3"/>
    <p:sldId id="264" r:id="rId4"/>
    <p:sldId id="278" r:id="rId5"/>
    <p:sldId id="284" r:id="rId6"/>
  </p:sldIdLst>
  <p:sldSz cx="6858000" cy="9144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476" userDrawn="1">
          <p15:clr>
            <a:srgbClr val="A4A3A4"/>
          </p15:clr>
        </p15:guide>
        <p15:guide id="2" pos="309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8E4BBF7F-74E7-7559-CB21-F9C331640ADE}" name="sarah frusciante" initials="sf" userId="86ca6520e161e73c" providerId="Windows Live"/>
  <p188:author id="{E6772385-8D64-21E6-1D25-D636941DCA53}" name="Olivia Costantina Demurtas" initials="OD" userId="S::olivia.demurtas@enea.it::7b51e76d-c233-4075-97be-3a0bd3e9ff42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3333"/>
    <a:srgbClr val="999999"/>
    <a:srgbClr val="660099"/>
    <a:srgbClr val="92F2DA"/>
    <a:srgbClr val="CC00CC"/>
    <a:srgbClr val="006666"/>
    <a:srgbClr val="FF9900"/>
    <a:srgbClr val="CB181D"/>
    <a:srgbClr val="225EA8"/>
    <a:srgbClr val="008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Stile chiaro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Stile chi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D27102A9-8310-4765-A935-A1911B00CA55}" styleName="Stile chiaro 1 - Colore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48"/>
    <p:restoredTop sz="91293"/>
  </p:normalViewPr>
  <p:slideViewPr>
    <p:cSldViewPr snapToGrid="0" snapToObjects="1" showGuides="1">
      <p:cViewPr varScale="1">
        <p:scale>
          <a:sx n="84" d="100"/>
          <a:sy n="84" d="100"/>
        </p:scale>
        <p:origin x="2128" y="184"/>
      </p:cViewPr>
      <p:guideLst>
        <p:guide orient="horz" pos="5476"/>
        <p:guide pos="3090"/>
      </p:guideLst>
    </p:cSldViewPr>
  </p:slideViewPr>
  <p:notesTextViewPr>
    <p:cViewPr>
      <p:scale>
        <a:sx n="20" d="100"/>
        <a:sy n="2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5BEB0E-1742-314D-98B0-1053CAC606EB}" type="datetimeFigureOut">
              <a:rPr lang="it-IT" smtClean="0"/>
              <a:t>25/03/26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559A11-76F8-8A4B-A1C5-BF6642CFB59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129079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9DBA3EF-409A-E34B-B747-39BBFBDF5000}" type="slidenum">
              <a:rPr lang="it-IT" smtClean="0"/>
              <a:pPr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733842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9DBA3EF-409A-E34B-B747-39BBFBDF5000}" type="slidenum">
              <a:rPr lang="it-IT" smtClean="0"/>
              <a:pPr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7696711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0559A11-76F8-8A4B-A1C5-BF6642CFB59B}" type="slidenum">
              <a:rPr lang="it-IT" smtClean="0"/>
              <a:t>5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422802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9CD8B-A1EA-424B-9579-3198DB6AD399}" type="datetimeFigureOut">
              <a:rPr lang="it-IT" smtClean="0"/>
              <a:t>25/03/2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E2BC2-567C-E241-9FF6-F8B8FAE2D6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713341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9CD8B-A1EA-424B-9579-3198DB6AD399}" type="datetimeFigureOut">
              <a:rPr lang="it-IT" smtClean="0"/>
              <a:t>25/03/2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E2BC2-567C-E241-9FF6-F8B8FAE2D6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736297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9CD8B-A1EA-424B-9579-3198DB6AD399}" type="datetimeFigureOut">
              <a:rPr lang="it-IT" smtClean="0"/>
              <a:t>25/03/2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E2BC2-567C-E241-9FF6-F8B8FAE2D6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3007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9CD8B-A1EA-424B-9579-3198DB6AD399}" type="datetimeFigureOut">
              <a:rPr lang="it-IT" smtClean="0"/>
              <a:t>25/03/2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E2BC2-567C-E241-9FF6-F8B8FAE2D6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619466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stile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9CD8B-A1EA-424B-9579-3198DB6AD399}" type="datetimeFigureOut">
              <a:rPr lang="it-IT" smtClean="0"/>
              <a:t>25/03/2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E2BC2-567C-E241-9FF6-F8B8FAE2D6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209351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9CD8B-A1EA-424B-9579-3198DB6AD399}" type="datetimeFigureOut">
              <a:rPr lang="it-IT" smtClean="0"/>
              <a:t>25/03/2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E2BC2-567C-E241-9FF6-F8B8FAE2D6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25960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/>
              <a:t>Fare clic per modificare stile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9CD8B-A1EA-424B-9579-3198DB6AD399}" type="datetimeFigureOut">
              <a:rPr lang="it-IT" smtClean="0"/>
              <a:t>25/03/26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E2BC2-567C-E241-9FF6-F8B8FAE2D6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86952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9CD8B-A1EA-424B-9579-3198DB6AD399}" type="datetimeFigureOut">
              <a:rPr lang="it-IT" smtClean="0"/>
              <a:t>25/03/26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E2BC2-567C-E241-9FF6-F8B8FAE2D6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01128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9CD8B-A1EA-424B-9579-3198DB6AD399}" type="datetimeFigureOut">
              <a:rPr lang="it-IT" smtClean="0"/>
              <a:t>25/03/26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E2BC2-567C-E241-9FF6-F8B8FAE2D6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801850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stile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9CD8B-A1EA-424B-9579-3198DB6AD399}" type="datetimeFigureOut">
              <a:rPr lang="it-IT" smtClean="0"/>
              <a:t>25/03/2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E2BC2-567C-E241-9FF6-F8B8FAE2D6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277988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stile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9CD8B-A1EA-424B-9579-3198DB6AD399}" type="datetimeFigureOut">
              <a:rPr lang="it-IT" smtClean="0"/>
              <a:t>25/03/2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E2BC2-567C-E241-9FF6-F8B8FAE2D6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502183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F9CD8B-A1EA-424B-9579-3198DB6AD399}" type="datetimeFigureOut">
              <a:rPr lang="it-IT" smtClean="0"/>
              <a:t>25/03/2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0E2BC2-567C-E241-9FF6-F8B8FAE2D6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169611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emf"/><Relationship Id="rId4" Type="http://schemas.openxmlformats.org/officeDocument/2006/relationships/image" Target="../media/image1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2.emf"/><Relationship Id="rId4" Type="http://schemas.openxmlformats.org/officeDocument/2006/relationships/image" Target="../media/image2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Gruppo 38"/>
          <p:cNvGrpSpPr/>
          <p:nvPr/>
        </p:nvGrpSpPr>
        <p:grpSpPr>
          <a:xfrm>
            <a:off x="1332480" y="1151981"/>
            <a:ext cx="3435015" cy="1029494"/>
            <a:chOff x="1157770" y="1281877"/>
            <a:chExt cx="3721266" cy="1115286"/>
          </a:xfrm>
        </p:grpSpPr>
        <p:sp>
          <p:nvSpPr>
            <p:cNvPr id="4" name="Rettangolo 3"/>
            <p:cNvSpPr/>
            <p:nvPr/>
          </p:nvSpPr>
          <p:spPr>
            <a:xfrm>
              <a:off x="1729163" y="1740253"/>
              <a:ext cx="2870200" cy="180000"/>
            </a:xfrm>
            <a:prstGeom prst="rect">
              <a:avLst/>
            </a:prstGeom>
            <a:noFill/>
            <a:ln w="1270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662"/>
            </a:p>
          </p:txBody>
        </p:sp>
        <p:sp>
          <p:nvSpPr>
            <p:cNvPr id="5" name="Rettangolo 4"/>
            <p:cNvSpPr/>
            <p:nvPr/>
          </p:nvSpPr>
          <p:spPr>
            <a:xfrm>
              <a:off x="1970464" y="1740253"/>
              <a:ext cx="433931" cy="180000"/>
            </a:xfrm>
            <a:prstGeom prst="rect">
              <a:avLst/>
            </a:prstGeom>
            <a:solidFill>
              <a:schemeClr val="tx1"/>
            </a:solidFill>
            <a:ln w="19050" cmpd="sng"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662"/>
            </a:p>
          </p:txBody>
        </p:sp>
        <p:sp>
          <p:nvSpPr>
            <p:cNvPr id="9" name="CasellaDiTesto 8"/>
            <p:cNvSpPr txBox="1"/>
            <p:nvPr/>
          </p:nvSpPr>
          <p:spPr>
            <a:xfrm>
              <a:off x="4230942" y="1521791"/>
              <a:ext cx="648094" cy="2385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31" dirty="0">
                  <a:latin typeface="Arial"/>
                  <a:cs typeface="Arial"/>
                </a:rPr>
                <a:t>3302  bp</a:t>
              </a:r>
            </a:p>
          </p:txBody>
        </p:sp>
        <p:sp>
          <p:nvSpPr>
            <p:cNvPr id="11" name="Rettangolo 10"/>
            <p:cNvSpPr/>
            <p:nvPr/>
          </p:nvSpPr>
          <p:spPr>
            <a:xfrm>
              <a:off x="4150660" y="1740253"/>
              <a:ext cx="325929" cy="180000"/>
            </a:xfrm>
            <a:prstGeom prst="rect">
              <a:avLst/>
            </a:prstGeom>
            <a:solidFill>
              <a:schemeClr val="tx1"/>
            </a:solidFill>
            <a:ln w="19050" cmpd="sng"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662"/>
            </a:p>
          </p:txBody>
        </p:sp>
        <p:sp>
          <p:nvSpPr>
            <p:cNvPr id="12" name="Rettangolo 11"/>
            <p:cNvSpPr/>
            <p:nvPr/>
          </p:nvSpPr>
          <p:spPr>
            <a:xfrm>
              <a:off x="2611814" y="1740253"/>
              <a:ext cx="181928" cy="180000"/>
            </a:xfrm>
            <a:prstGeom prst="rect">
              <a:avLst/>
            </a:prstGeom>
            <a:solidFill>
              <a:schemeClr val="tx1"/>
            </a:solidFill>
            <a:ln w="19050" cmpd="sng"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662"/>
            </a:p>
          </p:txBody>
        </p:sp>
        <p:sp>
          <p:nvSpPr>
            <p:cNvPr id="14" name="Rettangolo 13"/>
            <p:cNvSpPr/>
            <p:nvPr/>
          </p:nvSpPr>
          <p:spPr>
            <a:xfrm>
              <a:off x="3570664" y="1740253"/>
              <a:ext cx="181928" cy="180000"/>
            </a:xfrm>
            <a:prstGeom prst="rect">
              <a:avLst/>
            </a:prstGeom>
            <a:solidFill>
              <a:schemeClr val="tx1"/>
            </a:solidFill>
            <a:ln w="19050" cmpd="sng"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662"/>
            </a:p>
          </p:txBody>
        </p:sp>
        <p:sp>
          <p:nvSpPr>
            <p:cNvPr id="15" name="Rettangolo 14"/>
            <p:cNvSpPr/>
            <p:nvPr/>
          </p:nvSpPr>
          <p:spPr>
            <a:xfrm>
              <a:off x="2984347" y="1740253"/>
              <a:ext cx="217928" cy="180000"/>
            </a:xfrm>
            <a:prstGeom prst="rect">
              <a:avLst/>
            </a:prstGeom>
            <a:solidFill>
              <a:schemeClr val="tx1"/>
            </a:solidFill>
            <a:ln w="19050" cmpd="sng"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662"/>
            </a:p>
          </p:txBody>
        </p:sp>
        <p:grpSp>
          <p:nvGrpSpPr>
            <p:cNvPr id="24" name="Gruppo 23"/>
            <p:cNvGrpSpPr/>
            <p:nvPr/>
          </p:nvGrpSpPr>
          <p:grpSpPr>
            <a:xfrm>
              <a:off x="2187429" y="1541284"/>
              <a:ext cx="108000" cy="196850"/>
              <a:chOff x="851966" y="683664"/>
              <a:chExt cx="108000" cy="196850"/>
            </a:xfrm>
          </p:grpSpPr>
          <p:cxnSp>
            <p:nvCxnSpPr>
              <p:cNvPr id="22" name="Connettore 1 21"/>
              <p:cNvCxnSpPr/>
              <p:nvPr/>
            </p:nvCxnSpPr>
            <p:spPr>
              <a:xfrm flipV="1">
                <a:off x="851966" y="683664"/>
                <a:ext cx="0" cy="19685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Connettore 1 22"/>
              <p:cNvCxnSpPr/>
              <p:nvPr/>
            </p:nvCxnSpPr>
            <p:spPr>
              <a:xfrm rot="5400000" flipV="1">
                <a:off x="905966" y="633917"/>
                <a:ext cx="0" cy="10800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  <a:headEnd type="none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5" name="CasellaDiTesto 24"/>
            <p:cNvSpPr txBox="1"/>
            <p:nvPr/>
          </p:nvSpPr>
          <p:spPr>
            <a:xfrm>
              <a:off x="1984280" y="1281877"/>
              <a:ext cx="437968" cy="2385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31" dirty="0">
                  <a:latin typeface="Arial"/>
                  <a:cs typeface="Arial"/>
                </a:rPr>
                <a:t>ATG</a:t>
              </a:r>
            </a:p>
          </p:txBody>
        </p:sp>
        <p:cxnSp>
          <p:nvCxnSpPr>
            <p:cNvPr id="26" name="Connettore 1 25"/>
            <p:cNvCxnSpPr/>
            <p:nvPr/>
          </p:nvCxnSpPr>
          <p:spPr>
            <a:xfrm flipV="1">
              <a:off x="4271043" y="1541284"/>
              <a:ext cx="0" cy="19685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CasellaDiTesto 26"/>
            <p:cNvSpPr txBox="1"/>
            <p:nvPr/>
          </p:nvSpPr>
          <p:spPr>
            <a:xfrm>
              <a:off x="4056882" y="1281877"/>
              <a:ext cx="424075" cy="2385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31" dirty="0">
                  <a:latin typeface="Arial"/>
                  <a:cs typeface="Arial"/>
                </a:rPr>
                <a:t>TAA</a:t>
              </a:r>
            </a:p>
          </p:txBody>
        </p:sp>
        <p:cxnSp>
          <p:nvCxnSpPr>
            <p:cNvPr id="28" name="Connettore 1 27"/>
            <p:cNvCxnSpPr/>
            <p:nvPr/>
          </p:nvCxnSpPr>
          <p:spPr>
            <a:xfrm rot="10800000" flipV="1">
              <a:off x="2120782" y="1664110"/>
              <a:ext cx="0" cy="72000"/>
            </a:xfrm>
            <a:prstGeom prst="line">
              <a:avLst/>
            </a:prstGeom>
            <a:ln w="12700" cmpd="sng">
              <a:solidFill>
                <a:schemeClr val="tx1"/>
              </a:solidFill>
              <a:headEnd type="none"/>
              <a:tailEnd type="triangle" w="lg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CasellaDiTesto 28"/>
            <p:cNvSpPr txBox="1"/>
            <p:nvPr/>
          </p:nvSpPr>
          <p:spPr>
            <a:xfrm>
              <a:off x="1850613" y="1477282"/>
              <a:ext cx="411918" cy="2385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31" dirty="0">
                  <a:latin typeface="Arial"/>
                  <a:cs typeface="Arial"/>
                </a:rPr>
                <a:t>Up1</a:t>
              </a:r>
            </a:p>
          </p:txBody>
        </p:sp>
        <p:sp>
          <p:nvSpPr>
            <p:cNvPr id="30" name="CasellaDiTesto 29"/>
            <p:cNvSpPr txBox="1"/>
            <p:nvPr/>
          </p:nvSpPr>
          <p:spPr>
            <a:xfrm>
              <a:off x="2494946" y="1477282"/>
              <a:ext cx="431021" cy="2385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31" dirty="0">
                  <a:latin typeface="Arial"/>
                  <a:cs typeface="Arial"/>
                </a:rPr>
                <a:t>Dw1</a:t>
              </a:r>
            </a:p>
          </p:txBody>
        </p:sp>
        <p:cxnSp>
          <p:nvCxnSpPr>
            <p:cNvPr id="31" name="Connettore 1 30"/>
            <p:cNvCxnSpPr/>
            <p:nvPr/>
          </p:nvCxnSpPr>
          <p:spPr>
            <a:xfrm rot="10800000" flipV="1">
              <a:off x="2702724" y="1664110"/>
              <a:ext cx="0" cy="72000"/>
            </a:xfrm>
            <a:prstGeom prst="line">
              <a:avLst/>
            </a:prstGeom>
            <a:ln w="12700" cmpd="sng">
              <a:solidFill>
                <a:schemeClr val="tx1"/>
              </a:solidFill>
              <a:headEnd type="none"/>
              <a:tailEnd type="triangle" w="lg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CasellaDiTesto 31"/>
            <p:cNvSpPr txBox="1"/>
            <p:nvPr/>
          </p:nvSpPr>
          <p:spPr>
            <a:xfrm>
              <a:off x="1157770" y="1713874"/>
              <a:ext cx="601207" cy="2385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31" i="1" dirty="0">
                  <a:latin typeface="Arial"/>
                  <a:cs typeface="Arial"/>
                </a:rPr>
                <a:t>PSY1</a:t>
              </a:r>
              <a:r>
                <a:rPr lang="it-IT" sz="831" i="1" baseline="30000" dirty="0">
                  <a:latin typeface="Arial"/>
                  <a:cs typeface="Arial"/>
                </a:rPr>
                <a:t>AC</a:t>
              </a:r>
            </a:p>
          </p:txBody>
        </p:sp>
        <p:sp>
          <p:nvSpPr>
            <p:cNvPr id="33" name="CasellaDiTesto 32"/>
            <p:cNvSpPr txBox="1"/>
            <p:nvPr/>
          </p:nvSpPr>
          <p:spPr>
            <a:xfrm>
              <a:off x="1157770" y="2158626"/>
              <a:ext cx="688036" cy="2385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31" i="1" dirty="0">
                  <a:latin typeface="Arial"/>
                  <a:cs typeface="Arial"/>
                </a:rPr>
                <a:t>PSY1</a:t>
              </a:r>
              <a:r>
                <a:rPr lang="it-IT" sz="831" i="1" baseline="30000" dirty="0">
                  <a:latin typeface="Arial"/>
                  <a:cs typeface="Arial"/>
                </a:rPr>
                <a:t>3532 </a:t>
              </a:r>
            </a:p>
          </p:txBody>
        </p:sp>
        <p:sp>
          <p:nvSpPr>
            <p:cNvPr id="34" name="Rettangolo 33"/>
            <p:cNvSpPr/>
            <p:nvPr/>
          </p:nvSpPr>
          <p:spPr>
            <a:xfrm>
              <a:off x="1729163" y="2181788"/>
              <a:ext cx="2700000" cy="180000"/>
            </a:xfrm>
            <a:prstGeom prst="rect">
              <a:avLst/>
            </a:prstGeom>
            <a:noFill/>
            <a:ln w="1270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662"/>
            </a:p>
          </p:txBody>
        </p:sp>
        <p:cxnSp>
          <p:nvCxnSpPr>
            <p:cNvPr id="36" name="Connettore 1 35"/>
            <p:cNvCxnSpPr/>
            <p:nvPr/>
          </p:nvCxnSpPr>
          <p:spPr>
            <a:xfrm flipV="1">
              <a:off x="1729163" y="1920253"/>
              <a:ext cx="566266" cy="261536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Connettore 1 40"/>
            <p:cNvCxnSpPr/>
            <p:nvPr/>
          </p:nvCxnSpPr>
          <p:spPr>
            <a:xfrm flipH="1" flipV="1">
              <a:off x="2494946" y="1920253"/>
              <a:ext cx="1934217" cy="261535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CasellaDiTesto 58"/>
            <p:cNvSpPr txBox="1"/>
            <p:nvPr/>
          </p:nvSpPr>
          <p:spPr>
            <a:xfrm>
              <a:off x="2533544" y="2158626"/>
              <a:ext cx="1103079" cy="2385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31" dirty="0" err="1">
                  <a:latin typeface="Arial"/>
                  <a:cs typeface="Arial"/>
                </a:rPr>
                <a:t>Insertion</a:t>
              </a:r>
              <a:r>
                <a:rPr lang="it-IT" sz="831" dirty="0">
                  <a:latin typeface="Arial"/>
                  <a:cs typeface="Arial"/>
                </a:rPr>
                <a:t> of ~3 Kb</a:t>
              </a:r>
            </a:p>
          </p:txBody>
        </p:sp>
      </p:grpSp>
      <p:grpSp>
        <p:nvGrpSpPr>
          <p:cNvPr id="42" name="Gruppo 41"/>
          <p:cNvGrpSpPr/>
          <p:nvPr/>
        </p:nvGrpSpPr>
        <p:grpSpPr>
          <a:xfrm>
            <a:off x="4391504" y="1128562"/>
            <a:ext cx="1328024" cy="1413094"/>
            <a:chOff x="4607184" y="1222609"/>
            <a:chExt cx="1438693" cy="1530852"/>
          </a:xfrm>
        </p:grpSpPr>
        <p:sp>
          <p:nvSpPr>
            <p:cNvPr id="89" name="CasellaDiTesto 88"/>
            <p:cNvSpPr txBox="1"/>
            <p:nvPr/>
          </p:nvSpPr>
          <p:spPr>
            <a:xfrm>
              <a:off x="4747124" y="1774742"/>
              <a:ext cx="410182" cy="2230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738" dirty="0">
                  <a:latin typeface="Arial"/>
                  <a:cs typeface="Arial"/>
                </a:rPr>
                <a:t>4 Kb</a:t>
              </a:r>
            </a:p>
          </p:txBody>
        </p:sp>
        <p:sp>
          <p:nvSpPr>
            <p:cNvPr id="90" name="CasellaDiTesto 89"/>
            <p:cNvSpPr txBox="1"/>
            <p:nvPr/>
          </p:nvSpPr>
          <p:spPr>
            <a:xfrm>
              <a:off x="4747124" y="1927142"/>
              <a:ext cx="410182" cy="2230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738" dirty="0">
                  <a:latin typeface="Arial"/>
                  <a:cs typeface="Arial"/>
                </a:rPr>
                <a:t>3 Kb</a:t>
              </a:r>
            </a:p>
          </p:txBody>
        </p:sp>
        <p:pic>
          <p:nvPicPr>
            <p:cNvPr id="3" name="Immagine 2" descr="Senza titolo2.png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01837" y="1385469"/>
              <a:ext cx="922050" cy="1367992"/>
            </a:xfrm>
            <a:prstGeom prst="rect">
              <a:avLst/>
            </a:prstGeom>
          </p:spPr>
        </p:pic>
        <p:sp>
          <p:nvSpPr>
            <p:cNvPr id="98" name="CasellaDiTesto 97"/>
            <p:cNvSpPr txBox="1"/>
            <p:nvPr/>
          </p:nvSpPr>
          <p:spPr>
            <a:xfrm>
              <a:off x="4607184" y="2247442"/>
              <a:ext cx="552582" cy="2230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it-IT" sz="738" dirty="0">
                  <a:latin typeface="Arial"/>
                  <a:cs typeface="Arial"/>
                </a:rPr>
                <a:t>1,65 Kb</a:t>
              </a:r>
            </a:p>
          </p:txBody>
        </p:sp>
        <p:sp>
          <p:nvSpPr>
            <p:cNvPr id="99" name="CasellaDiTesto 98"/>
            <p:cNvSpPr txBox="1"/>
            <p:nvPr/>
          </p:nvSpPr>
          <p:spPr>
            <a:xfrm>
              <a:off x="4747124" y="2492517"/>
              <a:ext cx="410183" cy="2230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738" dirty="0">
                  <a:latin typeface="Arial"/>
                  <a:cs typeface="Arial"/>
                </a:rPr>
                <a:t>1 Kb</a:t>
              </a:r>
            </a:p>
          </p:txBody>
        </p:sp>
        <p:cxnSp>
          <p:nvCxnSpPr>
            <p:cNvPr id="100" name="Connettore 1 99"/>
            <p:cNvCxnSpPr/>
            <p:nvPr/>
          </p:nvCxnSpPr>
          <p:spPr>
            <a:xfrm rot="5400000" flipV="1">
              <a:off x="5070527" y="1846464"/>
              <a:ext cx="0" cy="72000"/>
            </a:xfrm>
            <a:prstGeom prst="line">
              <a:avLst/>
            </a:prstGeom>
            <a:ln w="12700" cmpd="sng">
              <a:solidFill>
                <a:schemeClr val="tx1"/>
              </a:solidFill>
              <a:headEnd type="none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Connettore 1 100"/>
            <p:cNvCxnSpPr/>
            <p:nvPr/>
          </p:nvCxnSpPr>
          <p:spPr>
            <a:xfrm rot="5400000" flipV="1">
              <a:off x="5070527" y="1998864"/>
              <a:ext cx="0" cy="72000"/>
            </a:xfrm>
            <a:prstGeom prst="line">
              <a:avLst/>
            </a:prstGeom>
            <a:ln w="12700" cmpd="sng">
              <a:solidFill>
                <a:schemeClr val="tx1"/>
              </a:solidFill>
              <a:headEnd type="none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Connettore 1 122"/>
            <p:cNvCxnSpPr/>
            <p:nvPr/>
          </p:nvCxnSpPr>
          <p:spPr>
            <a:xfrm rot="5400000" flipV="1">
              <a:off x="5070527" y="2316364"/>
              <a:ext cx="0" cy="72000"/>
            </a:xfrm>
            <a:prstGeom prst="line">
              <a:avLst/>
            </a:prstGeom>
            <a:ln w="12700" cmpd="sng">
              <a:solidFill>
                <a:schemeClr val="tx1"/>
              </a:solidFill>
              <a:headEnd type="none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Connettore 1 124"/>
            <p:cNvCxnSpPr/>
            <p:nvPr/>
          </p:nvCxnSpPr>
          <p:spPr>
            <a:xfrm rot="5400000" flipV="1">
              <a:off x="5070527" y="2561898"/>
              <a:ext cx="0" cy="72000"/>
            </a:xfrm>
            <a:prstGeom prst="line">
              <a:avLst/>
            </a:prstGeom>
            <a:ln w="12700" cmpd="sng">
              <a:solidFill>
                <a:schemeClr val="tx1"/>
              </a:solidFill>
              <a:headEnd type="none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CasellaDiTesto 5"/>
            <p:cNvSpPr txBox="1"/>
            <p:nvPr/>
          </p:nvSpPr>
          <p:spPr>
            <a:xfrm>
              <a:off x="5085563" y="1222609"/>
              <a:ext cx="257363" cy="2230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738" dirty="0"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126" name="CasellaDiTesto 125"/>
            <p:cNvSpPr txBox="1"/>
            <p:nvPr/>
          </p:nvSpPr>
          <p:spPr>
            <a:xfrm>
              <a:off x="5269713" y="1222609"/>
              <a:ext cx="257363" cy="2230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738" dirty="0"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128" name="CasellaDiTesto 127"/>
            <p:cNvSpPr txBox="1"/>
            <p:nvPr/>
          </p:nvSpPr>
          <p:spPr>
            <a:xfrm>
              <a:off x="5450314" y="1222609"/>
              <a:ext cx="257363" cy="2230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738" dirty="0"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129" name="CasellaDiTesto 128"/>
            <p:cNvSpPr txBox="1"/>
            <p:nvPr/>
          </p:nvSpPr>
          <p:spPr>
            <a:xfrm>
              <a:off x="5621396" y="1222609"/>
              <a:ext cx="257363" cy="2230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738" dirty="0"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130" name="CasellaDiTesto 129"/>
            <p:cNvSpPr txBox="1"/>
            <p:nvPr/>
          </p:nvSpPr>
          <p:spPr>
            <a:xfrm>
              <a:off x="5788514" y="1222609"/>
              <a:ext cx="257363" cy="2230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738" dirty="0">
                  <a:latin typeface="Arial"/>
                  <a:cs typeface="Arial"/>
                </a:rPr>
                <a:t>5</a:t>
              </a:r>
            </a:p>
          </p:txBody>
        </p:sp>
      </p:grpSp>
      <p:sp>
        <p:nvSpPr>
          <p:cNvPr id="13" name="CasellaDiTesto 12"/>
          <p:cNvSpPr txBox="1"/>
          <p:nvPr/>
        </p:nvSpPr>
        <p:spPr>
          <a:xfrm>
            <a:off x="847780" y="6857268"/>
            <a:ext cx="559190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Figure S1. Organization of </a:t>
            </a:r>
            <a:r>
              <a:rPr lang="en-US" sz="1200" b="1" i="1" dirty="0">
                <a:latin typeface="Calibri" panose="020F0502020204030204" pitchFamily="34" charset="0"/>
                <a:cs typeface="Calibri" panose="020F0502020204030204" pitchFamily="34" charset="0"/>
              </a:rPr>
              <a:t>PSY1</a:t>
            </a:r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 genomic sequence in Ailsa Craig and in </a:t>
            </a:r>
            <a:r>
              <a:rPr lang="en-US" sz="1200" b="1" i="1" dirty="0">
                <a:latin typeface="Calibri" panose="020F0502020204030204" pitchFamily="34" charset="0"/>
                <a:cs typeface="Calibri" panose="020F0502020204030204" pitchFamily="34" charset="0"/>
              </a:rPr>
              <a:t>yellow flesh</a:t>
            </a:r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 LA3532. A.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200" i="1" dirty="0">
                <a:latin typeface="Calibri" panose="020F0502020204030204" pitchFamily="34" charset="0"/>
                <a:cs typeface="Calibri" panose="020F0502020204030204" pitchFamily="34" charset="0"/>
              </a:rPr>
              <a:t>PSY1</a:t>
            </a:r>
            <a:r>
              <a:rPr lang="en-US" sz="1200" baseline="30000" dirty="0">
                <a:latin typeface="Calibri" panose="020F0502020204030204" pitchFamily="34" charset="0"/>
                <a:cs typeface="Calibri" panose="020F0502020204030204" pitchFamily="34" charset="0"/>
              </a:rPr>
              <a:t>3532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 long insertion (≈3 Kb) amplified with Up1/Dw1 primers. Black boxes represent exons. ATG, start codon; TAA, stop codon. </a:t>
            </a:r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. PCR products separated on 0.8% </a:t>
            </a:r>
            <a:r>
              <a:rPr lang="en-US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agarose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 gel: 1. 1 Kb Plus Ladder (Invitrogen); 2. </a:t>
            </a:r>
            <a:r>
              <a:rPr lang="en-US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λ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HindIII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 Ladder; 3.-4. PCR products by Up1-Dw1 primers in AC and LA3532, respectively; 5. C-.</a:t>
            </a:r>
          </a:p>
        </p:txBody>
      </p:sp>
      <p:sp>
        <p:nvSpPr>
          <p:cNvPr id="136" name="CasellaDiTesto 135"/>
          <p:cNvSpPr txBox="1"/>
          <p:nvPr/>
        </p:nvSpPr>
        <p:spPr>
          <a:xfrm>
            <a:off x="1325431" y="1040089"/>
            <a:ext cx="279244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8" dirty="0">
                <a:latin typeface="Arial"/>
                <a:cs typeface="Arial"/>
              </a:rPr>
              <a:t>A</a:t>
            </a:r>
          </a:p>
        </p:txBody>
      </p:sp>
      <p:sp>
        <p:nvSpPr>
          <p:cNvPr id="137" name="CasellaDiTesto 136"/>
          <p:cNvSpPr txBox="1"/>
          <p:nvPr/>
        </p:nvSpPr>
        <p:spPr>
          <a:xfrm>
            <a:off x="4565824" y="1040089"/>
            <a:ext cx="279244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8" dirty="0">
                <a:latin typeface="Arial"/>
                <a:cs typeface="Arial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8642235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CasellaDiTesto 87"/>
          <p:cNvSpPr txBox="1"/>
          <p:nvPr/>
        </p:nvSpPr>
        <p:spPr>
          <a:xfrm>
            <a:off x="462528" y="5451232"/>
            <a:ext cx="598516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igure S2. </a:t>
            </a:r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moter and 5'UTR region analysis </a:t>
            </a:r>
            <a:r>
              <a:rPr lang="it-IT" sz="12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of </a:t>
            </a:r>
            <a:r>
              <a:rPr lang="en-GB" sz="1200" b="1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YC-b </a:t>
            </a:r>
            <a:r>
              <a:rPr lang="en-GB" sz="12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gene</a:t>
            </a:r>
            <a:r>
              <a:rPr lang="en-GB" sz="1200" b="1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.</a:t>
            </a:r>
            <a:endParaRPr lang="it-IT" sz="1200" b="1" dirty="0">
              <a:solidFill>
                <a:srgbClr val="00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just"/>
            <a:r>
              <a:rPr lang="en-GB" sz="12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lustalW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alignment of nucleotide sequences of </a:t>
            </a:r>
            <a:r>
              <a:rPr lang="en-GB" sz="12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YC-b 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moter and 5’ UTR in </a:t>
            </a:r>
            <a:r>
              <a:rPr lang="en-GB" sz="12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. </a:t>
            </a:r>
            <a:r>
              <a:rPr lang="en-GB" sz="1200" i="1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lycopersicum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c 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nd </a:t>
            </a:r>
            <a:r>
              <a:rPr lang="en-GB" sz="12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Beta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. Putative transcriptional factor-binding sites, identified by PLACE software, are highlighted in boxes and numbered (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</a:rPr>
              <a:t>1. RBCSCONSENSUS; 2. CAREOSREP1; 3. CARGATCONSENSUS; 4. PRECONSCRHSP70A; 5. DRE1COREZMRAB17; 6. 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-300CORE), as described in Table S2. Red and black arrows indicates, respectively, the 5’ UTR start and ATG.</a:t>
            </a:r>
          </a:p>
        </p:txBody>
      </p:sp>
      <p:grpSp>
        <p:nvGrpSpPr>
          <p:cNvPr id="3" name="Group 2"/>
          <p:cNvGrpSpPr>
            <a:grpSpLocks noChangeAspect="1"/>
          </p:cNvGrpSpPr>
          <p:nvPr/>
        </p:nvGrpSpPr>
        <p:grpSpPr>
          <a:xfrm>
            <a:off x="462528" y="613994"/>
            <a:ext cx="5985167" cy="4503127"/>
            <a:chOff x="215318" y="665161"/>
            <a:chExt cx="6483931" cy="4878388"/>
          </a:xfrm>
        </p:grpSpPr>
        <p:grpSp>
          <p:nvGrpSpPr>
            <p:cNvPr id="90" name="Gruppo 89"/>
            <p:cNvGrpSpPr/>
            <p:nvPr/>
          </p:nvGrpSpPr>
          <p:grpSpPr>
            <a:xfrm>
              <a:off x="215318" y="665161"/>
              <a:ext cx="6483931" cy="4878388"/>
              <a:chOff x="215319" y="665160"/>
              <a:chExt cx="6483931" cy="4878388"/>
            </a:xfrm>
          </p:grpSpPr>
          <p:grpSp>
            <p:nvGrpSpPr>
              <p:cNvPr id="60" name="Gruppo 59"/>
              <p:cNvGrpSpPr/>
              <p:nvPr/>
            </p:nvGrpSpPr>
            <p:grpSpPr>
              <a:xfrm>
                <a:off x="215319" y="665160"/>
                <a:ext cx="6483931" cy="4878388"/>
                <a:chOff x="304219" y="665160"/>
                <a:chExt cx="6483931" cy="4878388"/>
              </a:xfrm>
            </p:grpSpPr>
            <p:grpSp>
              <p:nvGrpSpPr>
                <p:cNvPr id="46" name="Gruppo 45"/>
                <p:cNvGrpSpPr/>
                <p:nvPr/>
              </p:nvGrpSpPr>
              <p:grpSpPr>
                <a:xfrm>
                  <a:off x="1092200" y="706966"/>
                  <a:ext cx="5695950" cy="4836582"/>
                  <a:chOff x="482600" y="706966"/>
                  <a:chExt cx="5695950" cy="4836582"/>
                </a:xfrm>
              </p:grpSpPr>
              <p:grpSp>
                <p:nvGrpSpPr>
                  <p:cNvPr id="43" name="Gruppo 42"/>
                  <p:cNvGrpSpPr/>
                  <p:nvPr/>
                </p:nvGrpSpPr>
                <p:grpSpPr>
                  <a:xfrm>
                    <a:off x="482600" y="706966"/>
                    <a:ext cx="5695950" cy="4836582"/>
                    <a:chOff x="482600" y="706966"/>
                    <a:chExt cx="5695950" cy="4836582"/>
                  </a:xfrm>
                </p:grpSpPr>
                <p:grpSp>
                  <p:nvGrpSpPr>
                    <p:cNvPr id="32" name="Gruppo 31"/>
                    <p:cNvGrpSpPr/>
                    <p:nvPr/>
                  </p:nvGrpSpPr>
                  <p:grpSpPr>
                    <a:xfrm>
                      <a:off x="482600" y="706966"/>
                      <a:ext cx="5638800" cy="342900"/>
                      <a:chOff x="469900" y="592666"/>
                      <a:chExt cx="5638800" cy="342900"/>
                    </a:xfrm>
                  </p:grpSpPr>
                  <p:pic>
                    <p:nvPicPr>
                      <p:cNvPr id="4" name="Immagine 3" descr="Alignments BETA.pdf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0126" t="6977" r="11555" b="89015"/>
                      <a:stretch/>
                    </p:blipFill>
                    <p:spPr>
                      <a:xfrm>
                        <a:off x="469900" y="592666"/>
                        <a:ext cx="2921000" cy="34290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7" name="Immagine 6" descr="Alignments BETA.pdf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0126" t="12025" r="11555" b="83967"/>
                      <a:stretch/>
                    </p:blipFill>
                    <p:spPr>
                      <a:xfrm>
                        <a:off x="3187700" y="592666"/>
                        <a:ext cx="2921000" cy="342900"/>
                      </a:xfrm>
                      <a:prstGeom prst="rect">
                        <a:avLst/>
                      </a:prstGeom>
                    </p:spPr>
                  </p:pic>
                </p:grpSp>
                <p:grpSp>
                  <p:nvGrpSpPr>
                    <p:cNvPr id="33" name="Gruppo 32"/>
                    <p:cNvGrpSpPr/>
                    <p:nvPr/>
                  </p:nvGrpSpPr>
                  <p:grpSpPr>
                    <a:xfrm>
                      <a:off x="482600" y="1076998"/>
                      <a:ext cx="5638800" cy="429684"/>
                      <a:chOff x="469900" y="899582"/>
                      <a:chExt cx="5638800" cy="429684"/>
                    </a:xfrm>
                  </p:grpSpPr>
                  <p:pic>
                    <p:nvPicPr>
                      <p:cNvPr id="6" name="Immagine 5" descr="Alignments BETA.pdf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0126" t="16776" r="11555" b="78622"/>
                      <a:stretch/>
                    </p:blipFill>
                    <p:spPr>
                      <a:xfrm>
                        <a:off x="469900" y="935566"/>
                        <a:ext cx="2921000" cy="39370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8" name="Immagine 7" descr="Alignments BETA.pdf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0126" t="21377" r="11556" b="74021"/>
                      <a:stretch/>
                    </p:blipFill>
                    <p:spPr>
                      <a:xfrm>
                        <a:off x="3187700" y="899582"/>
                        <a:ext cx="2921000" cy="393700"/>
                      </a:xfrm>
                      <a:prstGeom prst="rect">
                        <a:avLst/>
                      </a:prstGeom>
                    </p:spPr>
                  </p:pic>
                </p:grpSp>
                <p:grpSp>
                  <p:nvGrpSpPr>
                    <p:cNvPr id="34" name="Gruppo 33"/>
                    <p:cNvGrpSpPr/>
                    <p:nvPr/>
                  </p:nvGrpSpPr>
                  <p:grpSpPr>
                    <a:xfrm>
                      <a:off x="482600" y="1457614"/>
                      <a:ext cx="5638800" cy="406400"/>
                      <a:chOff x="469900" y="1329266"/>
                      <a:chExt cx="5638800" cy="406400"/>
                    </a:xfrm>
                  </p:grpSpPr>
                  <p:pic>
                    <p:nvPicPr>
                      <p:cNvPr id="5" name="Immagine 4" descr="Alignments BETA.pdf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0126" t="26277" r="11555" b="68973"/>
                      <a:stretch/>
                    </p:blipFill>
                    <p:spPr>
                      <a:xfrm>
                        <a:off x="469900" y="1329266"/>
                        <a:ext cx="2921000" cy="40640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9" name="Immagine 8" descr="Alignments BETA.pdf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0126" t="32066" r="11555" b="63925"/>
                      <a:stretch/>
                    </p:blipFill>
                    <p:spPr>
                      <a:xfrm>
                        <a:off x="3187700" y="1392766"/>
                        <a:ext cx="2921000" cy="342900"/>
                      </a:xfrm>
                      <a:prstGeom prst="rect">
                        <a:avLst/>
                      </a:prstGeom>
                    </p:spPr>
                  </p:pic>
                </p:grpSp>
                <p:grpSp>
                  <p:nvGrpSpPr>
                    <p:cNvPr id="35" name="Gruppo 34"/>
                    <p:cNvGrpSpPr/>
                    <p:nvPr/>
                  </p:nvGrpSpPr>
                  <p:grpSpPr>
                    <a:xfrm>
                      <a:off x="482600" y="1903846"/>
                      <a:ext cx="5638800" cy="368300"/>
                      <a:chOff x="469900" y="1716616"/>
                      <a:chExt cx="5638800" cy="368300"/>
                    </a:xfrm>
                  </p:grpSpPr>
                  <p:pic>
                    <p:nvPicPr>
                      <p:cNvPr id="10" name="Immagine 9" descr="Alignments BETA.pdf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0126" t="37114" r="11555" b="58878"/>
                      <a:stretch/>
                    </p:blipFill>
                    <p:spPr>
                      <a:xfrm>
                        <a:off x="469900" y="1735666"/>
                        <a:ext cx="2921000" cy="34290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11" name="Immagine 10" descr="Alignments BETA.pdf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0126" t="41863" r="11555" b="53832"/>
                      <a:stretch/>
                    </p:blipFill>
                    <p:spPr>
                      <a:xfrm>
                        <a:off x="3187700" y="1716616"/>
                        <a:ext cx="2921000" cy="368300"/>
                      </a:xfrm>
                      <a:prstGeom prst="rect">
                        <a:avLst/>
                      </a:prstGeom>
                    </p:spPr>
                  </p:pic>
                </p:grpSp>
                <p:grpSp>
                  <p:nvGrpSpPr>
                    <p:cNvPr id="37" name="Gruppo 36"/>
                    <p:cNvGrpSpPr/>
                    <p:nvPr/>
                  </p:nvGrpSpPr>
                  <p:grpSpPr>
                    <a:xfrm>
                      <a:off x="482600" y="2762444"/>
                      <a:ext cx="5638800" cy="355600"/>
                      <a:chOff x="469900" y="2400299"/>
                      <a:chExt cx="5638800" cy="355600"/>
                    </a:xfrm>
                  </p:grpSpPr>
                  <p:pic>
                    <p:nvPicPr>
                      <p:cNvPr id="14" name="Immagine 13" descr="Alignments BETA.pdf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1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0126" t="56903" r="11555" b="38941"/>
                      <a:stretch/>
                    </p:blipFill>
                    <p:spPr>
                      <a:xfrm>
                        <a:off x="469900" y="2400299"/>
                        <a:ext cx="2921000" cy="35560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15" name="Immagine 14" descr="Alignments BETA.pdf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0126" t="61928" r="11555" b="33915"/>
                      <a:stretch/>
                    </p:blipFill>
                    <p:spPr>
                      <a:xfrm>
                        <a:off x="3187700" y="2400299"/>
                        <a:ext cx="2921000" cy="355599"/>
                      </a:xfrm>
                      <a:prstGeom prst="rect">
                        <a:avLst/>
                      </a:prstGeom>
                    </p:spPr>
                  </p:pic>
                </p:grpSp>
                <p:grpSp>
                  <p:nvGrpSpPr>
                    <p:cNvPr id="38" name="Gruppo 37"/>
                    <p:cNvGrpSpPr/>
                    <p:nvPr/>
                  </p:nvGrpSpPr>
                  <p:grpSpPr>
                    <a:xfrm>
                      <a:off x="482600" y="3183276"/>
                      <a:ext cx="5638800" cy="347134"/>
                      <a:chOff x="469900" y="2755899"/>
                      <a:chExt cx="5638800" cy="347134"/>
                    </a:xfrm>
                  </p:grpSpPr>
                  <p:pic>
                    <p:nvPicPr>
                      <p:cNvPr id="16" name="Immagine 15" descr="Alignments BETA.pdf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1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0126" t="66995" r="11555" b="28948"/>
                      <a:stretch/>
                    </p:blipFill>
                    <p:spPr>
                      <a:xfrm>
                        <a:off x="469900" y="2755899"/>
                        <a:ext cx="2921000" cy="347134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17" name="Immagine 16" descr="Alignments BETA.pdf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0126" t="72022" r="11555" b="23920"/>
                      <a:stretch/>
                    </p:blipFill>
                    <p:spPr>
                      <a:xfrm>
                        <a:off x="3187700" y="2755899"/>
                        <a:ext cx="2921000" cy="347134"/>
                      </a:xfrm>
                      <a:prstGeom prst="rect">
                        <a:avLst/>
                      </a:prstGeom>
                    </p:spPr>
                  </p:pic>
                </p:grpSp>
                <p:grpSp>
                  <p:nvGrpSpPr>
                    <p:cNvPr id="39" name="Gruppo 38"/>
                    <p:cNvGrpSpPr/>
                    <p:nvPr/>
                  </p:nvGrpSpPr>
                  <p:grpSpPr>
                    <a:xfrm>
                      <a:off x="482600" y="3595642"/>
                      <a:ext cx="5638800" cy="338666"/>
                      <a:chOff x="469900" y="3103033"/>
                      <a:chExt cx="5638800" cy="338666"/>
                    </a:xfrm>
                  </p:grpSpPr>
                  <p:pic>
                    <p:nvPicPr>
                      <p:cNvPr id="18" name="Immagine 17" descr="Alignments BETA.pdf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1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0126" t="77088" r="11555" b="18954"/>
                      <a:stretch/>
                    </p:blipFill>
                    <p:spPr>
                      <a:xfrm>
                        <a:off x="469900" y="3103033"/>
                        <a:ext cx="2921000" cy="338666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19" name="Immagine 18" descr="Alignments BETA.pdf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0126" t="82116" r="11555" b="13925"/>
                      <a:stretch/>
                    </p:blipFill>
                    <p:spPr>
                      <a:xfrm>
                        <a:off x="3187700" y="3103033"/>
                        <a:ext cx="2921000" cy="338666"/>
                      </a:xfrm>
                      <a:prstGeom prst="rect">
                        <a:avLst/>
                      </a:prstGeom>
                    </p:spPr>
                  </p:pic>
                </p:grpSp>
                <p:grpSp>
                  <p:nvGrpSpPr>
                    <p:cNvPr id="40" name="Gruppo 39"/>
                    <p:cNvGrpSpPr/>
                    <p:nvPr/>
                  </p:nvGrpSpPr>
                  <p:grpSpPr>
                    <a:xfrm>
                      <a:off x="482600" y="3999540"/>
                      <a:ext cx="5638800" cy="347135"/>
                      <a:chOff x="469900" y="3454399"/>
                      <a:chExt cx="5638800" cy="347135"/>
                    </a:xfrm>
                  </p:grpSpPr>
                  <p:pic>
                    <p:nvPicPr>
                      <p:cNvPr id="20" name="Immagine 19" descr="Alignments BETA.pdf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1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0126" t="86883" r="11555" b="9060"/>
                      <a:stretch/>
                    </p:blipFill>
                    <p:spPr>
                      <a:xfrm>
                        <a:off x="469900" y="3454400"/>
                        <a:ext cx="2921000" cy="347134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21" name="Immagine 20" descr="Alignments BETA.pdf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0126" t="91915" r="11555" b="4027"/>
                      <a:stretch/>
                    </p:blipFill>
                    <p:spPr>
                      <a:xfrm>
                        <a:off x="3187700" y="3454399"/>
                        <a:ext cx="2921000" cy="347134"/>
                      </a:xfrm>
                      <a:prstGeom prst="rect">
                        <a:avLst/>
                      </a:prstGeom>
                    </p:spPr>
                  </p:pic>
                </p:grpSp>
                <p:grpSp>
                  <p:nvGrpSpPr>
                    <p:cNvPr id="41" name="Gruppo 40"/>
                    <p:cNvGrpSpPr/>
                    <p:nvPr/>
                  </p:nvGrpSpPr>
                  <p:grpSpPr>
                    <a:xfrm>
                      <a:off x="482600" y="4411907"/>
                      <a:ext cx="5638800" cy="328082"/>
                      <a:chOff x="469900" y="3862917"/>
                      <a:chExt cx="5638800" cy="328082"/>
                    </a:xfrm>
                  </p:grpSpPr>
                  <p:pic>
                    <p:nvPicPr>
                      <p:cNvPr id="22" name="Immagine 21" descr="Alignments BETA.pdf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0092" t="2673" r="11589" b="93566"/>
                      <a:stretch/>
                    </p:blipFill>
                    <p:spPr>
                      <a:xfrm>
                        <a:off x="469900" y="3862917"/>
                        <a:ext cx="2921000" cy="321732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25" name="Immagine 24" descr="Alignments BETA.pdf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0092" t="7695" r="11589" b="88543"/>
                      <a:stretch/>
                    </p:blipFill>
                    <p:spPr>
                      <a:xfrm>
                        <a:off x="3187700" y="3869267"/>
                        <a:ext cx="2921000" cy="321732"/>
                      </a:xfrm>
                      <a:prstGeom prst="rect">
                        <a:avLst/>
                      </a:prstGeom>
                    </p:spPr>
                  </p:pic>
                </p:grpSp>
                <p:grpSp>
                  <p:nvGrpSpPr>
                    <p:cNvPr id="42" name="Gruppo 41"/>
                    <p:cNvGrpSpPr/>
                    <p:nvPr/>
                  </p:nvGrpSpPr>
                  <p:grpSpPr>
                    <a:xfrm>
                      <a:off x="482600" y="4805221"/>
                      <a:ext cx="5695950" cy="317500"/>
                      <a:chOff x="469900" y="4184649"/>
                      <a:chExt cx="5695950" cy="317500"/>
                    </a:xfrm>
                  </p:grpSpPr>
                  <p:pic>
                    <p:nvPicPr>
                      <p:cNvPr id="27" name="Immagine 26" descr="Alignments BETA.pdf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0092" t="12744" r="11589" b="83545"/>
                      <a:stretch/>
                    </p:blipFill>
                    <p:spPr>
                      <a:xfrm>
                        <a:off x="469900" y="4184649"/>
                        <a:ext cx="2921000" cy="31750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28" name="Immagine 27" descr="Alignments BETA.pdf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0092" t="17766" r="10644" b="78521"/>
                      <a:stretch/>
                    </p:blipFill>
                    <p:spPr>
                      <a:xfrm>
                        <a:off x="3187700" y="4184649"/>
                        <a:ext cx="2978150" cy="317500"/>
                      </a:xfrm>
                      <a:prstGeom prst="rect">
                        <a:avLst/>
                      </a:prstGeom>
                    </p:spPr>
                  </p:pic>
                </p:grpSp>
                <p:pic>
                  <p:nvPicPr>
                    <p:cNvPr id="29" name="Immagine 28" descr="Alignments BETA.pdf"/>
                    <p:cNvPicPr>
                      <a:picLocks noChangeAspect="1"/>
                    </p:cNvPicPr>
                    <p:nvPr/>
                  </p:nvPicPr>
                  <p:blipFill rotWithShape="1">
                    <a:blip r:embed="rId14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40092" t="22418" r="14950" b="73426"/>
                    <a:stretch/>
                  </p:blipFill>
                  <p:spPr>
                    <a:xfrm>
                      <a:off x="482600" y="5187949"/>
                      <a:ext cx="2717800" cy="355599"/>
                    </a:xfrm>
                    <a:prstGeom prst="rect">
                      <a:avLst/>
                    </a:prstGeom>
                  </p:spPr>
                </p:pic>
                <p:grpSp>
                  <p:nvGrpSpPr>
                    <p:cNvPr id="36" name="Gruppo 35"/>
                    <p:cNvGrpSpPr/>
                    <p:nvPr/>
                  </p:nvGrpSpPr>
                  <p:grpSpPr>
                    <a:xfrm>
                      <a:off x="482600" y="2299278"/>
                      <a:ext cx="5638800" cy="397934"/>
                      <a:chOff x="469900" y="2002365"/>
                      <a:chExt cx="5638800" cy="397934"/>
                    </a:xfrm>
                  </p:grpSpPr>
                  <p:pic>
                    <p:nvPicPr>
                      <p:cNvPr id="13" name="Immagine 12" descr="Alignments BETA.pdf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0126" t="46811" r="11555" b="48736"/>
                      <a:stretch/>
                    </p:blipFill>
                    <p:spPr>
                      <a:xfrm>
                        <a:off x="469900" y="2019300"/>
                        <a:ext cx="2921000" cy="380999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12" name="Immagine 11" descr="Alignments BETA.pdf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40126" t="51634" r="11555" b="43714"/>
                      <a:stretch/>
                    </p:blipFill>
                    <p:spPr>
                      <a:xfrm>
                        <a:off x="3187700" y="2002365"/>
                        <a:ext cx="2921000" cy="397934"/>
                      </a:xfrm>
                      <a:prstGeom prst="rect">
                        <a:avLst/>
                      </a:prstGeom>
                    </p:spPr>
                  </p:pic>
                </p:grpSp>
              </p:grpSp>
              <p:pic>
                <p:nvPicPr>
                  <p:cNvPr id="44" name="Immagine 43" descr="Alignments BETA.pdf"/>
                  <p:cNvPicPr>
                    <a:picLocks noChangeAspect="1"/>
                  </p:cNvPicPr>
                  <p:nvPr/>
                </p:nvPicPr>
                <p:blipFill rotWithShape="1">
                  <a:blip r:embed="rId1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4735" t="22418" r="10644" b="73426"/>
                  <a:stretch/>
                </p:blipFill>
                <p:spPr>
                  <a:xfrm>
                    <a:off x="5899150" y="5187947"/>
                    <a:ext cx="279400" cy="355599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47" name="CasellaDiTesto 46"/>
                <p:cNvSpPr txBox="1"/>
                <p:nvPr/>
              </p:nvSpPr>
              <p:spPr>
                <a:xfrm>
                  <a:off x="304219" y="665160"/>
                  <a:ext cx="882534" cy="34606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BETA</a:t>
                  </a:r>
                </a:p>
              </p:txBody>
            </p:sp>
            <p:sp>
              <p:nvSpPr>
                <p:cNvPr id="49" name="CasellaDiTesto 48"/>
                <p:cNvSpPr txBox="1"/>
                <p:nvPr/>
              </p:nvSpPr>
              <p:spPr>
                <a:xfrm>
                  <a:off x="304219" y="1087582"/>
                  <a:ext cx="882534" cy="34606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BETA</a:t>
                  </a:r>
                </a:p>
              </p:txBody>
            </p:sp>
            <p:sp>
              <p:nvSpPr>
                <p:cNvPr id="50" name="CasellaDiTesto 49"/>
                <p:cNvSpPr txBox="1"/>
                <p:nvPr/>
              </p:nvSpPr>
              <p:spPr>
                <a:xfrm>
                  <a:off x="304219" y="1477048"/>
                  <a:ext cx="882534" cy="34606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BETA</a:t>
                  </a:r>
                </a:p>
              </p:txBody>
            </p:sp>
            <p:sp>
              <p:nvSpPr>
                <p:cNvPr id="51" name="CasellaDiTesto 50"/>
                <p:cNvSpPr txBox="1"/>
                <p:nvPr/>
              </p:nvSpPr>
              <p:spPr>
                <a:xfrm>
                  <a:off x="304219" y="1864014"/>
                  <a:ext cx="882534" cy="34606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BETA</a:t>
                  </a:r>
                </a:p>
              </p:txBody>
            </p:sp>
            <p:sp>
              <p:nvSpPr>
                <p:cNvPr id="52" name="CasellaDiTesto 51"/>
                <p:cNvSpPr txBox="1"/>
                <p:nvPr/>
              </p:nvSpPr>
              <p:spPr>
                <a:xfrm>
                  <a:off x="304219" y="2290314"/>
                  <a:ext cx="882534" cy="34606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BETA</a:t>
                  </a:r>
                </a:p>
              </p:txBody>
            </p:sp>
            <p:sp>
              <p:nvSpPr>
                <p:cNvPr id="53" name="CasellaDiTesto 52"/>
                <p:cNvSpPr txBox="1"/>
                <p:nvPr/>
              </p:nvSpPr>
              <p:spPr>
                <a:xfrm>
                  <a:off x="304219" y="2717995"/>
                  <a:ext cx="882534" cy="34606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BETA</a:t>
                  </a:r>
                </a:p>
              </p:txBody>
            </p:sp>
            <p:sp>
              <p:nvSpPr>
                <p:cNvPr id="54" name="CasellaDiTesto 53"/>
                <p:cNvSpPr txBox="1"/>
                <p:nvPr/>
              </p:nvSpPr>
              <p:spPr>
                <a:xfrm>
                  <a:off x="304219" y="3140752"/>
                  <a:ext cx="882534" cy="34606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BETA</a:t>
                  </a:r>
                </a:p>
              </p:txBody>
            </p:sp>
            <p:sp>
              <p:nvSpPr>
                <p:cNvPr id="55" name="CasellaDiTesto 54"/>
                <p:cNvSpPr txBox="1"/>
                <p:nvPr/>
              </p:nvSpPr>
              <p:spPr>
                <a:xfrm>
                  <a:off x="304219" y="3543109"/>
                  <a:ext cx="882534" cy="34606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BETA</a:t>
                  </a:r>
                </a:p>
              </p:txBody>
            </p:sp>
            <p:sp>
              <p:nvSpPr>
                <p:cNvPr id="56" name="CasellaDiTesto 55"/>
                <p:cNvSpPr txBox="1"/>
                <p:nvPr/>
              </p:nvSpPr>
              <p:spPr>
                <a:xfrm>
                  <a:off x="304219" y="3956904"/>
                  <a:ext cx="882534" cy="34606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BETA</a:t>
                  </a:r>
                </a:p>
              </p:txBody>
            </p:sp>
            <p:sp>
              <p:nvSpPr>
                <p:cNvPr id="57" name="CasellaDiTesto 56"/>
                <p:cNvSpPr txBox="1"/>
                <p:nvPr/>
              </p:nvSpPr>
              <p:spPr>
                <a:xfrm>
                  <a:off x="304219" y="4359375"/>
                  <a:ext cx="882534" cy="34606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BETA</a:t>
                  </a:r>
                </a:p>
              </p:txBody>
            </p:sp>
            <p:sp>
              <p:nvSpPr>
                <p:cNvPr id="58" name="CasellaDiTesto 57"/>
                <p:cNvSpPr txBox="1"/>
                <p:nvPr/>
              </p:nvSpPr>
              <p:spPr>
                <a:xfrm>
                  <a:off x="304219" y="4737988"/>
                  <a:ext cx="882534" cy="34606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BETA</a:t>
                  </a:r>
                </a:p>
              </p:txBody>
            </p:sp>
            <p:sp>
              <p:nvSpPr>
                <p:cNvPr id="59" name="CasellaDiTesto 58"/>
                <p:cNvSpPr txBox="1"/>
                <p:nvPr/>
              </p:nvSpPr>
              <p:spPr>
                <a:xfrm>
                  <a:off x="304219" y="5149849"/>
                  <a:ext cx="882534" cy="34606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CYC-b_BETA</a:t>
                  </a:r>
                </a:p>
              </p:txBody>
            </p:sp>
          </p:grpSp>
          <p:grpSp>
            <p:nvGrpSpPr>
              <p:cNvPr id="67" name="Gruppo 66"/>
              <p:cNvGrpSpPr/>
              <p:nvPr/>
            </p:nvGrpSpPr>
            <p:grpSpPr>
              <a:xfrm>
                <a:off x="1126518" y="5171013"/>
                <a:ext cx="211667" cy="287998"/>
                <a:chOff x="1126518" y="5171013"/>
                <a:chExt cx="211667" cy="287998"/>
              </a:xfrm>
            </p:grpSpPr>
            <p:cxnSp>
              <p:nvCxnSpPr>
                <p:cNvPr id="65" name="Connettore 1 64"/>
                <p:cNvCxnSpPr/>
                <p:nvPr/>
              </p:nvCxnSpPr>
              <p:spPr>
                <a:xfrm flipV="1">
                  <a:off x="1126519" y="5171013"/>
                  <a:ext cx="0" cy="287998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" name="Connettore 1 65"/>
                <p:cNvCxnSpPr/>
                <p:nvPr/>
              </p:nvCxnSpPr>
              <p:spPr>
                <a:xfrm rot="16200000" flipV="1">
                  <a:off x="1232352" y="5069414"/>
                  <a:ext cx="0" cy="211667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  <a:headEnd type="stealth"/>
                  <a:tailEnd type="none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8" name="Rettangolo 67"/>
              <p:cNvSpPr/>
              <p:nvPr/>
            </p:nvSpPr>
            <p:spPr>
              <a:xfrm>
                <a:off x="5613400" y="4923367"/>
                <a:ext cx="423333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69" name="Rettangolo 68"/>
              <p:cNvSpPr/>
              <p:nvPr/>
            </p:nvSpPr>
            <p:spPr>
              <a:xfrm>
                <a:off x="5746749" y="2051244"/>
                <a:ext cx="359998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72" name="Rettangolo 71"/>
              <p:cNvSpPr/>
              <p:nvPr/>
            </p:nvSpPr>
            <p:spPr>
              <a:xfrm>
                <a:off x="3951651" y="2465035"/>
                <a:ext cx="539998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74" name="Rettangolo 73"/>
              <p:cNvSpPr/>
              <p:nvPr/>
            </p:nvSpPr>
            <p:spPr>
              <a:xfrm>
                <a:off x="5060949" y="2798620"/>
                <a:ext cx="395998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76" name="Rettangolo 75"/>
              <p:cNvSpPr/>
              <p:nvPr/>
            </p:nvSpPr>
            <p:spPr>
              <a:xfrm>
                <a:off x="4959346" y="2465035"/>
                <a:ext cx="1295991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78" name="Rettangolo 77"/>
              <p:cNvSpPr/>
              <p:nvPr/>
            </p:nvSpPr>
            <p:spPr>
              <a:xfrm>
                <a:off x="2876549" y="2049321"/>
                <a:ext cx="395998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81" name="CasellaDiTesto 80"/>
              <p:cNvSpPr txBox="1"/>
              <p:nvPr/>
            </p:nvSpPr>
            <p:spPr>
              <a:xfrm>
                <a:off x="2965450" y="2163581"/>
                <a:ext cx="264310" cy="23853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1</a:t>
                </a:r>
              </a:p>
            </p:txBody>
          </p:sp>
          <p:sp>
            <p:nvSpPr>
              <p:cNvPr id="82" name="CasellaDiTesto 81"/>
              <p:cNvSpPr txBox="1"/>
              <p:nvPr/>
            </p:nvSpPr>
            <p:spPr>
              <a:xfrm>
                <a:off x="5794359" y="2163581"/>
                <a:ext cx="264310" cy="23853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2</a:t>
                </a:r>
              </a:p>
            </p:txBody>
          </p:sp>
          <p:sp>
            <p:nvSpPr>
              <p:cNvPr id="83" name="CasellaDiTesto 82"/>
              <p:cNvSpPr txBox="1"/>
              <p:nvPr/>
            </p:nvSpPr>
            <p:spPr>
              <a:xfrm>
                <a:off x="4045377" y="2579163"/>
                <a:ext cx="264310" cy="23853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3</a:t>
                </a:r>
              </a:p>
            </p:txBody>
          </p:sp>
          <p:sp>
            <p:nvSpPr>
              <p:cNvPr id="84" name="CasellaDiTesto 83"/>
              <p:cNvSpPr txBox="1"/>
              <p:nvPr/>
            </p:nvSpPr>
            <p:spPr>
              <a:xfrm>
                <a:off x="5518282" y="2579163"/>
                <a:ext cx="264310" cy="23853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4</a:t>
                </a:r>
              </a:p>
            </p:txBody>
          </p:sp>
          <p:sp>
            <p:nvSpPr>
              <p:cNvPr id="85" name="CasellaDiTesto 84"/>
              <p:cNvSpPr txBox="1"/>
              <p:nvPr/>
            </p:nvSpPr>
            <p:spPr>
              <a:xfrm>
                <a:off x="5146660" y="3025336"/>
                <a:ext cx="264310" cy="23853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5</a:t>
                </a:r>
              </a:p>
            </p:txBody>
          </p:sp>
          <p:sp>
            <p:nvSpPr>
              <p:cNvPr id="86" name="CasellaDiTesto 85"/>
              <p:cNvSpPr txBox="1"/>
              <p:nvPr/>
            </p:nvSpPr>
            <p:spPr>
              <a:xfrm>
                <a:off x="5673172" y="5030197"/>
                <a:ext cx="264310" cy="23853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6</a:t>
                </a:r>
              </a:p>
            </p:txBody>
          </p:sp>
        </p:grpSp>
        <p:sp>
          <p:nvSpPr>
            <p:cNvPr id="2" name="CasellaDiTesto 1"/>
            <p:cNvSpPr txBox="1"/>
            <p:nvPr/>
          </p:nvSpPr>
          <p:spPr>
            <a:xfrm>
              <a:off x="1261982" y="5051143"/>
              <a:ext cx="747080" cy="2230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738" dirty="0">
                  <a:latin typeface="Arial"/>
                  <a:cs typeface="Arial"/>
                </a:rPr>
                <a:t>Start </a:t>
              </a:r>
              <a:r>
                <a:rPr lang="it-IT" sz="738" dirty="0" err="1">
                  <a:latin typeface="Arial"/>
                  <a:cs typeface="Arial"/>
                </a:rPr>
                <a:t>Codon</a:t>
              </a:r>
              <a:endParaRPr lang="it-IT" sz="738" dirty="0">
                <a:latin typeface="Arial"/>
                <a:cs typeface="Arial"/>
              </a:endParaRPr>
            </a:p>
          </p:txBody>
        </p:sp>
        <p:cxnSp>
          <p:nvCxnSpPr>
            <p:cNvPr id="73" name="Connettore 1 72"/>
            <p:cNvCxnSpPr/>
            <p:nvPr/>
          </p:nvCxnSpPr>
          <p:spPr>
            <a:xfrm rot="16200000" flipV="1">
              <a:off x="6344689" y="4325515"/>
              <a:ext cx="0" cy="211666"/>
            </a:xfrm>
            <a:prstGeom prst="line">
              <a:avLst/>
            </a:prstGeom>
            <a:ln w="12700" cmpd="sng">
              <a:solidFill>
                <a:srgbClr val="FF0000"/>
              </a:solidFill>
              <a:headEnd type="stealth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CasellaDiTesto 74"/>
            <p:cNvSpPr txBox="1"/>
            <p:nvPr/>
          </p:nvSpPr>
          <p:spPr>
            <a:xfrm>
              <a:off x="6099314" y="4239726"/>
              <a:ext cx="519586" cy="2230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738" dirty="0">
                  <a:solidFill>
                    <a:srgbClr val="FF0000"/>
                  </a:solidFill>
                  <a:latin typeface="Arial"/>
                  <a:cs typeface="Arial"/>
                </a:rPr>
                <a:t>5’ UTR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410543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>
            <a:grpSpLocks noChangeAspect="1"/>
          </p:cNvGrpSpPr>
          <p:nvPr/>
        </p:nvGrpSpPr>
        <p:grpSpPr>
          <a:xfrm>
            <a:off x="446322" y="301971"/>
            <a:ext cx="5990903" cy="6180923"/>
            <a:chOff x="197764" y="327133"/>
            <a:chExt cx="6699283" cy="6911769"/>
          </a:xfrm>
        </p:grpSpPr>
        <p:grpSp>
          <p:nvGrpSpPr>
            <p:cNvPr id="193" name="Gruppo 192"/>
            <p:cNvGrpSpPr/>
            <p:nvPr/>
          </p:nvGrpSpPr>
          <p:grpSpPr>
            <a:xfrm>
              <a:off x="197764" y="327133"/>
              <a:ext cx="6699283" cy="6911769"/>
              <a:chOff x="197764" y="327133"/>
              <a:chExt cx="6699283" cy="6911769"/>
            </a:xfrm>
          </p:grpSpPr>
          <p:grpSp>
            <p:nvGrpSpPr>
              <p:cNvPr id="108" name="Gruppo 107"/>
              <p:cNvGrpSpPr/>
              <p:nvPr/>
            </p:nvGrpSpPr>
            <p:grpSpPr>
              <a:xfrm>
                <a:off x="197764" y="327133"/>
                <a:ext cx="6330289" cy="6911769"/>
                <a:chOff x="11490" y="327133"/>
                <a:chExt cx="6330289" cy="6911769"/>
              </a:xfrm>
            </p:grpSpPr>
            <p:grpSp>
              <p:nvGrpSpPr>
                <p:cNvPr id="64" name="Gruppo 63"/>
                <p:cNvGrpSpPr/>
                <p:nvPr/>
              </p:nvGrpSpPr>
              <p:grpSpPr>
                <a:xfrm>
                  <a:off x="795888" y="342898"/>
                  <a:ext cx="5545891" cy="393700"/>
                  <a:chOff x="254000" y="342898"/>
                  <a:chExt cx="5545891" cy="393700"/>
                </a:xfrm>
              </p:grpSpPr>
              <p:pic>
                <p:nvPicPr>
                  <p:cNvPr id="2" name="Immagine 1" descr="clustalw delta1.pdf"/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075" t="6680" r="9664" b="88718"/>
                  <a:stretch/>
                </p:blipFill>
                <p:spPr>
                  <a:xfrm>
                    <a:off x="254000" y="342898"/>
                    <a:ext cx="3098800" cy="393700"/>
                  </a:xfrm>
                  <a:prstGeom prst="rect">
                    <a:avLst/>
                  </a:prstGeom>
                </p:spPr>
              </p:pic>
              <p:pic>
                <p:nvPicPr>
                  <p:cNvPr id="7" name="Immagine 6" descr="clustalw delta1.pdf"/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075" t="11653" r="14983" b="83745"/>
                  <a:stretch/>
                </p:blipFill>
                <p:spPr>
                  <a:xfrm>
                    <a:off x="3022600" y="342898"/>
                    <a:ext cx="2777291" cy="393700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65" name="Gruppo 64"/>
                <p:cNvGrpSpPr/>
                <p:nvPr/>
              </p:nvGrpSpPr>
              <p:grpSpPr>
                <a:xfrm>
                  <a:off x="791655" y="705171"/>
                  <a:ext cx="5550124" cy="406400"/>
                  <a:chOff x="249767" y="705171"/>
                  <a:chExt cx="5550124" cy="406400"/>
                </a:xfrm>
              </p:grpSpPr>
              <p:pic>
                <p:nvPicPr>
                  <p:cNvPr id="11" name="Immagine 10" descr="clustalw delta1.pdf"/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8935" t="16775" r="9804" b="78623"/>
                  <a:stretch/>
                </p:blipFill>
                <p:spPr>
                  <a:xfrm>
                    <a:off x="249767" y="705171"/>
                    <a:ext cx="3098800" cy="393700"/>
                  </a:xfrm>
                  <a:prstGeom prst="rect">
                    <a:avLst/>
                  </a:prstGeom>
                </p:spPr>
              </p:pic>
              <p:pic>
                <p:nvPicPr>
                  <p:cNvPr id="12" name="Immagine 11" descr="clustalw delta1.pdf"/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215" t="21921" r="14982" b="73477"/>
                  <a:stretch/>
                </p:blipFill>
                <p:spPr>
                  <a:xfrm>
                    <a:off x="3031066" y="717871"/>
                    <a:ext cx="2768825" cy="393700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66" name="Gruppo 65"/>
                <p:cNvGrpSpPr/>
                <p:nvPr/>
              </p:nvGrpSpPr>
              <p:grpSpPr>
                <a:xfrm>
                  <a:off x="787422" y="1097078"/>
                  <a:ext cx="5554357" cy="393700"/>
                  <a:chOff x="245534" y="1097078"/>
                  <a:chExt cx="5554357" cy="393700"/>
                </a:xfrm>
              </p:grpSpPr>
              <p:pic>
                <p:nvPicPr>
                  <p:cNvPr id="15" name="Immagine 14" descr="clustalw delta1.pdf"/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8865" t="27241" r="9874" b="68157"/>
                  <a:stretch/>
                </p:blipFill>
                <p:spPr>
                  <a:xfrm>
                    <a:off x="245534" y="1097078"/>
                    <a:ext cx="3098800" cy="393700"/>
                  </a:xfrm>
                  <a:prstGeom prst="rect">
                    <a:avLst/>
                  </a:prstGeom>
                </p:spPr>
              </p:pic>
              <p:pic>
                <p:nvPicPr>
                  <p:cNvPr id="16" name="Immagine 15" descr="clustalw delta1.pdf"/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075" t="32139" r="14983" b="63259"/>
                  <a:stretch/>
                </p:blipFill>
                <p:spPr>
                  <a:xfrm>
                    <a:off x="3022600" y="1097078"/>
                    <a:ext cx="2777291" cy="393700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67" name="Gruppo 66"/>
                <p:cNvGrpSpPr/>
                <p:nvPr/>
              </p:nvGrpSpPr>
              <p:grpSpPr>
                <a:xfrm>
                  <a:off x="795888" y="1391615"/>
                  <a:ext cx="5545891" cy="400050"/>
                  <a:chOff x="254000" y="1391615"/>
                  <a:chExt cx="5545891" cy="400050"/>
                </a:xfrm>
              </p:grpSpPr>
              <p:pic>
                <p:nvPicPr>
                  <p:cNvPr id="17" name="Immagine 16" descr="clustalw delta1.pdf"/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076" t="36742" r="9662" b="58656"/>
                  <a:stretch/>
                </p:blipFill>
                <p:spPr>
                  <a:xfrm>
                    <a:off x="254000" y="1391615"/>
                    <a:ext cx="3098800" cy="393700"/>
                  </a:xfrm>
                  <a:prstGeom prst="rect">
                    <a:avLst/>
                  </a:prstGeom>
                </p:spPr>
              </p:pic>
              <p:pic>
                <p:nvPicPr>
                  <p:cNvPr id="18" name="Immagine 17" descr="clustalw delta1.pdf"/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145" t="41862" r="14982" b="53536"/>
                  <a:stretch/>
                </p:blipFill>
                <p:spPr>
                  <a:xfrm>
                    <a:off x="3026833" y="1397965"/>
                    <a:ext cx="2773058" cy="393700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68" name="Gruppo 67"/>
                <p:cNvGrpSpPr/>
                <p:nvPr/>
              </p:nvGrpSpPr>
              <p:grpSpPr>
                <a:xfrm>
                  <a:off x="800121" y="1734837"/>
                  <a:ext cx="5541658" cy="393700"/>
                  <a:chOff x="258233" y="1734837"/>
                  <a:chExt cx="5541658" cy="393700"/>
                </a:xfrm>
              </p:grpSpPr>
              <p:pic>
                <p:nvPicPr>
                  <p:cNvPr id="19" name="Immagine 18" descr="clustalw delta1.pdf"/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110" t="46761" r="9629" b="48637"/>
                  <a:stretch/>
                </p:blipFill>
                <p:spPr>
                  <a:xfrm>
                    <a:off x="258233" y="1734837"/>
                    <a:ext cx="3098800" cy="393700"/>
                  </a:xfrm>
                  <a:prstGeom prst="rect">
                    <a:avLst/>
                  </a:prstGeom>
                </p:spPr>
              </p:pic>
              <p:pic>
                <p:nvPicPr>
                  <p:cNvPr id="20" name="Immagine 19" descr="clustalw delta1.pdf"/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8865" t="51708" r="15052" b="43690"/>
                  <a:stretch/>
                </p:blipFill>
                <p:spPr>
                  <a:xfrm>
                    <a:off x="3014134" y="1734837"/>
                    <a:ext cx="2785757" cy="393700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69" name="Gruppo 68"/>
                <p:cNvGrpSpPr/>
                <p:nvPr/>
              </p:nvGrpSpPr>
              <p:grpSpPr>
                <a:xfrm>
                  <a:off x="791655" y="2080176"/>
                  <a:ext cx="5550124" cy="400050"/>
                  <a:chOff x="249767" y="2080176"/>
                  <a:chExt cx="5550124" cy="400050"/>
                </a:xfrm>
              </p:grpSpPr>
              <p:pic>
                <p:nvPicPr>
                  <p:cNvPr id="21" name="Immagine 20" descr="clustalw delta1.pdf"/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8935" t="56878" r="9802" b="38520"/>
                  <a:stretch/>
                </p:blipFill>
                <p:spPr>
                  <a:xfrm>
                    <a:off x="249767" y="2086526"/>
                    <a:ext cx="3098800" cy="393700"/>
                  </a:xfrm>
                  <a:prstGeom prst="rect">
                    <a:avLst/>
                  </a:prstGeom>
                </p:spPr>
              </p:pic>
              <p:pic>
                <p:nvPicPr>
                  <p:cNvPr id="22" name="Immagine 21" descr="clustalw delta1.pdf"/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8971" t="61781" r="14947" b="33617"/>
                  <a:stretch/>
                </p:blipFill>
                <p:spPr>
                  <a:xfrm>
                    <a:off x="3014134" y="2080176"/>
                    <a:ext cx="2785757" cy="393700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71" name="Gruppo 70"/>
                <p:cNvGrpSpPr/>
                <p:nvPr/>
              </p:nvGrpSpPr>
              <p:grpSpPr>
                <a:xfrm>
                  <a:off x="800121" y="2743351"/>
                  <a:ext cx="5541658" cy="400048"/>
                  <a:chOff x="258233" y="2743351"/>
                  <a:chExt cx="5541658" cy="400048"/>
                </a:xfrm>
              </p:grpSpPr>
              <p:pic>
                <p:nvPicPr>
                  <p:cNvPr id="26" name="Immagine 25" descr="clustalw delta2.pdf"/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075" t="11878" r="9664" b="83520"/>
                  <a:stretch/>
                </p:blipFill>
                <p:spPr>
                  <a:xfrm>
                    <a:off x="258233" y="2743351"/>
                    <a:ext cx="3098800" cy="393698"/>
                  </a:xfrm>
                  <a:prstGeom prst="rect">
                    <a:avLst/>
                  </a:prstGeom>
                </p:spPr>
              </p:pic>
              <p:pic>
                <p:nvPicPr>
                  <p:cNvPr id="27" name="Immagine 26" descr="clustalw delta2.pdf"/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180" t="16975" r="15018" b="78423"/>
                  <a:stretch/>
                </p:blipFill>
                <p:spPr>
                  <a:xfrm>
                    <a:off x="3031066" y="2749701"/>
                    <a:ext cx="2768825" cy="393698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73" name="Gruppo 72"/>
                <p:cNvGrpSpPr/>
                <p:nvPr/>
              </p:nvGrpSpPr>
              <p:grpSpPr>
                <a:xfrm>
                  <a:off x="787422" y="3018835"/>
                  <a:ext cx="5554357" cy="406398"/>
                  <a:chOff x="245534" y="2976500"/>
                  <a:chExt cx="5554357" cy="406398"/>
                </a:xfrm>
              </p:grpSpPr>
              <p:pic>
                <p:nvPicPr>
                  <p:cNvPr id="28" name="Immagine 27" descr="clustalw delta2.pdf"/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8865" t="21600" r="9874" b="73798"/>
                  <a:stretch/>
                </p:blipFill>
                <p:spPr>
                  <a:xfrm>
                    <a:off x="245534" y="2976500"/>
                    <a:ext cx="3098800" cy="393698"/>
                  </a:xfrm>
                  <a:prstGeom prst="rect">
                    <a:avLst/>
                  </a:prstGeom>
                </p:spPr>
              </p:pic>
              <p:pic>
                <p:nvPicPr>
                  <p:cNvPr id="29" name="Immagine 28" descr="clustalw delta2.pdf"/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216" t="26739" r="15052" b="68659"/>
                  <a:stretch/>
                </p:blipFill>
                <p:spPr>
                  <a:xfrm>
                    <a:off x="3035299" y="2989200"/>
                    <a:ext cx="2764592" cy="393698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72" name="Gruppo 71"/>
                <p:cNvGrpSpPr/>
                <p:nvPr/>
              </p:nvGrpSpPr>
              <p:grpSpPr>
                <a:xfrm>
                  <a:off x="800121" y="3300669"/>
                  <a:ext cx="5541658" cy="393698"/>
                  <a:chOff x="258233" y="3224466"/>
                  <a:chExt cx="5541658" cy="393698"/>
                </a:xfrm>
              </p:grpSpPr>
              <p:pic>
                <p:nvPicPr>
                  <p:cNvPr id="30" name="Immagine 29" descr="clustalw delta2.pdf"/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075" t="31341" r="9664" b="64057"/>
                  <a:stretch/>
                </p:blipFill>
                <p:spPr>
                  <a:xfrm>
                    <a:off x="258233" y="3224466"/>
                    <a:ext cx="3098800" cy="393698"/>
                  </a:xfrm>
                  <a:prstGeom prst="rect">
                    <a:avLst/>
                  </a:prstGeom>
                </p:spPr>
              </p:pic>
              <p:pic>
                <p:nvPicPr>
                  <p:cNvPr id="31" name="Immagine 30" descr="clustalw delta2.pdf"/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215" t="36315" r="14982" b="59083"/>
                  <a:stretch/>
                </p:blipFill>
                <p:spPr>
                  <a:xfrm>
                    <a:off x="3031066" y="3224466"/>
                    <a:ext cx="2768825" cy="393698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74" name="Gruppo 73"/>
                <p:cNvGrpSpPr/>
                <p:nvPr/>
              </p:nvGrpSpPr>
              <p:grpSpPr>
                <a:xfrm>
                  <a:off x="800121" y="3595204"/>
                  <a:ext cx="5541658" cy="412748"/>
                  <a:chOff x="258233" y="3485133"/>
                  <a:chExt cx="5541658" cy="412748"/>
                </a:xfrm>
              </p:grpSpPr>
              <p:pic>
                <p:nvPicPr>
                  <p:cNvPr id="32" name="Immagine 31" descr="clustalw delta2.pdf"/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075" t="41740" r="9664" b="53658"/>
                  <a:stretch/>
                </p:blipFill>
                <p:spPr>
                  <a:xfrm>
                    <a:off x="258233" y="3504183"/>
                    <a:ext cx="3098800" cy="393698"/>
                  </a:xfrm>
                  <a:prstGeom prst="rect">
                    <a:avLst/>
                  </a:prstGeom>
                </p:spPr>
              </p:pic>
              <p:pic>
                <p:nvPicPr>
                  <p:cNvPr id="33" name="Immagine 32" descr="clustalw delta2.pdf"/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145" t="46590" r="14982" b="48808"/>
                  <a:stretch/>
                </p:blipFill>
                <p:spPr>
                  <a:xfrm>
                    <a:off x="3026833" y="3485133"/>
                    <a:ext cx="2773058" cy="393698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76" name="Gruppo 75"/>
                <p:cNvGrpSpPr/>
                <p:nvPr/>
              </p:nvGrpSpPr>
              <p:grpSpPr>
                <a:xfrm>
                  <a:off x="804354" y="3883388"/>
                  <a:ext cx="5537425" cy="393698"/>
                  <a:chOff x="262466" y="3747916"/>
                  <a:chExt cx="5537425" cy="393698"/>
                </a:xfrm>
              </p:grpSpPr>
              <p:pic>
                <p:nvPicPr>
                  <p:cNvPr id="34" name="Immagine 33" descr="clustalw delta2.pdf"/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075" t="51439" r="9664" b="43959"/>
                  <a:stretch/>
                </p:blipFill>
                <p:spPr>
                  <a:xfrm>
                    <a:off x="262466" y="3747916"/>
                    <a:ext cx="3098800" cy="393698"/>
                  </a:xfrm>
                  <a:prstGeom prst="rect">
                    <a:avLst/>
                  </a:prstGeom>
                </p:spPr>
              </p:pic>
              <p:pic>
                <p:nvPicPr>
                  <p:cNvPr id="35" name="Immagine 34" descr="clustalw delta2.pdf"/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145" t="56413" r="15053" b="38985"/>
                  <a:stretch/>
                </p:blipFill>
                <p:spPr>
                  <a:xfrm>
                    <a:off x="3031066" y="3747916"/>
                    <a:ext cx="2768825" cy="393698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78" name="Gruppo 77"/>
                <p:cNvGrpSpPr/>
                <p:nvPr/>
              </p:nvGrpSpPr>
              <p:grpSpPr>
                <a:xfrm>
                  <a:off x="774723" y="4764876"/>
                  <a:ext cx="5567056" cy="393698"/>
                  <a:chOff x="232835" y="4502399"/>
                  <a:chExt cx="5567056" cy="393698"/>
                </a:xfrm>
              </p:grpSpPr>
              <p:pic>
                <p:nvPicPr>
                  <p:cNvPr id="40" name="Immagine 39" descr="clustalw delta2.pdf"/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8690" t="81027" r="10049" b="14371"/>
                  <a:stretch/>
                </p:blipFill>
                <p:spPr>
                  <a:xfrm>
                    <a:off x="232835" y="4502399"/>
                    <a:ext cx="3098800" cy="393698"/>
                  </a:xfrm>
                  <a:prstGeom prst="rect">
                    <a:avLst/>
                  </a:prstGeom>
                </p:spPr>
              </p:pic>
              <p:pic>
                <p:nvPicPr>
                  <p:cNvPr id="41" name="Immagine 40" descr="clustalw delta2.pdf"/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390" t="86049" r="14948" b="9349"/>
                  <a:stretch/>
                </p:blipFill>
                <p:spPr>
                  <a:xfrm>
                    <a:off x="3039532" y="4502399"/>
                    <a:ext cx="2760359" cy="393698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79" name="Gruppo 78"/>
                <p:cNvGrpSpPr/>
                <p:nvPr/>
              </p:nvGrpSpPr>
              <p:grpSpPr>
                <a:xfrm>
                  <a:off x="774723" y="5135614"/>
                  <a:ext cx="5567056" cy="393698"/>
                  <a:chOff x="232835" y="4805401"/>
                  <a:chExt cx="5567056" cy="393698"/>
                </a:xfrm>
              </p:grpSpPr>
              <p:pic>
                <p:nvPicPr>
                  <p:cNvPr id="42" name="Immagine 41" descr="clustalw delta2.pdf"/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8690" t="91196" r="10049" b="4202"/>
                  <a:stretch/>
                </p:blipFill>
                <p:spPr>
                  <a:xfrm>
                    <a:off x="232835" y="4805401"/>
                    <a:ext cx="3098800" cy="393698"/>
                  </a:xfrm>
                  <a:prstGeom prst="rect">
                    <a:avLst/>
                  </a:prstGeom>
                </p:spPr>
              </p:pic>
              <p:pic>
                <p:nvPicPr>
                  <p:cNvPr id="44" name="Immagine 43" descr="clustalw delta2.pdf"/>
                  <p:cNvPicPr>
                    <a:picLocks noChangeAspect="1"/>
                  </p:cNvPicPr>
                  <p:nvPr/>
                </p:nvPicPr>
                <p:blipFill rotWithShape="1"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075" t="2549" r="15053" b="94210"/>
                  <a:stretch/>
                </p:blipFill>
                <p:spPr>
                  <a:xfrm>
                    <a:off x="3026833" y="4871000"/>
                    <a:ext cx="2773058" cy="277297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80" name="Gruppo 79"/>
                <p:cNvGrpSpPr/>
                <p:nvPr/>
              </p:nvGrpSpPr>
              <p:grpSpPr>
                <a:xfrm>
                  <a:off x="800121" y="5447083"/>
                  <a:ext cx="5541658" cy="391550"/>
                  <a:chOff x="258233" y="5091469"/>
                  <a:chExt cx="5541658" cy="391550"/>
                </a:xfrm>
              </p:grpSpPr>
              <p:pic>
                <p:nvPicPr>
                  <p:cNvPr id="45" name="Immagine 44" descr="clustalw delta2.pdf"/>
                  <p:cNvPicPr>
                    <a:picLocks noChangeAspect="1"/>
                  </p:cNvPicPr>
                  <p:nvPr/>
                </p:nvPicPr>
                <p:blipFill rotWithShape="1"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075" t="6805" r="9664" b="88841"/>
                  <a:stretch/>
                </p:blipFill>
                <p:spPr>
                  <a:xfrm>
                    <a:off x="258233" y="5091469"/>
                    <a:ext cx="3098800" cy="372500"/>
                  </a:xfrm>
                  <a:prstGeom prst="rect">
                    <a:avLst/>
                  </a:prstGeom>
                </p:spPr>
              </p:pic>
              <p:pic>
                <p:nvPicPr>
                  <p:cNvPr id="43" name="Immagine 42" descr="clustalw delta3.pdf"/>
                  <p:cNvPicPr>
                    <a:picLocks noChangeAspect="1"/>
                  </p:cNvPicPr>
                  <p:nvPr/>
                </p:nvPicPr>
                <p:blipFill rotWithShape="1"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285" t="7121" r="14982" b="89263"/>
                  <a:stretch/>
                </p:blipFill>
                <p:spPr>
                  <a:xfrm>
                    <a:off x="3035299" y="5173698"/>
                    <a:ext cx="2764592" cy="309321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81" name="Gruppo 80"/>
                <p:cNvGrpSpPr/>
                <p:nvPr/>
              </p:nvGrpSpPr>
              <p:grpSpPr>
                <a:xfrm>
                  <a:off x="800121" y="5856308"/>
                  <a:ext cx="5541658" cy="350909"/>
                  <a:chOff x="258233" y="5492227"/>
                  <a:chExt cx="5541658" cy="350909"/>
                </a:xfrm>
              </p:grpSpPr>
              <p:pic>
                <p:nvPicPr>
                  <p:cNvPr id="46" name="Immagine 45" descr="clustalw delta3.pdf"/>
                  <p:cNvPicPr>
                    <a:picLocks noChangeAspect="1"/>
                  </p:cNvPicPr>
                  <p:nvPr/>
                </p:nvPicPr>
                <p:blipFill rotWithShape="1"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006" t="12370" r="9733" b="83969"/>
                  <a:stretch/>
                </p:blipFill>
                <p:spPr>
                  <a:xfrm>
                    <a:off x="258233" y="5529903"/>
                    <a:ext cx="3098800" cy="313233"/>
                  </a:xfrm>
                  <a:prstGeom prst="rect">
                    <a:avLst/>
                  </a:prstGeom>
                </p:spPr>
              </p:pic>
              <p:pic>
                <p:nvPicPr>
                  <p:cNvPr id="47" name="Immagine 46" descr="clustalw delta3.pdf"/>
                  <p:cNvPicPr>
                    <a:picLocks noChangeAspect="1"/>
                  </p:cNvPicPr>
                  <p:nvPr/>
                </p:nvPicPr>
                <p:blipFill rotWithShape="1"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215" t="16952" r="14982" b="79169"/>
                  <a:stretch/>
                </p:blipFill>
                <p:spPr>
                  <a:xfrm>
                    <a:off x="3031066" y="5492227"/>
                    <a:ext cx="2768825" cy="331867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82" name="Gruppo 81"/>
                <p:cNvGrpSpPr/>
                <p:nvPr/>
              </p:nvGrpSpPr>
              <p:grpSpPr>
                <a:xfrm>
                  <a:off x="795888" y="6209658"/>
                  <a:ext cx="5545891" cy="325941"/>
                  <a:chOff x="254000" y="5845577"/>
                  <a:chExt cx="5545891" cy="325941"/>
                </a:xfrm>
              </p:grpSpPr>
              <p:pic>
                <p:nvPicPr>
                  <p:cNvPr id="48" name="Immagine 47" descr="clustalw delta3.pdf"/>
                  <p:cNvPicPr>
                    <a:picLocks noChangeAspect="1"/>
                  </p:cNvPicPr>
                  <p:nvPr/>
                </p:nvPicPr>
                <p:blipFill rotWithShape="1"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006" t="22018" r="9733" b="74321"/>
                  <a:stretch/>
                </p:blipFill>
                <p:spPr>
                  <a:xfrm>
                    <a:off x="254000" y="5845577"/>
                    <a:ext cx="3098800" cy="313233"/>
                  </a:xfrm>
                  <a:prstGeom prst="rect">
                    <a:avLst/>
                  </a:prstGeom>
                </p:spPr>
              </p:pic>
              <p:pic>
                <p:nvPicPr>
                  <p:cNvPr id="49" name="Immagine 48" descr="clustalw delta3.pdf"/>
                  <p:cNvPicPr>
                    <a:picLocks noChangeAspect="1"/>
                  </p:cNvPicPr>
                  <p:nvPr/>
                </p:nvPicPr>
                <p:blipFill rotWithShape="1"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8655" t="27065" r="15053" b="69274"/>
                  <a:stretch/>
                </p:blipFill>
                <p:spPr>
                  <a:xfrm>
                    <a:off x="3001435" y="5858285"/>
                    <a:ext cx="2798456" cy="313233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83" name="Gruppo 82"/>
                <p:cNvGrpSpPr/>
                <p:nvPr/>
              </p:nvGrpSpPr>
              <p:grpSpPr>
                <a:xfrm>
                  <a:off x="791655" y="6554974"/>
                  <a:ext cx="5550124" cy="342857"/>
                  <a:chOff x="249767" y="6207827"/>
                  <a:chExt cx="5550124" cy="342857"/>
                </a:xfrm>
              </p:grpSpPr>
              <p:pic>
                <p:nvPicPr>
                  <p:cNvPr id="50" name="Immagine 49" descr="clustalw delta3.pdf"/>
                  <p:cNvPicPr>
                    <a:picLocks noChangeAspect="1"/>
                  </p:cNvPicPr>
                  <p:nvPr/>
                </p:nvPicPr>
                <p:blipFill rotWithShape="1"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8901" t="32507" r="9838" b="63832"/>
                  <a:stretch/>
                </p:blipFill>
                <p:spPr>
                  <a:xfrm>
                    <a:off x="249767" y="6237451"/>
                    <a:ext cx="3098800" cy="313233"/>
                  </a:xfrm>
                  <a:prstGeom prst="rect">
                    <a:avLst/>
                  </a:prstGeom>
                </p:spPr>
              </p:pic>
              <p:pic>
                <p:nvPicPr>
                  <p:cNvPr id="51" name="Immagine 50" descr="clustalw delta3.pdf"/>
                  <p:cNvPicPr>
                    <a:picLocks noChangeAspect="1"/>
                  </p:cNvPicPr>
                  <p:nvPr/>
                </p:nvPicPr>
                <p:blipFill rotWithShape="1"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8655" t="37159" r="14983" b="59180"/>
                  <a:stretch/>
                </p:blipFill>
                <p:spPr>
                  <a:xfrm>
                    <a:off x="2997202" y="6207827"/>
                    <a:ext cx="2802689" cy="313233"/>
                  </a:xfrm>
                  <a:prstGeom prst="rect">
                    <a:avLst/>
                  </a:prstGeom>
                </p:spPr>
              </p:pic>
            </p:grpSp>
            <p:pic>
              <p:nvPicPr>
                <p:cNvPr id="52" name="Immagine 51" descr="clustalw delta3.pdf"/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8655" t="41954" r="14846" b="54059"/>
                <a:stretch/>
              </p:blipFill>
              <p:spPr>
                <a:xfrm>
                  <a:off x="778956" y="6897832"/>
                  <a:ext cx="2810930" cy="341070"/>
                </a:xfrm>
                <a:prstGeom prst="rect">
                  <a:avLst/>
                </a:prstGeom>
              </p:spPr>
            </p:pic>
            <p:grpSp>
              <p:nvGrpSpPr>
                <p:cNvPr id="77" name="Gruppo 76"/>
                <p:cNvGrpSpPr/>
                <p:nvPr/>
              </p:nvGrpSpPr>
              <p:grpSpPr>
                <a:xfrm>
                  <a:off x="787422" y="4478808"/>
                  <a:ext cx="5554357" cy="393698"/>
                  <a:chOff x="245534" y="4267133"/>
                  <a:chExt cx="5554357" cy="393698"/>
                </a:xfrm>
              </p:grpSpPr>
              <p:pic>
                <p:nvPicPr>
                  <p:cNvPr id="38" name="Immagine 37" descr="clustalw delta2.pdf"/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8795" t="71303" r="9944" b="24095"/>
                  <a:stretch/>
                </p:blipFill>
                <p:spPr>
                  <a:xfrm>
                    <a:off x="245534" y="4267133"/>
                    <a:ext cx="3098800" cy="393698"/>
                  </a:xfrm>
                  <a:prstGeom prst="rect">
                    <a:avLst/>
                  </a:prstGeom>
                </p:spPr>
              </p:pic>
              <p:pic>
                <p:nvPicPr>
                  <p:cNvPr id="39" name="Immagine 38" descr="clustalw delta2.pdf"/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391" t="76251" r="15087" b="19147"/>
                  <a:stretch/>
                </p:blipFill>
                <p:spPr>
                  <a:xfrm>
                    <a:off x="3047998" y="4267133"/>
                    <a:ext cx="2751893" cy="393698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75" name="Gruppo 74"/>
                <p:cNvGrpSpPr/>
                <p:nvPr/>
              </p:nvGrpSpPr>
              <p:grpSpPr>
                <a:xfrm>
                  <a:off x="791655" y="4203324"/>
                  <a:ext cx="5550124" cy="400048"/>
                  <a:chOff x="249767" y="4008583"/>
                  <a:chExt cx="5550124" cy="400048"/>
                </a:xfrm>
              </p:grpSpPr>
              <p:pic>
                <p:nvPicPr>
                  <p:cNvPr id="36" name="Immagine 35" descr="clustalw delta2.pdf"/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8935" t="61604" r="9804" b="33794"/>
                  <a:stretch/>
                </p:blipFill>
                <p:spPr>
                  <a:xfrm>
                    <a:off x="249767" y="4014933"/>
                    <a:ext cx="3098800" cy="393698"/>
                  </a:xfrm>
                  <a:prstGeom prst="rect">
                    <a:avLst/>
                  </a:prstGeom>
                </p:spPr>
              </p:pic>
              <p:pic>
                <p:nvPicPr>
                  <p:cNvPr id="37" name="Immagine 36" descr="clustalw delta2.pdf"/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9215" t="66558" r="14982" b="28840"/>
                  <a:stretch/>
                </p:blipFill>
                <p:spPr>
                  <a:xfrm>
                    <a:off x="3031066" y="4008583"/>
                    <a:ext cx="2768825" cy="393698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86" name="Gruppo 85"/>
                <p:cNvGrpSpPr/>
                <p:nvPr/>
              </p:nvGrpSpPr>
              <p:grpSpPr>
                <a:xfrm>
                  <a:off x="787422" y="2414946"/>
                  <a:ext cx="5554357" cy="393700"/>
                  <a:chOff x="245534" y="2414946"/>
                  <a:chExt cx="5554357" cy="393700"/>
                </a:xfrm>
              </p:grpSpPr>
              <p:grpSp>
                <p:nvGrpSpPr>
                  <p:cNvPr id="70" name="Gruppo 69"/>
                  <p:cNvGrpSpPr/>
                  <p:nvPr/>
                </p:nvGrpSpPr>
                <p:grpSpPr>
                  <a:xfrm>
                    <a:off x="245534" y="2414946"/>
                    <a:ext cx="5554357" cy="393700"/>
                    <a:chOff x="245534" y="2414946"/>
                    <a:chExt cx="5554357" cy="393700"/>
                  </a:xfrm>
                </p:grpSpPr>
                <p:pic>
                  <p:nvPicPr>
                    <p:cNvPr id="23" name="Immagine 22" descr="clustalw delta1.pdf"/>
                    <p:cNvPicPr>
                      <a:picLocks noChangeAspect="1"/>
                    </p:cNvPicPr>
                    <p:nvPr/>
                  </p:nvPicPr>
                  <p:blipFill rotWithShape="1">
                    <a:blip r:embed="rId2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8795" t="66849" r="9944" b="28549"/>
                    <a:stretch/>
                  </p:blipFill>
                  <p:spPr>
                    <a:xfrm>
                      <a:off x="245534" y="2414946"/>
                      <a:ext cx="3098800" cy="3937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5" name="Immagine 24" descr="clustalw delta2.pdf"/>
                    <p:cNvPicPr>
                      <a:picLocks noChangeAspect="1"/>
                    </p:cNvPicPr>
                    <p:nvPr/>
                  </p:nvPicPr>
                  <p:blipFill rotWithShape="1">
                    <a:blip r:embed="rId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9075" t="6830" r="14983" b="88568"/>
                    <a:stretch/>
                  </p:blipFill>
                  <p:spPr>
                    <a:xfrm>
                      <a:off x="3022600" y="2414946"/>
                      <a:ext cx="2777291" cy="393699"/>
                    </a:xfrm>
                    <a:prstGeom prst="rect">
                      <a:avLst/>
                    </a:prstGeom>
                  </p:spPr>
                </p:pic>
              </p:grpSp>
              <p:sp>
                <p:nvSpPr>
                  <p:cNvPr id="84" name="Rettangolo 83"/>
                  <p:cNvSpPr/>
                  <p:nvPr/>
                </p:nvSpPr>
                <p:spPr>
                  <a:xfrm>
                    <a:off x="3047998" y="2473876"/>
                    <a:ext cx="110069" cy="9152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 sz="1662"/>
                  </a:p>
                </p:txBody>
              </p:sp>
              <p:sp>
                <p:nvSpPr>
                  <p:cNvPr id="85" name="Rettangolo 84"/>
                  <p:cNvSpPr/>
                  <p:nvPr/>
                </p:nvSpPr>
                <p:spPr>
                  <a:xfrm>
                    <a:off x="3077631" y="2689927"/>
                    <a:ext cx="110069" cy="9152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 sz="1662"/>
                  </a:p>
                </p:txBody>
              </p:sp>
            </p:grpSp>
            <p:sp>
              <p:nvSpPr>
                <p:cNvPr id="87" name="CasellaDiTesto 86"/>
                <p:cNvSpPr txBox="1"/>
                <p:nvPr/>
              </p:nvSpPr>
              <p:spPr>
                <a:xfrm>
                  <a:off x="11490" y="327133"/>
                  <a:ext cx="979090" cy="357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DELTA</a:t>
                  </a:r>
                </a:p>
              </p:txBody>
            </p:sp>
            <p:sp>
              <p:nvSpPr>
                <p:cNvPr id="88" name="CasellaDiTesto 87"/>
                <p:cNvSpPr txBox="1"/>
                <p:nvPr/>
              </p:nvSpPr>
              <p:spPr>
                <a:xfrm>
                  <a:off x="11490" y="2384862"/>
                  <a:ext cx="979090" cy="357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DELTA</a:t>
                  </a:r>
                </a:p>
              </p:txBody>
            </p:sp>
            <p:sp>
              <p:nvSpPr>
                <p:cNvPr id="89" name="CasellaDiTesto 88"/>
                <p:cNvSpPr txBox="1"/>
                <p:nvPr/>
              </p:nvSpPr>
              <p:spPr>
                <a:xfrm>
                  <a:off x="11490" y="2054775"/>
                  <a:ext cx="979090" cy="357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DELTA</a:t>
                  </a:r>
                </a:p>
              </p:txBody>
            </p:sp>
            <p:sp>
              <p:nvSpPr>
                <p:cNvPr id="90" name="CasellaDiTesto 89"/>
                <p:cNvSpPr txBox="1"/>
                <p:nvPr/>
              </p:nvSpPr>
              <p:spPr>
                <a:xfrm>
                  <a:off x="11490" y="1041414"/>
                  <a:ext cx="979090" cy="357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DELTA</a:t>
                  </a:r>
                </a:p>
              </p:txBody>
            </p:sp>
            <p:sp>
              <p:nvSpPr>
                <p:cNvPr id="91" name="CasellaDiTesto 90"/>
                <p:cNvSpPr txBox="1"/>
                <p:nvPr/>
              </p:nvSpPr>
              <p:spPr>
                <a:xfrm>
                  <a:off x="11490" y="1370882"/>
                  <a:ext cx="979090" cy="357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DELTA</a:t>
                  </a:r>
                </a:p>
              </p:txBody>
            </p:sp>
            <p:sp>
              <p:nvSpPr>
                <p:cNvPr id="92" name="CasellaDiTesto 91"/>
                <p:cNvSpPr txBox="1"/>
                <p:nvPr/>
              </p:nvSpPr>
              <p:spPr>
                <a:xfrm>
                  <a:off x="11490" y="1717903"/>
                  <a:ext cx="979090" cy="357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DELTA</a:t>
                  </a:r>
                </a:p>
              </p:txBody>
            </p:sp>
            <p:sp>
              <p:nvSpPr>
                <p:cNvPr id="93" name="CasellaDiTesto 92"/>
                <p:cNvSpPr txBox="1"/>
                <p:nvPr/>
              </p:nvSpPr>
              <p:spPr>
                <a:xfrm>
                  <a:off x="11490" y="679441"/>
                  <a:ext cx="979090" cy="357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DELTA</a:t>
                  </a:r>
                </a:p>
              </p:txBody>
            </p:sp>
            <p:sp>
              <p:nvSpPr>
                <p:cNvPr id="94" name="CasellaDiTesto 93"/>
                <p:cNvSpPr txBox="1"/>
                <p:nvPr/>
              </p:nvSpPr>
              <p:spPr>
                <a:xfrm>
                  <a:off x="11490" y="3310992"/>
                  <a:ext cx="979090" cy="357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DELTA</a:t>
                  </a:r>
                </a:p>
              </p:txBody>
            </p:sp>
            <p:sp>
              <p:nvSpPr>
                <p:cNvPr id="95" name="CasellaDiTesto 94"/>
                <p:cNvSpPr txBox="1"/>
                <p:nvPr/>
              </p:nvSpPr>
              <p:spPr>
                <a:xfrm>
                  <a:off x="11490" y="3006134"/>
                  <a:ext cx="979090" cy="357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DELTA</a:t>
                  </a:r>
                </a:p>
              </p:txBody>
            </p:sp>
            <p:sp>
              <p:nvSpPr>
                <p:cNvPr id="96" name="CasellaDiTesto 95"/>
                <p:cNvSpPr txBox="1"/>
                <p:nvPr/>
              </p:nvSpPr>
              <p:spPr>
                <a:xfrm>
                  <a:off x="11490" y="2713715"/>
                  <a:ext cx="979090" cy="357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DELTA</a:t>
                  </a:r>
                </a:p>
              </p:txBody>
            </p:sp>
            <p:sp>
              <p:nvSpPr>
                <p:cNvPr id="97" name="CasellaDiTesto 96"/>
                <p:cNvSpPr txBox="1"/>
                <p:nvPr/>
              </p:nvSpPr>
              <p:spPr>
                <a:xfrm>
                  <a:off x="11490" y="4199199"/>
                  <a:ext cx="979090" cy="357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DELTA</a:t>
                  </a:r>
                </a:p>
              </p:txBody>
            </p:sp>
            <p:sp>
              <p:nvSpPr>
                <p:cNvPr id="98" name="CasellaDiTesto 97"/>
                <p:cNvSpPr txBox="1"/>
                <p:nvPr/>
              </p:nvSpPr>
              <p:spPr>
                <a:xfrm>
                  <a:off x="11490" y="3591078"/>
                  <a:ext cx="979090" cy="357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DELTA</a:t>
                  </a:r>
                </a:p>
              </p:txBody>
            </p:sp>
            <p:sp>
              <p:nvSpPr>
                <p:cNvPr id="99" name="CasellaDiTesto 98"/>
                <p:cNvSpPr txBox="1"/>
                <p:nvPr/>
              </p:nvSpPr>
              <p:spPr>
                <a:xfrm>
                  <a:off x="11490" y="3888674"/>
                  <a:ext cx="979090" cy="357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DELTA</a:t>
                  </a:r>
                </a:p>
              </p:txBody>
            </p:sp>
            <p:sp>
              <p:nvSpPr>
                <p:cNvPr id="100" name="CasellaDiTesto 99"/>
                <p:cNvSpPr txBox="1"/>
                <p:nvPr/>
              </p:nvSpPr>
              <p:spPr>
                <a:xfrm>
                  <a:off x="11490" y="4512676"/>
                  <a:ext cx="979090" cy="357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DELTA</a:t>
                  </a:r>
                </a:p>
              </p:txBody>
            </p:sp>
            <p:sp>
              <p:nvSpPr>
                <p:cNvPr id="101" name="CasellaDiTesto 100"/>
                <p:cNvSpPr txBox="1"/>
                <p:nvPr/>
              </p:nvSpPr>
              <p:spPr>
                <a:xfrm>
                  <a:off x="11490" y="5478510"/>
                  <a:ext cx="979090" cy="357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DELTA</a:t>
                  </a:r>
                </a:p>
              </p:txBody>
            </p:sp>
            <p:sp>
              <p:nvSpPr>
                <p:cNvPr id="102" name="CasellaDiTesto 101"/>
                <p:cNvSpPr txBox="1"/>
                <p:nvPr/>
              </p:nvSpPr>
              <p:spPr>
                <a:xfrm>
                  <a:off x="11490" y="4828487"/>
                  <a:ext cx="979090" cy="357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DELTA</a:t>
                  </a:r>
                </a:p>
              </p:txBody>
            </p:sp>
            <p:sp>
              <p:nvSpPr>
                <p:cNvPr id="103" name="CasellaDiTesto 102"/>
                <p:cNvSpPr txBox="1"/>
                <p:nvPr/>
              </p:nvSpPr>
              <p:spPr>
                <a:xfrm>
                  <a:off x="11490" y="5162332"/>
                  <a:ext cx="979090" cy="357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DELTA</a:t>
                  </a:r>
                </a:p>
              </p:txBody>
            </p:sp>
            <p:sp>
              <p:nvSpPr>
                <p:cNvPr id="104" name="CasellaDiTesto 103"/>
                <p:cNvSpPr txBox="1"/>
                <p:nvPr/>
              </p:nvSpPr>
              <p:spPr>
                <a:xfrm>
                  <a:off x="11490" y="5825531"/>
                  <a:ext cx="979090" cy="357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DELTA</a:t>
                  </a:r>
                </a:p>
              </p:txBody>
            </p:sp>
            <p:sp>
              <p:nvSpPr>
                <p:cNvPr id="105" name="CasellaDiTesto 104"/>
                <p:cNvSpPr txBox="1"/>
                <p:nvPr/>
              </p:nvSpPr>
              <p:spPr>
                <a:xfrm>
                  <a:off x="11490" y="6172552"/>
                  <a:ext cx="979090" cy="357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DELTA</a:t>
                  </a:r>
                </a:p>
              </p:txBody>
            </p:sp>
            <p:sp>
              <p:nvSpPr>
                <p:cNvPr id="106" name="CasellaDiTesto 105"/>
                <p:cNvSpPr txBox="1"/>
                <p:nvPr/>
              </p:nvSpPr>
              <p:spPr>
                <a:xfrm>
                  <a:off x="11490" y="6502639"/>
                  <a:ext cx="979090" cy="357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DELTA</a:t>
                  </a:r>
                </a:p>
              </p:txBody>
            </p:sp>
            <p:sp>
              <p:nvSpPr>
                <p:cNvPr id="107" name="CasellaDiTesto 106"/>
                <p:cNvSpPr txBox="1"/>
                <p:nvPr/>
              </p:nvSpPr>
              <p:spPr>
                <a:xfrm>
                  <a:off x="11490" y="6852024"/>
                  <a:ext cx="979090" cy="357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S. lyc</a:t>
                  </a:r>
                </a:p>
                <a:p>
                  <a:r>
                    <a:rPr lang="it-IT" sz="738" dirty="0">
                      <a:latin typeface="American Typewriter"/>
                      <a:cs typeface="American Typewriter"/>
                    </a:rPr>
                    <a:t>&gt;LCY-e_DELTA</a:t>
                  </a:r>
                </a:p>
              </p:txBody>
            </p:sp>
          </p:grpSp>
          <p:sp>
            <p:nvSpPr>
              <p:cNvPr id="109" name="Rettangolo 108"/>
              <p:cNvSpPr/>
              <p:nvPr/>
            </p:nvSpPr>
            <p:spPr>
              <a:xfrm>
                <a:off x="1050055" y="6343889"/>
                <a:ext cx="287998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110" name="CasellaDiTesto 109"/>
              <p:cNvSpPr txBox="1"/>
              <p:nvPr/>
            </p:nvSpPr>
            <p:spPr>
              <a:xfrm>
                <a:off x="1058522" y="6420507"/>
                <a:ext cx="339150" cy="246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16</a:t>
                </a:r>
              </a:p>
            </p:txBody>
          </p:sp>
          <p:sp>
            <p:nvSpPr>
              <p:cNvPr id="112" name="Rettangolo 111"/>
              <p:cNvSpPr/>
              <p:nvPr/>
            </p:nvSpPr>
            <p:spPr>
              <a:xfrm>
                <a:off x="6384056" y="6000355"/>
                <a:ext cx="143997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115" name="Rettangolo 114"/>
              <p:cNvSpPr/>
              <p:nvPr/>
            </p:nvSpPr>
            <p:spPr>
              <a:xfrm>
                <a:off x="5522506" y="6676740"/>
                <a:ext cx="395998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116" name="CasellaDiTesto 115"/>
              <p:cNvSpPr txBox="1"/>
              <p:nvPr/>
            </p:nvSpPr>
            <p:spPr>
              <a:xfrm>
                <a:off x="5550023" y="6769234"/>
                <a:ext cx="339150" cy="246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17</a:t>
                </a:r>
              </a:p>
            </p:txBody>
          </p:sp>
          <p:sp>
            <p:nvSpPr>
              <p:cNvPr id="119" name="Rettangolo 118"/>
              <p:cNvSpPr/>
              <p:nvPr/>
            </p:nvSpPr>
            <p:spPr>
              <a:xfrm>
                <a:off x="5357861" y="2887676"/>
                <a:ext cx="359998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120" name="CasellaDiTesto 119"/>
              <p:cNvSpPr txBox="1"/>
              <p:nvPr/>
            </p:nvSpPr>
            <p:spPr>
              <a:xfrm>
                <a:off x="5413433" y="2936782"/>
                <a:ext cx="272827" cy="246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3</a:t>
                </a:r>
              </a:p>
            </p:txBody>
          </p:sp>
          <p:sp>
            <p:nvSpPr>
              <p:cNvPr id="121" name="Rettangolo 120"/>
              <p:cNvSpPr/>
              <p:nvPr/>
            </p:nvSpPr>
            <p:spPr>
              <a:xfrm>
                <a:off x="1062275" y="5339982"/>
                <a:ext cx="179997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122" name="CasellaDiTesto 121"/>
              <p:cNvSpPr txBox="1"/>
              <p:nvPr/>
            </p:nvSpPr>
            <p:spPr>
              <a:xfrm>
                <a:off x="1027846" y="5398444"/>
                <a:ext cx="272827" cy="246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3</a:t>
                </a:r>
              </a:p>
            </p:txBody>
          </p:sp>
          <p:sp>
            <p:nvSpPr>
              <p:cNvPr id="123" name="Rettangolo 122"/>
              <p:cNvSpPr/>
              <p:nvPr/>
            </p:nvSpPr>
            <p:spPr>
              <a:xfrm>
                <a:off x="6329006" y="4979300"/>
                <a:ext cx="179997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124" name="Rettangolo 123"/>
              <p:cNvSpPr/>
              <p:nvPr/>
            </p:nvSpPr>
            <p:spPr>
              <a:xfrm>
                <a:off x="3571196" y="3192454"/>
                <a:ext cx="431995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125" name="CasellaDiTesto 124"/>
              <p:cNvSpPr txBox="1"/>
              <p:nvPr/>
            </p:nvSpPr>
            <p:spPr>
              <a:xfrm>
                <a:off x="3662766" y="3250022"/>
                <a:ext cx="272827" cy="246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7</a:t>
                </a:r>
              </a:p>
            </p:txBody>
          </p:sp>
          <p:sp>
            <p:nvSpPr>
              <p:cNvPr id="126" name="Rettangolo 125"/>
              <p:cNvSpPr/>
              <p:nvPr/>
            </p:nvSpPr>
            <p:spPr>
              <a:xfrm>
                <a:off x="1636306" y="4678093"/>
                <a:ext cx="359998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127" name="CasellaDiTesto 126"/>
              <p:cNvSpPr txBox="1"/>
              <p:nvPr/>
            </p:nvSpPr>
            <p:spPr>
              <a:xfrm>
                <a:off x="1691878" y="4738837"/>
                <a:ext cx="339150" cy="246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11</a:t>
                </a:r>
              </a:p>
            </p:txBody>
          </p:sp>
          <p:sp>
            <p:nvSpPr>
              <p:cNvPr id="128" name="Rettangolo 127"/>
              <p:cNvSpPr/>
              <p:nvPr/>
            </p:nvSpPr>
            <p:spPr>
              <a:xfrm>
                <a:off x="4404968" y="2887676"/>
                <a:ext cx="287998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129" name="CasellaDiTesto 128"/>
              <p:cNvSpPr txBox="1"/>
              <p:nvPr/>
            </p:nvSpPr>
            <p:spPr>
              <a:xfrm>
                <a:off x="4424540" y="2936782"/>
                <a:ext cx="272827" cy="246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2</a:t>
                </a:r>
              </a:p>
            </p:txBody>
          </p:sp>
          <p:sp>
            <p:nvSpPr>
              <p:cNvPr id="130" name="Rettangolo 129"/>
              <p:cNvSpPr/>
              <p:nvPr/>
            </p:nvSpPr>
            <p:spPr>
              <a:xfrm>
                <a:off x="6164361" y="3497628"/>
                <a:ext cx="287998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131" name="CasellaDiTesto 130"/>
              <p:cNvSpPr txBox="1"/>
              <p:nvPr/>
            </p:nvSpPr>
            <p:spPr>
              <a:xfrm>
                <a:off x="6183933" y="3542495"/>
                <a:ext cx="272827" cy="246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2</a:t>
                </a:r>
              </a:p>
            </p:txBody>
          </p:sp>
          <p:sp>
            <p:nvSpPr>
              <p:cNvPr id="132" name="Rettangolo 131"/>
              <p:cNvSpPr/>
              <p:nvPr/>
            </p:nvSpPr>
            <p:spPr>
              <a:xfrm>
                <a:off x="2544861" y="3192454"/>
                <a:ext cx="359998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133" name="CasellaDiTesto 132"/>
              <p:cNvSpPr txBox="1"/>
              <p:nvPr/>
            </p:nvSpPr>
            <p:spPr>
              <a:xfrm>
                <a:off x="2511188" y="3250022"/>
                <a:ext cx="272827" cy="246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5</a:t>
                </a:r>
              </a:p>
            </p:txBody>
          </p:sp>
          <p:sp>
            <p:nvSpPr>
              <p:cNvPr id="134" name="Rettangolo 133"/>
              <p:cNvSpPr/>
              <p:nvPr/>
            </p:nvSpPr>
            <p:spPr>
              <a:xfrm>
                <a:off x="1492307" y="4380543"/>
                <a:ext cx="323998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135" name="CasellaDiTesto 134"/>
              <p:cNvSpPr txBox="1"/>
              <p:nvPr/>
            </p:nvSpPr>
            <p:spPr>
              <a:xfrm>
                <a:off x="1529880" y="4438112"/>
                <a:ext cx="339150" cy="246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10</a:t>
                </a:r>
              </a:p>
            </p:txBody>
          </p:sp>
          <p:sp>
            <p:nvSpPr>
              <p:cNvPr id="136" name="Rettangolo 135"/>
              <p:cNvSpPr/>
              <p:nvPr/>
            </p:nvSpPr>
            <p:spPr>
              <a:xfrm>
                <a:off x="1866957" y="4380543"/>
                <a:ext cx="323998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137" name="CasellaDiTesto 136"/>
              <p:cNvSpPr txBox="1"/>
              <p:nvPr/>
            </p:nvSpPr>
            <p:spPr>
              <a:xfrm>
                <a:off x="1904529" y="4438112"/>
                <a:ext cx="339150" cy="246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10</a:t>
                </a:r>
              </a:p>
            </p:txBody>
          </p:sp>
          <p:sp>
            <p:nvSpPr>
              <p:cNvPr id="138" name="Rettangolo 137"/>
              <p:cNvSpPr/>
              <p:nvPr/>
            </p:nvSpPr>
            <p:spPr>
              <a:xfrm>
                <a:off x="5623129" y="1226305"/>
                <a:ext cx="467998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139" name="CasellaDiTesto 138"/>
              <p:cNvSpPr txBox="1"/>
              <p:nvPr/>
            </p:nvSpPr>
            <p:spPr>
              <a:xfrm>
                <a:off x="5732701" y="1288106"/>
                <a:ext cx="272827" cy="246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1</a:t>
                </a:r>
              </a:p>
            </p:txBody>
          </p:sp>
          <p:sp>
            <p:nvSpPr>
              <p:cNvPr id="140" name="Rettangolo 139"/>
              <p:cNvSpPr/>
              <p:nvPr/>
            </p:nvSpPr>
            <p:spPr>
              <a:xfrm>
                <a:off x="4780767" y="4980244"/>
                <a:ext cx="359998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141" name="CasellaDiTesto 140"/>
              <p:cNvSpPr txBox="1"/>
              <p:nvPr/>
            </p:nvSpPr>
            <p:spPr>
              <a:xfrm>
                <a:off x="4804244" y="5038706"/>
                <a:ext cx="339150" cy="246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13</a:t>
                </a:r>
              </a:p>
            </p:txBody>
          </p:sp>
          <p:sp>
            <p:nvSpPr>
              <p:cNvPr id="142" name="Rettangolo 141"/>
              <p:cNvSpPr/>
              <p:nvPr/>
            </p:nvSpPr>
            <p:spPr>
              <a:xfrm>
                <a:off x="4130769" y="3497628"/>
                <a:ext cx="467998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143" name="CasellaDiTesto 142"/>
              <p:cNvSpPr txBox="1"/>
              <p:nvPr/>
            </p:nvSpPr>
            <p:spPr>
              <a:xfrm>
                <a:off x="4211430" y="3542495"/>
                <a:ext cx="272827" cy="246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9</a:t>
                </a:r>
              </a:p>
            </p:txBody>
          </p:sp>
          <p:sp>
            <p:nvSpPr>
              <p:cNvPr id="144" name="Rettangolo 143"/>
              <p:cNvSpPr/>
              <p:nvPr/>
            </p:nvSpPr>
            <p:spPr>
              <a:xfrm>
                <a:off x="3193628" y="4678093"/>
                <a:ext cx="395998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145" name="CasellaDiTesto 144"/>
              <p:cNvSpPr txBox="1"/>
              <p:nvPr/>
            </p:nvSpPr>
            <p:spPr>
              <a:xfrm>
                <a:off x="3235105" y="4738837"/>
                <a:ext cx="339150" cy="246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12</a:t>
                </a:r>
              </a:p>
            </p:txBody>
          </p:sp>
          <p:sp>
            <p:nvSpPr>
              <p:cNvPr id="146" name="Rettangolo 145"/>
              <p:cNvSpPr/>
              <p:nvPr/>
            </p:nvSpPr>
            <p:spPr>
              <a:xfrm>
                <a:off x="2622574" y="3192454"/>
                <a:ext cx="287998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147" name="CasellaDiTesto 146"/>
              <p:cNvSpPr txBox="1"/>
              <p:nvPr/>
            </p:nvSpPr>
            <p:spPr>
              <a:xfrm>
                <a:off x="2694542" y="3250022"/>
                <a:ext cx="272827" cy="246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6</a:t>
                </a:r>
              </a:p>
            </p:txBody>
          </p:sp>
          <p:sp>
            <p:nvSpPr>
              <p:cNvPr id="149" name="Rettangolo 148"/>
              <p:cNvSpPr/>
              <p:nvPr/>
            </p:nvSpPr>
            <p:spPr>
              <a:xfrm>
                <a:off x="4831473" y="3192454"/>
                <a:ext cx="467998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150" name="CasellaDiTesto 149"/>
              <p:cNvSpPr txBox="1"/>
              <p:nvPr/>
            </p:nvSpPr>
            <p:spPr>
              <a:xfrm>
                <a:off x="4908950" y="3250022"/>
                <a:ext cx="272827" cy="246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8</a:t>
                </a:r>
              </a:p>
            </p:txBody>
          </p:sp>
          <p:sp>
            <p:nvSpPr>
              <p:cNvPr id="151" name="Rettangolo 150"/>
              <p:cNvSpPr/>
              <p:nvPr/>
            </p:nvSpPr>
            <p:spPr>
              <a:xfrm>
                <a:off x="2599611" y="5650423"/>
                <a:ext cx="359997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152" name="CasellaDiTesto 151"/>
              <p:cNvSpPr txBox="1"/>
              <p:nvPr/>
            </p:nvSpPr>
            <p:spPr>
              <a:xfrm>
                <a:off x="2623087" y="5727042"/>
                <a:ext cx="339150" cy="246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15</a:t>
                </a:r>
              </a:p>
            </p:txBody>
          </p:sp>
          <p:sp>
            <p:nvSpPr>
              <p:cNvPr id="158" name="Rettangolo 157"/>
              <p:cNvSpPr/>
              <p:nvPr/>
            </p:nvSpPr>
            <p:spPr>
              <a:xfrm>
                <a:off x="4044970" y="5339982"/>
                <a:ext cx="431998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159" name="CasellaDiTesto 158"/>
              <p:cNvSpPr txBox="1"/>
              <p:nvPr/>
            </p:nvSpPr>
            <p:spPr>
              <a:xfrm>
                <a:off x="4104446" y="5398444"/>
                <a:ext cx="339150" cy="246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14</a:t>
                </a:r>
              </a:p>
            </p:txBody>
          </p:sp>
          <p:sp>
            <p:nvSpPr>
              <p:cNvPr id="160" name="Rettangolo 159"/>
              <p:cNvSpPr/>
              <p:nvPr/>
            </p:nvSpPr>
            <p:spPr>
              <a:xfrm>
                <a:off x="5634233" y="6676740"/>
                <a:ext cx="431998" cy="105833"/>
              </a:xfrm>
              <a:prstGeom prst="rect">
                <a:avLst/>
              </a:prstGeom>
              <a:noFill/>
              <a:ln w="12700" cmpd="sng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161" name="CasellaDiTesto 160"/>
              <p:cNvSpPr txBox="1"/>
              <p:nvPr/>
            </p:nvSpPr>
            <p:spPr>
              <a:xfrm>
                <a:off x="5723136" y="6769234"/>
                <a:ext cx="339150" cy="246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31" b="1" dirty="0">
                    <a:latin typeface="Arial"/>
                    <a:cs typeface="Arial"/>
                  </a:rPr>
                  <a:t>14</a:t>
                </a:r>
              </a:p>
            </p:txBody>
          </p:sp>
          <p:cxnSp>
            <p:nvCxnSpPr>
              <p:cNvPr id="167" name="Connettore 1 166"/>
              <p:cNvCxnSpPr/>
              <p:nvPr/>
            </p:nvCxnSpPr>
            <p:spPr>
              <a:xfrm flipV="1">
                <a:off x="2085121" y="6903792"/>
                <a:ext cx="0" cy="251998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8" name="Connettore 1 167"/>
              <p:cNvCxnSpPr/>
              <p:nvPr/>
            </p:nvCxnSpPr>
            <p:spPr>
              <a:xfrm rot="16200000" flipV="1">
                <a:off x="2190954" y="6802193"/>
                <a:ext cx="0" cy="211667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  <a:headEnd type="stealth"/>
                <a:tailEnd type="non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8" name="CasellaDiTesto 187"/>
              <p:cNvSpPr txBox="1"/>
              <p:nvPr/>
            </p:nvSpPr>
            <p:spPr>
              <a:xfrm>
                <a:off x="6453930" y="6875878"/>
                <a:ext cx="443117" cy="325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46" dirty="0">
                    <a:latin typeface="American Typewriter"/>
                    <a:cs typeface="American Typewriter"/>
                  </a:rPr>
                  <a:t>1023</a:t>
                </a:r>
              </a:p>
              <a:p>
                <a:r>
                  <a:rPr lang="it-IT" sz="646" dirty="0">
                    <a:latin typeface="American Typewriter"/>
                    <a:cs typeface="American Typewriter"/>
                  </a:rPr>
                  <a:t>2037</a:t>
                </a:r>
              </a:p>
            </p:txBody>
          </p:sp>
          <p:sp>
            <p:nvSpPr>
              <p:cNvPr id="169" name="CasellaDiTesto 168"/>
              <p:cNvSpPr txBox="1"/>
              <p:nvPr/>
            </p:nvSpPr>
            <p:spPr>
              <a:xfrm>
                <a:off x="6453930" y="339831"/>
                <a:ext cx="383964" cy="325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46" dirty="0">
                    <a:latin typeface="American Typewriter"/>
                    <a:cs typeface="American Typewriter"/>
                  </a:rPr>
                  <a:t>99</a:t>
                </a:r>
              </a:p>
              <a:p>
                <a:r>
                  <a:rPr lang="it-IT" sz="646" dirty="0">
                    <a:latin typeface="American Typewriter"/>
                    <a:cs typeface="American Typewriter"/>
                  </a:rPr>
                  <a:t>100</a:t>
                </a:r>
              </a:p>
            </p:txBody>
          </p:sp>
          <p:sp>
            <p:nvSpPr>
              <p:cNvPr id="170" name="CasellaDiTesto 169"/>
              <p:cNvSpPr txBox="1"/>
              <p:nvPr/>
            </p:nvSpPr>
            <p:spPr>
              <a:xfrm>
                <a:off x="6453930" y="696373"/>
                <a:ext cx="383964" cy="325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46" dirty="0">
                    <a:latin typeface="American Typewriter"/>
                    <a:cs typeface="American Typewriter"/>
                  </a:rPr>
                  <a:t>199</a:t>
                </a:r>
              </a:p>
              <a:p>
                <a:r>
                  <a:rPr lang="it-IT" sz="646" dirty="0">
                    <a:latin typeface="American Typewriter"/>
                    <a:cs typeface="American Typewriter"/>
                  </a:rPr>
                  <a:t>199</a:t>
                </a:r>
              </a:p>
            </p:txBody>
          </p:sp>
          <p:sp>
            <p:nvSpPr>
              <p:cNvPr id="171" name="CasellaDiTesto 170"/>
              <p:cNvSpPr txBox="1"/>
              <p:nvPr/>
            </p:nvSpPr>
            <p:spPr>
              <a:xfrm>
                <a:off x="6453930" y="1059192"/>
                <a:ext cx="383964" cy="325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46" dirty="0">
                    <a:latin typeface="American Typewriter"/>
                    <a:cs typeface="American Typewriter"/>
                  </a:rPr>
                  <a:t>299</a:t>
                </a:r>
              </a:p>
              <a:p>
                <a:r>
                  <a:rPr lang="it-IT" sz="646" dirty="0">
                    <a:latin typeface="American Typewriter"/>
                    <a:cs typeface="American Typewriter"/>
                  </a:rPr>
                  <a:t>299</a:t>
                </a:r>
              </a:p>
            </p:txBody>
          </p:sp>
          <p:sp>
            <p:nvSpPr>
              <p:cNvPr id="172" name="CasellaDiTesto 171"/>
              <p:cNvSpPr txBox="1"/>
              <p:nvPr/>
            </p:nvSpPr>
            <p:spPr>
              <a:xfrm>
                <a:off x="6453930" y="1384433"/>
                <a:ext cx="383964" cy="325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46" dirty="0">
                    <a:latin typeface="American Typewriter"/>
                    <a:cs typeface="American Typewriter"/>
                  </a:rPr>
                  <a:t>399</a:t>
                </a:r>
              </a:p>
              <a:p>
                <a:r>
                  <a:rPr lang="it-IT" sz="646" dirty="0">
                    <a:latin typeface="American Typewriter"/>
                    <a:cs typeface="American Typewriter"/>
                  </a:rPr>
                  <a:t>399</a:t>
                </a:r>
              </a:p>
            </p:txBody>
          </p:sp>
          <p:sp>
            <p:nvSpPr>
              <p:cNvPr id="173" name="CasellaDiTesto 172"/>
              <p:cNvSpPr txBox="1"/>
              <p:nvPr/>
            </p:nvSpPr>
            <p:spPr>
              <a:xfrm>
                <a:off x="6453930" y="1739919"/>
                <a:ext cx="383964" cy="325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46" dirty="0">
                    <a:latin typeface="American Typewriter"/>
                    <a:cs typeface="American Typewriter"/>
                  </a:rPr>
                  <a:t>496</a:t>
                </a:r>
              </a:p>
              <a:p>
                <a:r>
                  <a:rPr lang="it-IT" sz="646" dirty="0">
                    <a:latin typeface="American Typewriter"/>
                    <a:cs typeface="American Typewriter"/>
                  </a:rPr>
                  <a:t>499</a:t>
                </a:r>
              </a:p>
            </p:txBody>
          </p:sp>
          <p:sp>
            <p:nvSpPr>
              <p:cNvPr id="174" name="CasellaDiTesto 173"/>
              <p:cNvSpPr txBox="1"/>
              <p:nvPr/>
            </p:nvSpPr>
            <p:spPr>
              <a:xfrm>
                <a:off x="6453930" y="2072062"/>
                <a:ext cx="383964" cy="325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46" dirty="0">
                    <a:latin typeface="American Typewriter"/>
                    <a:cs typeface="American Typewriter"/>
                  </a:rPr>
                  <a:t>596</a:t>
                </a:r>
              </a:p>
              <a:p>
                <a:r>
                  <a:rPr lang="it-IT" sz="646" dirty="0">
                    <a:latin typeface="American Typewriter"/>
                    <a:cs typeface="American Typewriter"/>
                  </a:rPr>
                  <a:t>589</a:t>
                </a:r>
              </a:p>
            </p:txBody>
          </p:sp>
          <p:sp>
            <p:nvSpPr>
              <p:cNvPr id="175" name="CasellaDiTesto 174"/>
              <p:cNvSpPr txBox="1"/>
              <p:nvPr/>
            </p:nvSpPr>
            <p:spPr>
              <a:xfrm>
                <a:off x="6453930" y="2399412"/>
                <a:ext cx="383964" cy="325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46" dirty="0">
                    <a:latin typeface="American Typewriter"/>
                    <a:cs typeface="American Typewriter"/>
                  </a:rPr>
                  <a:t>635</a:t>
                </a:r>
              </a:p>
              <a:p>
                <a:r>
                  <a:rPr lang="it-IT" sz="646" dirty="0">
                    <a:latin typeface="American Typewriter"/>
                    <a:cs typeface="American Typewriter"/>
                  </a:rPr>
                  <a:t>700</a:t>
                </a:r>
              </a:p>
            </p:txBody>
          </p:sp>
          <p:sp>
            <p:nvSpPr>
              <p:cNvPr id="176" name="CasellaDiTesto 175"/>
              <p:cNvSpPr txBox="1"/>
              <p:nvPr/>
            </p:nvSpPr>
            <p:spPr>
              <a:xfrm>
                <a:off x="6453930" y="2729555"/>
                <a:ext cx="383964" cy="325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46" dirty="0">
                    <a:latin typeface="American Typewriter"/>
                    <a:cs typeface="American Typewriter"/>
                  </a:rPr>
                  <a:t>635</a:t>
                </a:r>
              </a:p>
              <a:p>
                <a:r>
                  <a:rPr lang="it-IT" sz="646" dirty="0">
                    <a:latin typeface="American Typewriter"/>
                    <a:cs typeface="American Typewriter"/>
                  </a:rPr>
                  <a:t>800</a:t>
                </a:r>
              </a:p>
            </p:txBody>
          </p:sp>
          <p:sp>
            <p:nvSpPr>
              <p:cNvPr id="177" name="CasellaDiTesto 176"/>
              <p:cNvSpPr txBox="1"/>
              <p:nvPr/>
            </p:nvSpPr>
            <p:spPr>
              <a:xfrm>
                <a:off x="6453930" y="3030099"/>
                <a:ext cx="383964" cy="325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46" dirty="0">
                    <a:latin typeface="American Typewriter"/>
                    <a:cs typeface="American Typewriter"/>
                  </a:rPr>
                  <a:t>635</a:t>
                </a:r>
              </a:p>
              <a:p>
                <a:r>
                  <a:rPr lang="it-IT" sz="646" dirty="0">
                    <a:latin typeface="American Typewriter"/>
                    <a:cs typeface="American Typewriter"/>
                  </a:rPr>
                  <a:t>900</a:t>
                </a:r>
              </a:p>
            </p:txBody>
          </p:sp>
          <p:sp>
            <p:nvSpPr>
              <p:cNvPr id="178" name="CasellaDiTesto 177"/>
              <p:cNvSpPr txBox="1"/>
              <p:nvPr/>
            </p:nvSpPr>
            <p:spPr>
              <a:xfrm>
                <a:off x="6453930" y="3335276"/>
                <a:ext cx="443117" cy="325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46" dirty="0">
                    <a:latin typeface="American Typewriter"/>
                    <a:cs typeface="American Typewriter"/>
                  </a:rPr>
                  <a:t>635</a:t>
                </a:r>
              </a:p>
              <a:p>
                <a:r>
                  <a:rPr lang="it-IT" sz="646" dirty="0">
                    <a:latin typeface="American Typewriter"/>
                    <a:cs typeface="American Typewriter"/>
                  </a:rPr>
                  <a:t>1000</a:t>
                </a:r>
              </a:p>
            </p:txBody>
          </p:sp>
          <p:sp>
            <p:nvSpPr>
              <p:cNvPr id="179" name="CasellaDiTesto 178"/>
              <p:cNvSpPr txBox="1"/>
              <p:nvPr/>
            </p:nvSpPr>
            <p:spPr>
              <a:xfrm>
                <a:off x="6453930" y="3601820"/>
                <a:ext cx="443117" cy="325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46" dirty="0">
                    <a:latin typeface="American Typewriter"/>
                    <a:cs typeface="American Typewriter"/>
                  </a:rPr>
                  <a:t>635</a:t>
                </a:r>
              </a:p>
              <a:p>
                <a:r>
                  <a:rPr lang="it-IT" sz="646" dirty="0">
                    <a:latin typeface="American Typewriter"/>
                    <a:cs typeface="American Typewriter"/>
                  </a:rPr>
                  <a:t>1100</a:t>
                </a:r>
              </a:p>
            </p:txBody>
          </p:sp>
          <p:sp>
            <p:nvSpPr>
              <p:cNvPr id="180" name="CasellaDiTesto 179"/>
              <p:cNvSpPr txBox="1"/>
              <p:nvPr/>
            </p:nvSpPr>
            <p:spPr>
              <a:xfrm>
                <a:off x="6453930" y="3905364"/>
                <a:ext cx="443117" cy="325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46" dirty="0">
                    <a:latin typeface="American Typewriter"/>
                    <a:cs typeface="American Typewriter"/>
                  </a:rPr>
                  <a:t>635</a:t>
                </a:r>
              </a:p>
              <a:p>
                <a:r>
                  <a:rPr lang="it-IT" sz="646" dirty="0">
                    <a:latin typeface="American Typewriter"/>
                    <a:cs typeface="American Typewriter"/>
                  </a:rPr>
                  <a:t>1200</a:t>
                </a:r>
              </a:p>
            </p:txBody>
          </p:sp>
          <p:sp>
            <p:nvSpPr>
              <p:cNvPr id="181" name="CasellaDiTesto 180"/>
              <p:cNvSpPr txBox="1"/>
              <p:nvPr/>
            </p:nvSpPr>
            <p:spPr>
              <a:xfrm>
                <a:off x="6453930" y="4213591"/>
                <a:ext cx="443117" cy="325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46" dirty="0">
                    <a:latin typeface="American Typewriter"/>
                    <a:cs typeface="American Typewriter"/>
                  </a:rPr>
                  <a:t>635</a:t>
                </a:r>
              </a:p>
              <a:p>
                <a:r>
                  <a:rPr lang="it-IT" sz="646" dirty="0">
                    <a:latin typeface="American Typewriter"/>
                    <a:cs typeface="American Typewriter"/>
                  </a:rPr>
                  <a:t>1300</a:t>
                </a:r>
              </a:p>
            </p:txBody>
          </p:sp>
          <p:sp>
            <p:nvSpPr>
              <p:cNvPr id="182" name="CasellaDiTesto 181"/>
              <p:cNvSpPr txBox="1"/>
              <p:nvPr/>
            </p:nvSpPr>
            <p:spPr>
              <a:xfrm>
                <a:off x="6453930" y="4515738"/>
                <a:ext cx="443117" cy="325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46" dirty="0">
                    <a:latin typeface="American Typewriter"/>
                    <a:cs typeface="American Typewriter"/>
                  </a:rPr>
                  <a:t>635</a:t>
                </a:r>
              </a:p>
              <a:p>
                <a:r>
                  <a:rPr lang="it-IT" sz="646" dirty="0">
                    <a:latin typeface="American Typewriter"/>
                    <a:cs typeface="American Typewriter"/>
                  </a:rPr>
                  <a:t>1400</a:t>
                </a:r>
              </a:p>
            </p:txBody>
          </p:sp>
          <p:sp>
            <p:nvSpPr>
              <p:cNvPr id="183" name="CasellaDiTesto 182"/>
              <p:cNvSpPr txBox="1"/>
              <p:nvPr/>
            </p:nvSpPr>
            <p:spPr>
              <a:xfrm>
                <a:off x="6453930" y="4824254"/>
                <a:ext cx="443117" cy="325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46" dirty="0">
                    <a:latin typeface="American Typewriter"/>
                    <a:cs typeface="American Typewriter"/>
                  </a:rPr>
                  <a:t>635</a:t>
                </a:r>
              </a:p>
              <a:p>
                <a:r>
                  <a:rPr lang="it-IT" sz="646" dirty="0">
                    <a:latin typeface="American Typewriter"/>
                    <a:cs typeface="American Typewriter"/>
                  </a:rPr>
                  <a:t>1500</a:t>
                </a:r>
              </a:p>
            </p:txBody>
          </p:sp>
          <p:sp>
            <p:nvSpPr>
              <p:cNvPr id="184" name="CasellaDiTesto 183"/>
              <p:cNvSpPr txBox="1"/>
              <p:nvPr/>
            </p:nvSpPr>
            <p:spPr>
              <a:xfrm>
                <a:off x="6453930" y="5178855"/>
                <a:ext cx="443117" cy="325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46" dirty="0">
                    <a:latin typeface="American Typewriter"/>
                    <a:cs typeface="American Typewriter"/>
                  </a:rPr>
                  <a:t>635</a:t>
                </a:r>
              </a:p>
              <a:p>
                <a:r>
                  <a:rPr lang="it-IT" sz="646" dirty="0">
                    <a:latin typeface="American Typewriter"/>
                    <a:cs typeface="American Typewriter"/>
                  </a:rPr>
                  <a:t>1600</a:t>
                </a:r>
              </a:p>
            </p:txBody>
          </p:sp>
          <p:sp>
            <p:nvSpPr>
              <p:cNvPr id="185" name="CasellaDiTesto 184"/>
              <p:cNvSpPr txBox="1"/>
              <p:nvPr/>
            </p:nvSpPr>
            <p:spPr>
              <a:xfrm>
                <a:off x="6453930" y="5492300"/>
                <a:ext cx="443117" cy="325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46" dirty="0">
                    <a:latin typeface="American Typewriter"/>
                    <a:cs typeface="American Typewriter"/>
                  </a:rPr>
                  <a:t>673</a:t>
                </a:r>
              </a:p>
              <a:p>
                <a:r>
                  <a:rPr lang="it-IT" sz="646" dirty="0">
                    <a:latin typeface="American Typewriter"/>
                    <a:cs typeface="American Typewriter"/>
                  </a:rPr>
                  <a:t>1689</a:t>
                </a:r>
              </a:p>
            </p:txBody>
          </p:sp>
          <p:sp>
            <p:nvSpPr>
              <p:cNvPr id="186" name="CasellaDiTesto 185"/>
              <p:cNvSpPr txBox="1"/>
              <p:nvPr/>
            </p:nvSpPr>
            <p:spPr>
              <a:xfrm>
                <a:off x="6453930" y="5835143"/>
                <a:ext cx="443117" cy="325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46" dirty="0">
                    <a:latin typeface="American Typewriter"/>
                    <a:cs typeface="American Typewriter"/>
                  </a:rPr>
                  <a:t>773</a:t>
                </a:r>
              </a:p>
              <a:p>
                <a:r>
                  <a:rPr lang="it-IT" sz="646" dirty="0">
                    <a:latin typeface="American Typewriter"/>
                    <a:cs typeface="American Typewriter"/>
                  </a:rPr>
                  <a:t>1789</a:t>
                </a:r>
              </a:p>
            </p:txBody>
          </p:sp>
          <p:sp>
            <p:nvSpPr>
              <p:cNvPr id="187" name="CasellaDiTesto 186"/>
              <p:cNvSpPr txBox="1"/>
              <p:nvPr/>
            </p:nvSpPr>
            <p:spPr>
              <a:xfrm>
                <a:off x="6453930" y="6193094"/>
                <a:ext cx="443117" cy="325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46" dirty="0">
                    <a:latin typeface="American Typewriter"/>
                    <a:cs typeface="American Typewriter"/>
                  </a:rPr>
                  <a:t>873</a:t>
                </a:r>
              </a:p>
              <a:p>
                <a:r>
                  <a:rPr lang="it-IT" sz="646" dirty="0">
                    <a:latin typeface="American Typewriter"/>
                    <a:cs typeface="American Typewriter"/>
                  </a:rPr>
                  <a:t>1889</a:t>
                </a:r>
              </a:p>
            </p:txBody>
          </p:sp>
          <p:sp>
            <p:nvSpPr>
              <p:cNvPr id="189" name="CasellaDiTesto 188"/>
              <p:cNvSpPr txBox="1"/>
              <p:nvPr/>
            </p:nvSpPr>
            <p:spPr>
              <a:xfrm>
                <a:off x="6453930" y="6516190"/>
                <a:ext cx="443117" cy="325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46" dirty="0">
                    <a:latin typeface="American Typewriter"/>
                    <a:cs typeface="American Typewriter"/>
                  </a:rPr>
                  <a:t>973</a:t>
                </a:r>
              </a:p>
              <a:p>
                <a:r>
                  <a:rPr lang="it-IT" sz="646" dirty="0">
                    <a:latin typeface="American Typewriter"/>
                    <a:cs typeface="American Typewriter"/>
                  </a:rPr>
                  <a:t>1988</a:t>
                </a:r>
              </a:p>
            </p:txBody>
          </p:sp>
        </p:grpSp>
        <p:sp>
          <p:nvSpPr>
            <p:cNvPr id="194" name="Rettangolo 193"/>
            <p:cNvSpPr/>
            <p:nvPr/>
          </p:nvSpPr>
          <p:spPr>
            <a:xfrm>
              <a:off x="1279996" y="3192454"/>
              <a:ext cx="431995" cy="105833"/>
            </a:xfrm>
            <a:prstGeom prst="rect">
              <a:avLst/>
            </a:prstGeom>
            <a:noFill/>
            <a:ln w="12700" cmpd="sng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662"/>
            </a:p>
          </p:txBody>
        </p:sp>
        <p:sp>
          <p:nvSpPr>
            <p:cNvPr id="195" name="CasellaDiTesto 194"/>
            <p:cNvSpPr txBox="1"/>
            <p:nvPr/>
          </p:nvSpPr>
          <p:spPr>
            <a:xfrm>
              <a:off x="1371566" y="3250022"/>
              <a:ext cx="272827" cy="2462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31" b="1" dirty="0">
                  <a:solidFill>
                    <a:srgbClr val="000000"/>
                  </a:solidFill>
                  <a:latin typeface="Arial"/>
                  <a:cs typeface="Arial"/>
                </a:rPr>
                <a:t>4</a:t>
              </a:r>
            </a:p>
          </p:txBody>
        </p:sp>
        <p:cxnSp>
          <p:nvCxnSpPr>
            <p:cNvPr id="162" name="Connettore 1 161"/>
            <p:cNvCxnSpPr/>
            <p:nvPr/>
          </p:nvCxnSpPr>
          <p:spPr>
            <a:xfrm rot="16200000" flipV="1">
              <a:off x="1287902" y="6117858"/>
              <a:ext cx="0" cy="211667"/>
            </a:xfrm>
            <a:prstGeom prst="line">
              <a:avLst/>
            </a:prstGeom>
            <a:ln w="12700" cmpd="sng">
              <a:solidFill>
                <a:srgbClr val="FF0000"/>
              </a:solidFill>
              <a:headEnd type="stealth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3" name="CasellaDiTesto 162"/>
            <p:cNvSpPr txBox="1"/>
            <p:nvPr/>
          </p:nvSpPr>
          <p:spPr>
            <a:xfrm>
              <a:off x="1319036" y="6089254"/>
              <a:ext cx="577559" cy="2462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31" dirty="0">
                  <a:solidFill>
                    <a:srgbClr val="FF0000"/>
                  </a:solidFill>
                  <a:latin typeface="Arial"/>
                  <a:cs typeface="Arial"/>
                </a:rPr>
                <a:t>5’ UTR</a:t>
              </a:r>
            </a:p>
          </p:txBody>
        </p:sp>
        <p:sp>
          <p:nvSpPr>
            <p:cNvPr id="164" name="CasellaDiTesto 163"/>
            <p:cNvSpPr txBox="1"/>
            <p:nvPr/>
          </p:nvSpPr>
          <p:spPr>
            <a:xfrm>
              <a:off x="2206522" y="6769724"/>
              <a:ext cx="819552" cy="2462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31" dirty="0">
                  <a:latin typeface="Arial"/>
                  <a:cs typeface="Arial"/>
                </a:rPr>
                <a:t>Codon start</a:t>
              </a:r>
            </a:p>
          </p:txBody>
        </p:sp>
      </p:grpSp>
      <p:sp>
        <p:nvSpPr>
          <p:cNvPr id="166" name="CasellaDiTesto 165"/>
          <p:cNvSpPr txBox="1"/>
          <p:nvPr/>
        </p:nvSpPr>
        <p:spPr>
          <a:xfrm>
            <a:off x="468715" y="6815661"/>
            <a:ext cx="5985167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igure S3. </a:t>
            </a:r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moter and 5'UTR region analysis </a:t>
            </a:r>
            <a:r>
              <a:rPr lang="it-IT" sz="12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of </a:t>
            </a:r>
            <a:r>
              <a:rPr lang="it-IT" sz="1200" b="1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LCY-e</a:t>
            </a:r>
            <a:r>
              <a:rPr lang="en-GB" sz="1200" b="1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gene</a:t>
            </a:r>
            <a:r>
              <a:rPr lang="en-GB" sz="1200" b="1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.</a:t>
            </a:r>
            <a:endParaRPr lang="it-IT" sz="1200" b="1" dirty="0">
              <a:solidFill>
                <a:srgbClr val="00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just"/>
            <a:r>
              <a:rPr lang="en-GB" sz="12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lustalW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alignment of nucleotide sequences of </a:t>
            </a:r>
            <a:r>
              <a:rPr lang="en-GB" sz="12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LCY-e 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moter and 5’ UTR in </a:t>
            </a:r>
            <a:r>
              <a:rPr lang="en-GB" sz="12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. </a:t>
            </a:r>
            <a:r>
              <a:rPr lang="en-GB" sz="1200" i="1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lycopersicum</a:t>
            </a:r>
            <a:r>
              <a:rPr lang="en-GB" sz="12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c 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nd </a:t>
            </a:r>
            <a:r>
              <a:rPr lang="en-GB" sz="1200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Delta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. Putative transcriptional factor-binding sites, identified by the PLACE software, are highlighted in boxes and numbered (</a:t>
            </a:r>
            <a:r>
              <a:rPr lang="it-IT" sz="12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. L1BOXATPDF1; 2. ELRECOREPCRP1; 3. CAREOSREP1; 4. ASF1MOTIFCAMV; 5. SITEIIATCYTC; 6. SORLIP2AT; 7. CATATGGMSAUR; 8. TATABOX3; 9. PYRIMIDINEBOXHVEPB1; 10. GT1CORE; 11. CPBCSPOR; 12. SEBFCONSSTPR10A; 14. XYLAT; 13. LTRECOREATCOR15; 15. TBOXATGAPB; 16. AMYBOX2; 17. ANAERO1CONSENSUS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) as described in Table S3. Red and black arrows indicates, respectively, the 5’ UTR start and ATG.</a:t>
            </a:r>
          </a:p>
        </p:txBody>
      </p:sp>
    </p:spTree>
    <p:extLst>
      <p:ext uri="{BB962C8B-B14F-4D97-AF65-F5344CB8AC3E}">
        <p14:creationId xmlns:p14="http://schemas.microsoft.com/office/powerpoint/2010/main" val="7800242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37E82E0B-30A9-B64C-BD1F-CDC64615353A}"/>
              </a:ext>
            </a:extLst>
          </p:cNvPr>
          <p:cNvSpPr txBox="1"/>
          <p:nvPr/>
        </p:nvSpPr>
        <p:spPr>
          <a:xfrm>
            <a:off x="280555" y="6552789"/>
            <a:ext cx="623454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igure S4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.</a:t>
            </a:r>
            <a:r>
              <a:rPr lang="it-IT" sz="1200" dirty="0"/>
              <a:t> ABA </a:t>
            </a:r>
            <a:r>
              <a:rPr lang="it-IT" sz="1200" dirty="0" err="1"/>
              <a:t>biosynthesis</a:t>
            </a:r>
            <a:r>
              <a:rPr lang="it-IT" sz="1200" dirty="0"/>
              <a:t> and </a:t>
            </a:r>
            <a:r>
              <a:rPr lang="it-IT" sz="1200" dirty="0" err="1"/>
              <a:t>related</a:t>
            </a:r>
            <a:r>
              <a:rPr lang="it-IT" sz="1200" dirty="0"/>
              <a:t> </a:t>
            </a:r>
            <a:r>
              <a:rPr lang="it-IT" sz="1200" dirty="0" err="1"/>
              <a:t>changes</a:t>
            </a:r>
            <a:r>
              <a:rPr lang="it-IT" sz="1200" dirty="0"/>
              <a:t> in tomato </a:t>
            </a:r>
            <a:r>
              <a:rPr lang="it-IT" sz="1200" dirty="0" err="1"/>
              <a:t>mutants</a:t>
            </a:r>
            <a:r>
              <a:rPr lang="it-IT" sz="1200" dirty="0"/>
              <a:t> </a:t>
            </a:r>
            <a:r>
              <a:rPr lang="it-IT" sz="1200" dirty="0" err="1"/>
              <a:t>at</a:t>
            </a:r>
            <a:r>
              <a:rPr lang="it-IT" sz="1200" dirty="0"/>
              <a:t> the MG (A) and Br (B) stages. </a:t>
            </a:r>
            <a:r>
              <a:rPr lang="it-IT" sz="1200" dirty="0" err="1"/>
              <a:t>Transcript</a:t>
            </a:r>
            <a:r>
              <a:rPr lang="it-IT" sz="1200" dirty="0"/>
              <a:t> (EU-TOM3 microarray) and </a:t>
            </a:r>
            <a:r>
              <a:rPr lang="it-IT" sz="1200" dirty="0" err="1"/>
              <a:t>metabolite</a:t>
            </a:r>
            <a:r>
              <a:rPr lang="it-IT" sz="1200" dirty="0"/>
              <a:t> data are </a:t>
            </a:r>
            <a:r>
              <a:rPr lang="it-IT" sz="1200" dirty="0" err="1"/>
              <a:t>shown</a:t>
            </a:r>
            <a:r>
              <a:rPr lang="it-IT" sz="1200" dirty="0"/>
              <a:t> </a:t>
            </a:r>
            <a:r>
              <a:rPr lang="it-IT" sz="1200" dirty="0" err="1"/>
              <a:t>as</a:t>
            </a:r>
            <a:r>
              <a:rPr lang="it-IT" sz="1200" dirty="0"/>
              <a:t> log2 </a:t>
            </a:r>
            <a:r>
              <a:rPr lang="it-IT" sz="1200" dirty="0" err="1"/>
              <a:t>fold</a:t>
            </a:r>
            <a:r>
              <a:rPr lang="it-IT" sz="1200" dirty="0"/>
              <a:t> </a:t>
            </a:r>
            <a:r>
              <a:rPr lang="it-IT" sz="1200" dirty="0" err="1"/>
              <a:t>change</a:t>
            </a:r>
            <a:r>
              <a:rPr lang="it-IT" sz="1200" dirty="0"/>
              <a:t> relative to the appropriate wild </a:t>
            </a:r>
            <a:r>
              <a:rPr lang="it-IT" sz="1200" dirty="0" err="1"/>
              <a:t>type</a:t>
            </a:r>
            <a:r>
              <a:rPr lang="it-IT" sz="1200" dirty="0"/>
              <a:t> (AC for </a:t>
            </a:r>
            <a:r>
              <a:rPr lang="it-IT" sz="1200" dirty="0" err="1"/>
              <a:t>at</a:t>
            </a:r>
            <a:r>
              <a:rPr lang="it-IT" sz="1200" dirty="0"/>
              <a:t>, </a:t>
            </a:r>
            <a:r>
              <a:rPr lang="it-IT" sz="1200" dirty="0" err="1"/>
              <a:t>r</a:t>
            </a:r>
            <a:r>
              <a:rPr lang="it-IT" sz="1200" dirty="0"/>
              <a:t>, t and B; M82 for Del). Red and blue indicate </a:t>
            </a:r>
            <a:r>
              <a:rPr lang="it-IT" sz="1200" dirty="0" err="1"/>
              <a:t>higher</a:t>
            </a:r>
            <a:r>
              <a:rPr lang="it-IT" sz="1200" dirty="0"/>
              <a:t> and </a:t>
            </a:r>
            <a:r>
              <a:rPr lang="it-IT" sz="1200" dirty="0" err="1"/>
              <a:t>lower</a:t>
            </a:r>
            <a:r>
              <a:rPr lang="it-IT" sz="1200" dirty="0"/>
              <a:t> relative </a:t>
            </a:r>
            <a:r>
              <a:rPr lang="it-IT" sz="1200" dirty="0" err="1"/>
              <a:t>levels</a:t>
            </a:r>
            <a:r>
              <a:rPr lang="it-IT" sz="1200" dirty="0"/>
              <a:t> vs wild </a:t>
            </a:r>
            <a:r>
              <a:rPr lang="it-IT" sz="1200" dirty="0" err="1"/>
              <a:t>type</a:t>
            </a:r>
            <a:r>
              <a:rPr lang="it-IT" sz="1200" dirty="0"/>
              <a:t>, </a:t>
            </a:r>
            <a:r>
              <a:rPr lang="it-IT" sz="1200" dirty="0" err="1"/>
              <a:t>respectively</a:t>
            </a:r>
            <a:r>
              <a:rPr lang="it-IT" sz="1200" dirty="0"/>
              <a:t>; white </a:t>
            </a:r>
            <a:r>
              <a:rPr lang="it-IT" sz="1200" dirty="0" err="1"/>
              <a:t>indicates</a:t>
            </a:r>
            <a:r>
              <a:rPr lang="it-IT" sz="1200" dirty="0"/>
              <a:t> no </a:t>
            </a:r>
            <a:r>
              <a:rPr lang="it-IT" sz="1200" dirty="0" err="1"/>
              <a:t>change</a:t>
            </a:r>
            <a:r>
              <a:rPr lang="it-IT" sz="1200" dirty="0"/>
              <a:t>; gray </a:t>
            </a:r>
            <a:r>
              <a:rPr lang="it-IT" sz="1200" dirty="0" err="1"/>
              <a:t>indicates</a:t>
            </a:r>
            <a:r>
              <a:rPr lang="it-IT" sz="1200" dirty="0"/>
              <a:t> </a:t>
            </a:r>
            <a:r>
              <a:rPr lang="it-IT" sz="1200" dirty="0" err="1"/>
              <a:t>not</a:t>
            </a:r>
            <a:r>
              <a:rPr lang="it-IT" sz="1200" dirty="0"/>
              <a:t> </a:t>
            </a:r>
            <a:r>
              <a:rPr lang="it-IT" sz="1200" dirty="0" err="1"/>
              <a:t>detected</a:t>
            </a:r>
            <a:r>
              <a:rPr lang="it-IT" sz="1200" dirty="0"/>
              <a:t>. </a:t>
            </a:r>
            <a:r>
              <a:rPr lang="it-IT" sz="1200" dirty="0" err="1"/>
              <a:t>Student’s</a:t>
            </a:r>
            <a:r>
              <a:rPr lang="it-IT" sz="1200" dirty="0"/>
              <a:t> t-test: *</a:t>
            </a:r>
            <a:r>
              <a:rPr lang="it-IT" sz="1200" dirty="0" err="1"/>
              <a:t>p</a:t>
            </a:r>
            <a:r>
              <a:rPr lang="it-IT" sz="1200" dirty="0"/>
              <a:t> ≤ 0.05; **</a:t>
            </a:r>
            <a:r>
              <a:rPr lang="it-IT" sz="1200" dirty="0" err="1"/>
              <a:t>p</a:t>
            </a:r>
            <a:r>
              <a:rPr lang="it-IT" sz="1200" dirty="0"/>
              <a:t> ≤ 0.01; ***</a:t>
            </a:r>
            <a:r>
              <a:rPr lang="it-IT" sz="1200" dirty="0" err="1"/>
              <a:t>p</a:t>
            </a:r>
            <a:r>
              <a:rPr lang="it-IT" sz="1200" dirty="0"/>
              <a:t> ≤ 0.001. See </a:t>
            </a:r>
            <a:r>
              <a:rPr lang="it-IT" sz="1200" dirty="0" err="1"/>
              <a:t>Materials</a:t>
            </a:r>
            <a:r>
              <a:rPr lang="it-IT" sz="1200" dirty="0"/>
              <a:t> and Methods and </a:t>
            </a:r>
            <a:r>
              <a:rPr lang="it-IT" sz="1200" dirty="0" err="1"/>
              <a:t>Supplementary</a:t>
            </a:r>
            <a:r>
              <a:rPr lang="it-IT" sz="1200" dirty="0"/>
              <a:t> </a:t>
            </a:r>
            <a:r>
              <a:rPr lang="it-IT" sz="1200" dirty="0" err="1"/>
              <a:t>Table</a:t>
            </a:r>
            <a:r>
              <a:rPr lang="it-IT" sz="1200" dirty="0"/>
              <a:t> 6-7 for </a:t>
            </a:r>
            <a:r>
              <a:rPr lang="it-IT" sz="1200" dirty="0" err="1"/>
              <a:t>details</a:t>
            </a:r>
            <a:r>
              <a:rPr lang="it-IT" sz="1200" dirty="0"/>
              <a:t>.</a:t>
            </a:r>
            <a:endParaRPr 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6" name="Immagine 5">
            <a:extLst>
              <a:ext uri="{FF2B5EF4-FFF2-40B4-BE49-F238E27FC236}">
                <a16:creationId xmlns:a16="http://schemas.microsoft.com/office/drawing/2014/main" id="{6E6111C9-12E3-D841-A3DE-C117C1A938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1792" y="317445"/>
            <a:ext cx="3519237" cy="2941777"/>
          </a:xfrm>
          <a:prstGeom prst="rect">
            <a:avLst/>
          </a:prstGeom>
        </p:spPr>
      </p:pic>
      <p:pic>
        <p:nvPicPr>
          <p:cNvPr id="8" name="Immagine 7">
            <a:extLst>
              <a:ext uri="{FF2B5EF4-FFF2-40B4-BE49-F238E27FC236}">
                <a16:creationId xmlns:a16="http://schemas.microsoft.com/office/drawing/2014/main" id="{BF3D0A4F-56DA-EB4E-AC47-B8A57BF3749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01792" y="3259222"/>
            <a:ext cx="3572256" cy="2906242"/>
          </a:xfrm>
          <a:prstGeom prst="rect">
            <a:avLst/>
          </a:prstGeom>
        </p:spPr>
      </p:pic>
      <p:sp>
        <p:nvSpPr>
          <p:cNvPr id="9" name="CasellaDiTesto 8">
            <a:extLst>
              <a:ext uri="{FF2B5EF4-FFF2-40B4-BE49-F238E27FC236}">
                <a16:creationId xmlns:a16="http://schemas.microsoft.com/office/drawing/2014/main" id="{C2ABC9FB-386A-E84E-80D5-8FC589409E8D}"/>
              </a:ext>
            </a:extLst>
          </p:cNvPr>
          <p:cNvSpPr txBox="1"/>
          <p:nvPr/>
        </p:nvSpPr>
        <p:spPr>
          <a:xfrm>
            <a:off x="992092" y="17527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F3F8055A-1FED-F94F-8D6E-65DE16B769FF}"/>
              </a:ext>
            </a:extLst>
          </p:cNvPr>
          <p:cNvSpPr txBox="1"/>
          <p:nvPr/>
        </p:nvSpPr>
        <p:spPr>
          <a:xfrm>
            <a:off x="992092" y="3091054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8828869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magine 7">
            <a:extLst>
              <a:ext uri="{FF2B5EF4-FFF2-40B4-BE49-F238E27FC236}">
                <a16:creationId xmlns:a16="http://schemas.microsoft.com/office/drawing/2014/main" id="{E762D001-5CE9-1551-2A10-9D3A65AF47F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-49" b="-1"/>
          <a:stretch>
            <a:fillRect/>
          </a:stretch>
        </p:blipFill>
        <p:spPr>
          <a:xfrm>
            <a:off x="2883734" y="367739"/>
            <a:ext cx="1003911" cy="8633929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E90D0ECD-3BAA-A190-1410-DB065375C93E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-49" b="-1"/>
          <a:stretch>
            <a:fillRect/>
          </a:stretch>
        </p:blipFill>
        <p:spPr>
          <a:xfrm>
            <a:off x="832942" y="369671"/>
            <a:ext cx="1003910" cy="8633929"/>
          </a:xfrm>
          <a:prstGeom prst="rect">
            <a:avLst/>
          </a:prstGeom>
        </p:spPr>
      </p:pic>
      <p:sp>
        <p:nvSpPr>
          <p:cNvPr id="35" name="Rettangolo 34">
            <a:extLst>
              <a:ext uri="{FF2B5EF4-FFF2-40B4-BE49-F238E27FC236}">
                <a16:creationId xmlns:a16="http://schemas.microsoft.com/office/drawing/2014/main" id="{529799FE-A479-F346-BC21-B2818D5BE135}"/>
              </a:ext>
            </a:extLst>
          </p:cNvPr>
          <p:cNvSpPr/>
          <p:nvPr/>
        </p:nvSpPr>
        <p:spPr>
          <a:xfrm>
            <a:off x="796952" y="3870495"/>
            <a:ext cx="45719" cy="956281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8F011933-A9C6-A040-BF29-2190A1230386}"/>
              </a:ext>
            </a:extLst>
          </p:cNvPr>
          <p:cNvSpPr txBox="1"/>
          <p:nvPr/>
        </p:nvSpPr>
        <p:spPr>
          <a:xfrm rot="16200000">
            <a:off x="197696" y="4237423"/>
            <a:ext cx="9562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/>
              <a:t>MVA</a:t>
            </a:r>
          </a:p>
        </p:txBody>
      </p:sp>
      <p:sp>
        <p:nvSpPr>
          <p:cNvPr id="41" name="Rettangolo 40">
            <a:extLst>
              <a:ext uri="{FF2B5EF4-FFF2-40B4-BE49-F238E27FC236}">
                <a16:creationId xmlns:a16="http://schemas.microsoft.com/office/drawing/2014/main" id="{72CFA1D1-FEFF-C446-95CB-E5612BAF1682}"/>
              </a:ext>
            </a:extLst>
          </p:cNvPr>
          <p:cNvSpPr/>
          <p:nvPr/>
        </p:nvSpPr>
        <p:spPr>
          <a:xfrm>
            <a:off x="796952" y="3133889"/>
            <a:ext cx="45719" cy="733116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39F9D93C-0109-F843-BBFC-F40EDD5EB5BA}"/>
              </a:ext>
            </a:extLst>
          </p:cNvPr>
          <p:cNvSpPr txBox="1"/>
          <p:nvPr/>
        </p:nvSpPr>
        <p:spPr>
          <a:xfrm rot="16200000">
            <a:off x="309279" y="3392724"/>
            <a:ext cx="7331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/>
              <a:t>MEP</a:t>
            </a:r>
          </a:p>
        </p:txBody>
      </p:sp>
      <p:sp>
        <p:nvSpPr>
          <p:cNvPr id="46" name="Rettangolo 45">
            <a:extLst>
              <a:ext uri="{FF2B5EF4-FFF2-40B4-BE49-F238E27FC236}">
                <a16:creationId xmlns:a16="http://schemas.microsoft.com/office/drawing/2014/main" id="{5E072BA1-7EF9-6545-A371-B86A569180AF}"/>
              </a:ext>
            </a:extLst>
          </p:cNvPr>
          <p:cNvSpPr/>
          <p:nvPr/>
        </p:nvSpPr>
        <p:spPr>
          <a:xfrm>
            <a:off x="796952" y="4826775"/>
            <a:ext cx="45719" cy="2592083"/>
          </a:xfrm>
          <a:prstGeom prst="rect">
            <a:avLst/>
          </a:prstGeom>
          <a:solidFill>
            <a:srgbClr val="00B05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7" name="Rettangolo 46">
            <a:extLst>
              <a:ext uri="{FF2B5EF4-FFF2-40B4-BE49-F238E27FC236}">
                <a16:creationId xmlns:a16="http://schemas.microsoft.com/office/drawing/2014/main" id="{E9633DE7-01DB-B44D-B19E-59C7BFE4ADD1}"/>
              </a:ext>
            </a:extLst>
          </p:cNvPr>
          <p:cNvSpPr/>
          <p:nvPr/>
        </p:nvSpPr>
        <p:spPr>
          <a:xfrm>
            <a:off x="796952" y="7419146"/>
            <a:ext cx="45719" cy="864568"/>
          </a:xfrm>
          <a:prstGeom prst="rect">
            <a:avLst/>
          </a:prstGeom>
          <a:solidFill>
            <a:srgbClr val="7030A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1" name="Rettangolo 50">
            <a:extLst>
              <a:ext uri="{FF2B5EF4-FFF2-40B4-BE49-F238E27FC236}">
                <a16:creationId xmlns:a16="http://schemas.microsoft.com/office/drawing/2014/main" id="{61939E64-C50F-0945-832C-980EA6A22BE6}"/>
              </a:ext>
            </a:extLst>
          </p:cNvPr>
          <p:cNvSpPr/>
          <p:nvPr/>
        </p:nvSpPr>
        <p:spPr>
          <a:xfrm>
            <a:off x="796952" y="8280224"/>
            <a:ext cx="45719" cy="729064"/>
          </a:xfrm>
          <a:prstGeom prst="rect">
            <a:avLst/>
          </a:prstGeom>
          <a:solidFill>
            <a:srgbClr val="CA40B8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52" name="Gruppo 51">
            <a:extLst>
              <a:ext uri="{FF2B5EF4-FFF2-40B4-BE49-F238E27FC236}">
                <a16:creationId xmlns:a16="http://schemas.microsoft.com/office/drawing/2014/main" id="{B4B7154D-6BE2-7248-A4C2-85450FC4B2EE}"/>
              </a:ext>
            </a:extLst>
          </p:cNvPr>
          <p:cNvGrpSpPr>
            <a:grpSpLocks noChangeAspect="1"/>
          </p:cNvGrpSpPr>
          <p:nvPr/>
        </p:nvGrpSpPr>
        <p:grpSpPr>
          <a:xfrm>
            <a:off x="1165574" y="581246"/>
            <a:ext cx="192888" cy="223235"/>
            <a:chOff x="-1357336" y="2664884"/>
            <a:chExt cx="951173" cy="752874"/>
          </a:xfrm>
        </p:grpSpPr>
        <p:sp>
          <p:nvSpPr>
            <p:cNvPr id="53" name="Ovale 52">
              <a:extLst>
                <a:ext uri="{FF2B5EF4-FFF2-40B4-BE49-F238E27FC236}">
                  <a16:creationId xmlns:a16="http://schemas.microsoft.com/office/drawing/2014/main" id="{5EC02B77-3151-904B-9F0F-51D6038F4D6C}"/>
                </a:ext>
              </a:extLst>
            </p:cNvPr>
            <p:cNvSpPr/>
            <p:nvPr/>
          </p:nvSpPr>
          <p:spPr>
            <a:xfrm>
              <a:off x="-1309635" y="2827208"/>
              <a:ext cx="877311" cy="590550"/>
            </a:xfrm>
            <a:prstGeom prst="ellipse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4" name="Figura a mano libera 53">
              <a:extLst>
                <a:ext uri="{FF2B5EF4-FFF2-40B4-BE49-F238E27FC236}">
                  <a16:creationId xmlns:a16="http://schemas.microsoft.com/office/drawing/2014/main" id="{50D1DE70-73C7-A245-85F7-4A35022A015A}"/>
                </a:ext>
              </a:extLst>
            </p:cNvPr>
            <p:cNvSpPr/>
            <p:nvPr/>
          </p:nvSpPr>
          <p:spPr>
            <a:xfrm>
              <a:off x="-1357336" y="2664884"/>
              <a:ext cx="951173" cy="426823"/>
            </a:xfrm>
            <a:custGeom>
              <a:avLst/>
              <a:gdLst>
                <a:gd name="connsiteX0" fmla="*/ 376313 w 951173"/>
                <a:gd name="connsiteY0" fmla="*/ 148036 h 426823"/>
                <a:gd name="connsiteX1" fmla="*/ 76 w 951173"/>
                <a:gd name="connsiteY1" fmla="*/ 319486 h 426823"/>
                <a:gd name="connsiteX2" fmla="*/ 409651 w 951173"/>
                <a:gd name="connsiteY2" fmla="*/ 205186 h 426823"/>
                <a:gd name="connsiteX3" fmla="*/ 304876 w 951173"/>
                <a:gd name="connsiteY3" fmla="*/ 329011 h 426823"/>
                <a:gd name="connsiteX4" fmla="*/ 295351 w 951173"/>
                <a:gd name="connsiteY4" fmla="*/ 424261 h 426823"/>
                <a:gd name="connsiteX5" fmla="*/ 462038 w 951173"/>
                <a:gd name="connsiteY5" fmla="*/ 224236 h 426823"/>
                <a:gd name="connsiteX6" fmla="*/ 590626 w 951173"/>
                <a:gd name="connsiteY6" fmla="*/ 405211 h 426823"/>
                <a:gd name="connsiteX7" fmla="*/ 547763 w 951173"/>
                <a:gd name="connsiteY7" fmla="*/ 214711 h 426823"/>
                <a:gd name="connsiteX8" fmla="*/ 714451 w 951173"/>
                <a:gd name="connsiteY8" fmla="*/ 348061 h 426823"/>
                <a:gd name="connsiteX9" fmla="*/ 819226 w 951173"/>
                <a:gd name="connsiteY9" fmla="*/ 343298 h 426823"/>
                <a:gd name="connsiteX10" fmla="*/ 723976 w 951173"/>
                <a:gd name="connsiteY10" fmla="*/ 319486 h 426823"/>
                <a:gd name="connsiteX11" fmla="*/ 619201 w 951173"/>
                <a:gd name="connsiteY11" fmla="*/ 219473 h 426823"/>
                <a:gd name="connsiteX12" fmla="*/ 933526 w 951173"/>
                <a:gd name="connsiteY12" fmla="*/ 329011 h 426823"/>
                <a:gd name="connsiteX13" fmla="*/ 909713 w 951173"/>
                <a:gd name="connsiteY13" fmla="*/ 267098 h 426823"/>
                <a:gd name="connsiteX14" fmla="*/ 895426 w 951173"/>
                <a:gd name="connsiteY14" fmla="*/ 271861 h 426823"/>
                <a:gd name="connsiteX15" fmla="*/ 571576 w 951173"/>
                <a:gd name="connsiteY15" fmla="*/ 138511 h 426823"/>
                <a:gd name="connsiteX16" fmla="*/ 690638 w 951173"/>
                <a:gd name="connsiteY16" fmla="*/ 67073 h 426823"/>
                <a:gd name="connsiteX17" fmla="*/ 800176 w 951173"/>
                <a:gd name="connsiteY17" fmla="*/ 76598 h 426823"/>
                <a:gd name="connsiteX18" fmla="*/ 766838 w 951173"/>
                <a:gd name="connsiteY18" fmla="*/ 398 h 426823"/>
                <a:gd name="connsiteX19" fmla="*/ 509663 w 951173"/>
                <a:gd name="connsiteY19" fmla="*/ 114698 h 426823"/>
                <a:gd name="connsiteX20" fmla="*/ 376313 w 951173"/>
                <a:gd name="connsiteY20" fmla="*/ 148036 h 4268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</a:cxnLst>
              <a:rect l="l" t="t" r="r" b="b"/>
              <a:pathLst>
                <a:path w="951173" h="426823">
                  <a:moveTo>
                    <a:pt x="376313" y="148036"/>
                  </a:moveTo>
                  <a:cubicBezTo>
                    <a:pt x="291382" y="182167"/>
                    <a:pt x="-5480" y="309961"/>
                    <a:pt x="76" y="319486"/>
                  </a:cubicBezTo>
                  <a:cubicBezTo>
                    <a:pt x="5632" y="329011"/>
                    <a:pt x="358851" y="203599"/>
                    <a:pt x="409651" y="205186"/>
                  </a:cubicBezTo>
                  <a:cubicBezTo>
                    <a:pt x="460451" y="206774"/>
                    <a:pt x="323926" y="292499"/>
                    <a:pt x="304876" y="329011"/>
                  </a:cubicBezTo>
                  <a:cubicBezTo>
                    <a:pt x="285826" y="365523"/>
                    <a:pt x="269157" y="441723"/>
                    <a:pt x="295351" y="424261"/>
                  </a:cubicBezTo>
                  <a:cubicBezTo>
                    <a:pt x="321545" y="406799"/>
                    <a:pt x="412826" y="227411"/>
                    <a:pt x="462038" y="224236"/>
                  </a:cubicBezTo>
                  <a:cubicBezTo>
                    <a:pt x="511250" y="221061"/>
                    <a:pt x="576339" y="406798"/>
                    <a:pt x="590626" y="405211"/>
                  </a:cubicBezTo>
                  <a:cubicBezTo>
                    <a:pt x="604913" y="403624"/>
                    <a:pt x="527126" y="224236"/>
                    <a:pt x="547763" y="214711"/>
                  </a:cubicBezTo>
                  <a:cubicBezTo>
                    <a:pt x="568400" y="205186"/>
                    <a:pt x="669207" y="326630"/>
                    <a:pt x="714451" y="348061"/>
                  </a:cubicBezTo>
                  <a:cubicBezTo>
                    <a:pt x="759695" y="369492"/>
                    <a:pt x="817639" y="348060"/>
                    <a:pt x="819226" y="343298"/>
                  </a:cubicBezTo>
                  <a:cubicBezTo>
                    <a:pt x="820813" y="338536"/>
                    <a:pt x="757314" y="340124"/>
                    <a:pt x="723976" y="319486"/>
                  </a:cubicBezTo>
                  <a:cubicBezTo>
                    <a:pt x="690639" y="298849"/>
                    <a:pt x="584276" y="217885"/>
                    <a:pt x="619201" y="219473"/>
                  </a:cubicBezTo>
                  <a:cubicBezTo>
                    <a:pt x="654126" y="221061"/>
                    <a:pt x="885107" y="321074"/>
                    <a:pt x="933526" y="329011"/>
                  </a:cubicBezTo>
                  <a:cubicBezTo>
                    <a:pt x="981945" y="336948"/>
                    <a:pt x="916063" y="276623"/>
                    <a:pt x="909713" y="267098"/>
                  </a:cubicBezTo>
                  <a:cubicBezTo>
                    <a:pt x="903363" y="257573"/>
                    <a:pt x="951782" y="293292"/>
                    <a:pt x="895426" y="271861"/>
                  </a:cubicBezTo>
                  <a:cubicBezTo>
                    <a:pt x="839070" y="250430"/>
                    <a:pt x="605707" y="172642"/>
                    <a:pt x="571576" y="138511"/>
                  </a:cubicBezTo>
                  <a:cubicBezTo>
                    <a:pt x="537445" y="104380"/>
                    <a:pt x="652538" y="77392"/>
                    <a:pt x="690638" y="67073"/>
                  </a:cubicBezTo>
                  <a:cubicBezTo>
                    <a:pt x="728738" y="56754"/>
                    <a:pt x="787476" y="87710"/>
                    <a:pt x="800176" y="76598"/>
                  </a:cubicBezTo>
                  <a:cubicBezTo>
                    <a:pt x="812876" y="65486"/>
                    <a:pt x="815257" y="-5952"/>
                    <a:pt x="766838" y="398"/>
                  </a:cubicBezTo>
                  <a:cubicBezTo>
                    <a:pt x="718419" y="6748"/>
                    <a:pt x="574750" y="91679"/>
                    <a:pt x="509663" y="114698"/>
                  </a:cubicBezTo>
                  <a:cubicBezTo>
                    <a:pt x="444576" y="137717"/>
                    <a:pt x="461244" y="113905"/>
                    <a:pt x="376313" y="148036"/>
                  </a:cubicBez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55" name="Luna 54">
              <a:extLst>
                <a:ext uri="{FF2B5EF4-FFF2-40B4-BE49-F238E27FC236}">
                  <a16:creationId xmlns:a16="http://schemas.microsoft.com/office/drawing/2014/main" id="{82F03781-C1A0-5244-840B-C71E40D478CB}"/>
                </a:ext>
              </a:extLst>
            </p:cNvPr>
            <p:cNvSpPr/>
            <p:nvPr/>
          </p:nvSpPr>
          <p:spPr>
            <a:xfrm rot="19982958">
              <a:off x="-1248144" y="3031995"/>
              <a:ext cx="152821" cy="217007"/>
            </a:xfrm>
            <a:prstGeom prst="moon">
              <a:avLst/>
            </a:prstGeom>
            <a:solidFill>
              <a:schemeClr val="accent3">
                <a:lumMod val="40000"/>
                <a:lumOff val="6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56" name="Gruppo 55">
            <a:extLst>
              <a:ext uri="{FF2B5EF4-FFF2-40B4-BE49-F238E27FC236}">
                <a16:creationId xmlns:a16="http://schemas.microsoft.com/office/drawing/2014/main" id="{892EAFB3-ACB8-6447-A816-2C03F997DF3B}"/>
              </a:ext>
            </a:extLst>
          </p:cNvPr>
          <p:cNvGrpSpPr>
            <a:grpSpLocks noChangeAspect="1"/>
          </p:cNvGrpSpPr>
          <p:nvPr/>
        </p:nvGrpSpPr>
        <p:grpSpPr>
          <a:xfrm>
            <a:off x="2178840" y="586612"/>
            <a:ext cx="192888" cy="217869"/>
            <a:chOff x="-1357336" y="2664884"/>
            <a:chExt cx="951173" cy="752874"/>
          </a:xfrm>
        </p:grpSpPr>
        <p:sp>
          <p:nvSpPr>
            <p:cNvPr id="57" name="Ovale 56">
              <a:extLst>
                <a:ext uri="{FF2B5EF4-FFF2-40B4-BE49-F238E27FC236}">
                  <a16:creationId xmlns:a16="http://schemas.microsoft.com/office/drawing/2014/main" id="{7858115A-DB15-C147-9F95-9AED60011918}"/>
                </a:ext>
              </a:extLst>
            </p:cNvPr>
            <p:cNvSpPr/>
            <p:nvPr/>
          </p:nvSpPr>
          <p:spPr>
            <a:xfrm>
              <a:off x="-1309635" y="2827208"/>
              <a:ext cx="877311" cy="590550"/>
            </a:xfrm>
            <a:prstGeom prst="ellipse">
              <a:avLst/>
            </a:prstGeom>
            <a:gradFill flip="none" rotWithShape="1">
              <a:gsLst>
                <a:gs pos="0">
                  <a:schemeClr val="accent6">
                    <a:lumMod val="75000"/>
                  </a:schemeClr>
                </a:gs>
                <a:gs pos="58000">
                  <a:schemeClr val="accent3">
                    <a:lumMod val="97000"/>
                    <a:lumOff val="3000"/>
                  </a:schemeClr>
                </a:gs>
                <a:gs pos="100000">
                  <a:schemeClr val="accent3">
                    <a:lumMod val="60000"/>
                    <a:lumOff val="40000"/>
                  </a:schemeClr>
                </a:gs>
              </a:gsLst>
              <a:path path="circle">
                <a:fillToRect l="100000" t="100000"/>
              </a:path>
              <a:tileRect r="-100000" b="-100000"/>
            </a:gra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8" name="Figura a mano libera 57">
              <a:extLst>
                <a:ext uri="{FF2B5EF4-FFF2-40B4-BE49-F238E27FC236}">
                  <a16:creationId xmlns:a16="http://schemas.microsoft.com/office/drawing/2014/main" id="{69B61B87-207C-5A4E-A5D1-914DBF7E473E}"/>
                </a:ext>
              </a:extLst>
            </p:cNvPr>
            <p:cNvSpPr/>
            <p:nvPr/>
          </p:nvSpPr>
          <p:spPr>
            <a:xfrm>
              <a:off x="-1357336" y="2664884"/>
              <a:ext cx="951173" cy="426823"/>
            </a:xfrm>
            <a:custGeom>
              <a:avLst/>
              <a:gdLst>
                <a:gd name="connsiteX0" fmla="*/ 376313 w 951173"/>
                <a:gd name="connsiteY0" fmla="*/ 148036 h 426823"/>
                <a:gd name="connsiteX1" fmla="*/ 76 w 951173"/>
                <a:gd name="connsiteY1" fmla="*/ 319486 h 426823"/>
                <a:gd name="connsiteX2" fmla="*/ 409651 w 951173"/>
                <a:gd name="connsiteY2" fmla="*/ 205186 h 426823"/>
                <a:gd name="connsiteX3" fmla="*/ 304876 w 951173"/>
                <a:gd name="connsiteY3" fmla="*/ 329011 h 426823"/>
                <a:gd name="connsiteX4" fmla="*/ 295351 w 951173"/>
                <a:gd name="connsiteY4" fmla="*/ 424261 h 426823"/>
                <a:gd name="connsiteX5" fmla="*/ 462038 w 951173"/>
                <a:gd name="connsiteY5" fmla="*/ 224236 h 426823"/>
                <a:gd name="connsiteX6" fmla="*/ 590626 w 951173"/>
                <a:gd name="connsiteY6" fmla="*/ 405211 h 426823"/>
                <a:gd name="connsiteX7" fmla="*/ 547763 w 951173"/>
                <a:gd name="connsiteY7" fmla="*/ 214711 h 426823"/>
                <a:gd name="connsiteX8" fmla="*/ 714451 w 951173"/>
                <a:gd name="connsiteY8" fmla="*/ 348061 h 426823"/>
                <a:gd name="connsiteX9" fmla="*/ 819226 w 951173"/>
                <a:gd name="connsiteY9" fmla="*/ 343298 h 426823"/>
                <a:gd name="connsiteX10" fmla="*/ 723976 w 951173"/>
                <a:gd name="connsiteY10" fmla="*/ 319486 h 426823"/>
                <a:gd name="connsiteX11" fmla="*/ 619201 w 951173"/>
                <a:gd name="connsiteY11" fmla="*/ 219473 h 426823"/>
                <a:gd name="connsiteX12" fmla="*/ 933526 w 951173"/>
                <a:gd name="connsiteY12" fmla="*/ 329011 h 426823"/>
                <a:gd name="connsiteX13" fmla="*/ 909713 w 951173"/>
                <a:gd name="connsiteY13" fmla="*/ 267098 h 426823"/>
                <a:gd name="connsiteX14" fmla="*/ 895426 w 951173"/>
                <a:gd name="connsiteY14" fmla="*/ 271861 h 426823"/>
                <a:gd name="connsiteX15" fmla="*/ 571576 w 951173"/>
                <a:gd name="connsiteY15" fmla="*/ 138511 h 426823"/>
                <a:gd name="connsiteX16" fmla="*/ 690638 w 951173"/>
                <a:gd name="connsiteY16" fmla="*/ 67073 h 426823"/>
                <a:gd name="connsiteX17" fmla="*/ 800176 w 951173"/>
                <a:gd name="connsiteY17" fmla="*/ 76598 h 426823"/>
                <a:gd name="connsiteX18" fmla="*/ 766838 w 951173"/>
                <a:gd name="connsiteY18" fmla="*/ 398 h 426823"/>
                <a:gd name="connsiteX19" fmla="*/ 509663 w 951173"/>
                <a:gd name="connsiteY19" fmla="*/ 114698 h 426823"/>
                <a:gd name="connsiteX20" fmla="*/ 376313 w 951173"/>
                <a:gd name="connsiteY20" fmla="*/ 148036 h 4268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</a:cxnLst>
              <a:rect l="l" t="t" r="r" b="b"/>
              <a:pathLst>
                <a:path w="951173" h="426823">
                  <a:moveTo>
                    <a:pt x="376313" y="148036"/>
                  </a:moveTo>
                  <a:cubicBezTo>
                    <a:pt x="291382" y="182167"/>
                    <a:pt x="-5480" y="309961"/>
                    <a:pt x="76" y="319486"/>
                  </a:cubicBezTo>
                  <a:cubicBezTo>
                    <a:pt x="5632" y="329011"/>
                    <a:pt x="358851" y="203599"/>
                    <a:pt x="409651" y="205186"/>
                  </a:cubicBezTo>
                  <a:cubicBezTo>
                    <a:pt x="460451" y="206774"/>
                    <a:pt x="323926" y="292499"/>
                    <a:pt x="304876" y="329011"/>
                  </a:cubicBezTo>
                  <a:cubicBezTo>
                    <a:pt x="285826" y="365523"/>
                    <a:pt x="269157" y="441723"/>
                    <a:pt x="295351" y="424261"/>
                  </a:cubicBezTo>
                  <a:cubicBezTo>
                    <a:pt x="321545" y="406799"/>
                    <a:pt x="412826" y="227411"/>
                    <a:pt x="462038" y="224236"/>
                  </a:cubicBezTo>
                  <a:cubicBezTo>
                    <a:pt x="511250" y="221061"/>
                    <a:pt x="576339" y="406798"/>
                    <a:pt x="590626" y="405211"/>
                  </a:cubicBezTo>
                  <a:cubicBezTo>
                    <a:pt x="604913" y="403624"/>
                    <a:pt x="527126" y="224236"/>
                    <a:pt x="547763" y="214711"/>
                  </a:cubicBezTo>
                  <a:cubicBezTo>
                    <a:pt x="568400" y="205186"/>
                    <a:pt x="669207" y="326630"/>
                    <a:pt x="714451" y="348061"/>
                  </a:cubicBezTo>
                  <a:cubicBezTo>
                    <a:pt x="759695" y="369492"/>
                    <a:pt x="817639" y="348060"/>
                    <a:pt x="819226" y="343298"/>
                  </a:cubicBezTo>
                  <a:cubicBezTo>
                    <a:pt x="820813" y="338536"/>
                    <a:pt x="757314" y="340124"/>
                    <a:pt x="723976" y="319486"/>
                  </a:cubicBezTo>
                  <a:cubicBezTo>
                    <a:pt x="690639" y="298849"/>
                    <a:pt x="584276" y="217885"/>
                    <a:pt x="619201" y="219473"/>
                  </a:cubicBezTo>
                  <a:cubicBezTo>
                    <a:pt x="654126" y="221061"/>
                    <a:pt x="885107" y="321074"/>
                    <a:pt x="933526" y="329011"/>
                  </a:cubicBezTo>
                  <a:cubicBezTo>
                    <a:pt x="981945" y="336948"/>
                    <a:pt x="916063" y="276623"/>
                    <a:pt x="909713" y="267098"/>
                  </a:cubicBezTo>
                  <a:cubicBezTo>
                    <a:pt x="903363" y="257573"/>
                    <a:pt x="951782" y="293292"/>
                    <a:pt x="895426" y="271861"/>
                  </a:cubicBezTo>
                  <a:cubicBezTo>
                    <a:pt x="839070" y="250430"/>
                    <a:pt x="605707" y="172642"/>
                    <a:pt x="571576" y="138511"/>
                  </a:cubicBezTo>
                  <a:cubicBezTo>
                    <a:pt x="537445" y="104380"/>
                    <a:pt x="652538" y="77392"/>
                    <a:pt x="690638" y="67073"/>
                  </a:cubicBezTo>
                  <a:cubicBezTo>
                    <a:pt x="728738" y="56754"/>
                    <a:pt x="787476" y="87710"/>
                    <a:pt x="800176" y="76598"/>
                  </a:cubicBezTo>
                  <a:cubicBezTo>
                    <a:pt x="812876" y="65486"/>
                    <a:pt x="815257" y="-5952"/>
                    <a:pt x="766838" y="398"/>
                  </a:cubicBezTo>
                  <a:cubicBezTo>
                    <a:pt x="718419" y="6748"/>
                    <a:pt x="574750" y="91679"/>
                    <a:pt x="509663" y="114698"/>
                  </a:cubicBezTo>
                  <a:cubicBezTo>
                    <a:pt x="444576" y="137717"/>
                    <a:pt x="461244" y="113905"/>
                    <a:pt x="376313" y="148036"/>
                  </a:cubicBez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59" name="Luna 58">
              <a:extLst>
                <a:ext uri="{FF2B5EF4-FFF2-40B4-BE49-F238E27FC236}">
                  <a16:creationId xmlns:a16="http://schemas.microsoft.com/office/drawing/2014/main" id="{E869B05C-6B94-1546-8850-97930FAF71B3}"/>
                </a:ext>
              </a:extLst>
            </p:cNvPr>
            <p:cNvSpPr/>
            <p:nvPr/>
          </p:nvSpPr>
          <p:spPr>
            <a:xfrm rot="19982958">
              <a:off x="-1248144" y="3031995"/>
              <a:ext cx="152821" cy="217007"/>
            </a:xfrm>
            <a:prstGeom prst="moon">
              <a:avLst/>
            </a:prstGeom>
            <a:solidFill>
              <a:schemeClr val="accent3">
                <a:lumMod val="40000"/>
                <a:lumOff val="6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60" name="Gruppo 59">
            <a:extLst>
              <a:ext uri="{FF2B5EF4-FFF2-40B4-BE49-F238E27FC236}">
                <a16:creationId xmlns:a16="http://schemas.microsoft.com/office/drawing/2014/main" id="{98A4B8A7-3EE9-8447-8F2D-433F4C37B936}"/>
              </a:ext>
            </a:extLst>
          </p:cNvPr>
          <p:cNvGrpSpPr>
            <a:grpSpLocks noChangeAspect="1"/>
          </p:cNvGrpSpPr>
          <p:nvPr/>
        </p:nvGrpSpPr>
        <p:grpSpPr>
          <a:xfrm>
            <a:off x="3232539" y="629377"/>
            <a:ext cx="192888" cy="220139"/>
            <a:chOff x="-1357336" y="2664884"/>
            <a:chExt cx="951173" cy="752874"/>
          </a:xfrm>
        </p:grpSpPr>
        <p:sp>
          <p:nvSpPr>
            <p:cNvPr id="61" name="Ovale 60">
              <a:extLst>
                <a:ext uri="{FF2B5EF4-FFF2-40B4-BE49-F238E27FC236}">
                  <a16:creationId xmlns:a16="http://schemas.microsoft.com/office/drawing/2014/main" id="{511D6842-7188-FF44-A1EE-7B29FBB77071}"/>
                </a:ext>
              </a:extLst>
            </p:cNvPr>
            <p:cNvSpPr/>
            <p:nvPr/>
          </p:nvSpPr>
          <p:spPr>
            <a:xfrm>
              <a:off x="-1309635" y="2827208"/>
              <a:ext cx="877311" cy="590550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2" name="Figura a mano libera 61">
              <a:extLst>
                <a:ext uri="{FF2B5EF4-FFF2-40B4-BE49-F238E27FC236}">
                  <a16:creationId xmlns:a16="http://schemas.microsoft.com/office/drawing/2014/main" id="{576C3317-DA81-F947-B133-8351D0334BFB}"/>
                </a:ext>
              </a:extLst>
            </p:cNvPr>
            <p:cNvSpPr/>
            <p:nvPr/>
          </p:nvSpPr>
          <p:spPr>
            <a:xfrm>
              <a:off x="-1357336" y="2664884"/>
              <a:ext cx="951173" cy="426823"/>
            </a:xfrm>
            <a:custGeom>
              <a:avLst/>
              <a:gdLst>
                <a:gd name="connsiteX0" fmla="*/ 376313 w 951173"/>
                <a:gd name="connsiteY0" fmla="*/ 148036 h 426823"/>
                <a:gd name="connsiteX1" fmla="*/ 76 w 951173"/>
                <a:gd name="connsiteY1" fmla="*/ 319486 h 426823"/>
                <a:gd name="connsiteX2" fmla="*/ 409651 w 951173"/>
                <a:gd name="connsiteY2" fmla="*/ 205186 h 426823"/>
                <a:gd name="connsiteX3" fmla="*/ 304876 w 951173"/>
                <a:gd name="connsiteY3" fmla="*/ 329011 h 426823"/>
                <a:gd name="connsiteX4" fmla="*/ 295351 w 951173"/>
                <a:gd name="connsiteY4" fmla="*/ 424261 h 426823"/>
                <a:gd name="connsiteX5" fmla="*/ 462038 w 951173"/>
                <a:gd name="connsiteY5" fmla="*/ 224236 h 426823"/>
                <a:gd name="connsiteX6" fmla="*/ 590626 w 951173"/>
                <a:gd name="connsiteY6" fmla="*/ 405211 h 426823"/>
                <a:gd name="connsiteX7" fmla="*/ 547763 w 951173"/>
                <a:gd name="connsiteY7" fmla="*/ 214711 h 426823"/>
                <a:gd name="connsiteX8" fmla="*/ 714451 w 951173"/>
                <a:gd name="connsiteY8" fmla="*/ 348061 h 426823"/>
                <a:gd name="connsiteX9" fmla="*/ 819226 w 951173"/>
                <a:gd name="connsiteY9" fmla="*/ 343298 h 426823"/>
                <a:gd name="connsiteX10" fmla="*/ 723976 w 951173"/>
                <a:gd name="connsiteY10" fmla="*/ 319486 h 426823"/>
                <a:gd name="connsiteX11" fmla="*/ 619201 w 951173"/>
                <a:gd name="connsiteY11" fmla="*/ 219473 h 426823"/>
                <a:gd name="connsiteX12" fmla="*/ 933526 w 951173"/>
                <a:gd name="connsiteY12" fmla="*/ 329011 h 426823"/>
                <a:gd name="connsiteX13" fmla="*/ 909713 w 951173"/>
                <a:gd name="connsiteY13" fmla="*/ 267098 h 426823"/>
                <a:gd name="connsiteX14" fmla="*/ 895426 w 951173"/>
                <a:gd name="connsiteY14" fmla="*/ 271861 h 426823"/>
                <a:gd name="connsiteX15" fmla="*/ 571576 w 951173"/>
                <a:gd name="connsiteY15" fmla="*/ 138511 h 426823"/>
                <a:gd name="connsiteX16" fmla="*/ 690638 w 951173"/>
                <a:gd name="connsiteY16" fmla="*/ 67073 h 426823"/>
                <a:gd name="connsiteX17" fmla="*/ 800176 w 951173"/>
                <a:gd name="connsiteY17" fmla="*/ 76598 h 426823"/>
                <a:gd name="connsiteX18" fmla="*/ 766838 w 951173"/>
                <a:gd name="connsiteY18" fmla="*/ 398 h 426823"/>
                <a:gd name="connsiteX19" fmla="*/ 509663 w 951173"/>
                <a:gd name="connsiteY19" fmla="*/ 114698 h 426823"/>
                <a:gd name="connsiteX20" fmla="*/ 376313 w 951173"/>
                <a:gd name="connsiteY20" fmla="*/ 148036 h 4268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</a:cxnLst>
              <a:rect l="l" t="t" r="r" b="b"/>
              <a:pathLst>
                <a:path w="951173" h="426823">
                  <a:moveTo>
                    <a:pt x="376313" y="148036"/>
                  </a:moveTo>
                  <a:cubicBezTo>
                    <a:pt x="291382" y="182167"/>
                    <a:pt x="-5480" y="309961"/>
                    <a:pt x="76" y="319486"/>
                  </a:cubicBezTo>
                  <a:cubicBezTo>
                    <a:pt x="5632" y="329011"/>
                    <a:pt x="358851" y="203599"/>
                    <a:pt x="409651" y="205186"/>
                  </a:cubicBezTo>
                  <a:cubicBezTo>
                    <a:pt x="460451" y="206774"/>
                    <a:pt x="323926" y="292499"/>
                    <a:pt x="304876" y="329011"/>
                  </a:cubicBezTo>
                  <a:cubicBezTo>
                    <a:pt x="285826" y="365523"/>
                    <a:pt x="269157" y="441723"/>
                    <a:pt x="295351" y="424261"/>
                  </a:cubicBezTo>
                  <a:cubicBezTo>
                    <a:pt x="321545" y="406799"/>
                    <a:pt x="412826" y="227411"/>
                    <a:pt x="462038" y="224236"/>
                  </a:cubicBezTo>
                  <a:cubicBezTo>
                    <a:pt x="511250" y="221061"/>
                    <a:pt x="576339" y="406798"/>
                    <a:pt x="590626" y="405211"/>
                  </a:cubicBezTo>
                  <a:cubicBezTo>
                    <a:pt x="604913" y="403624"/>
                    <a:pt x="527126" y="224236"/>
                    <a:pt x="547763" y="214711"/>
                  </a:cubicBezTo>
                  <a:cubicBezTo>
                    <a:pt x="568400" y="205186"/>
                    <a:pt x="669207" y="326630"/>
                    <a:pt x="714451" y="348061"/>
                  </a:cubicBezTo>
                  <a:cubicBezTo>
                    <a:pt x="759695" y="369492"/>
                    <a:pt x="817639" y="348060"/>
                    <a:pt x="819226" y="343298"/>
                  </a:cubicBezTo>
                  <a:cubicBezTo>
                    <a:pt x="820813" y="338536"/>
                    <a:pt x="757314" y="340124"/>
                    <a:pt x="723976" y="319486"/>
                  </a:cubicBezTo>
                  <a:cubicBezTo>
                    <a:pt x="690639" y="298849"/>
                    <a:pt x="584276" y="217885"/>
                    <a:pt x="619201" y="219473"/>
                  </a:cubicBezTo>
                  <a:cubicBezTo>
                    <a:pt x="654126" y="221061"/>
                    <a:pt x="885107" y="321074"/>
                    <a:pt x="933526" y="329011"/>
                  </a:cubicBezTo>
                  <a:cubicBezTo>
                    <a:pt x="981945" y="336948"/>
                    <a:pt x="916063" y="276623"/>
                    <a:pt x="909713" y="267098"/>
                  </a:cubicBezTo>
                  <a:cubicBezTo>
                    <a:pt x="903363" y="257573"/>
                    <a:pt x="951782" y="293292"/>
                    <a:pt x="895426" y="271861"/>
                  </a:cubicBezTo>
                  <a:cubicBezTo>
                    <a:pt x="839070" y="250430"/>
                    <a:pt x="605707" y="172642"/>
                    <a:pt x="571576" y="138511"/>
                  </a:cubicBezTo>
                  <a:cubicBezTo>
                    <a:pt x="537445" y="104380"/>
                    <a:pt x="652538" y="77392"/>
                    <a:pt x="690638" y="67073"/>
                  </a:cubicBezTo>
                  <a:cubicBezTo>
                    <a:pt x="728738" y="56754"/>
                    <a:pt x="787476" y="87710"/>
                    <a:pt x="800176" y="76598"/>
                  </a:cubicBezTo>
                  <a:cubicBezTo>
                    <a:pt x="812876" y="65486"/>
                    <a:pt x="815257" y="-5952"/>
                    <a:pt x="766838" y="398"/>
                  </a:cubicBezTo>
                  <a:cubicBezTo>
                    <a:pt x="718419" y="6748"/>
                    <a:pt x="574750" y="91679"/>
                    <a:pt x="509663" y="114698"/>
                  </a:cubicBezTo>
                  <a:cubicBezTo>
                    <a:pt x="444576" y="137717"/>
                    <a:pt x="461244" y="113905"/>
                    <a:pt x="376313" y="148036"/>
                  </a:cubicBezTo>
                  <a:close/>
                </a:path>
              </a:pathLst>
            </a:custGeom>
            <a:solidFill>
              <a:srgbClr val="00B05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3" name="Luna 62">
              <a:extLst>
                <a:ext uri="{FF2B5EF4-FFF2-40B4-BE49-F238E27FC236}">
                  <a16:creationId xmlns:a16="http://schemas.microsoft.com/office/drawing/2014/main" id="{60857A2B-FF6B-1F4E-96F3-7F8354C9F232}"/>
                </a:ext>
              </a:extLst>
            </p:cNvPr>
            <p:cNvSpPr/>
            <p:nvPr/>
          </p:nvSpPr>
          <p:spPr>
            <a:xfrm rot="19982958">
              <a:off x="-1248144" y="3031995"/>
              <a:ext cx="152821" cy="217007"/>
            </a:xfrm>
            <a:prstGeom prst="moon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70" name="CasellaDiTesto 69">
            <a:extLst>
              <a:ext uri="{FF2B5EF4-FFF2-40B4-BE49-F238E27FC236}">
                <a16:creationId xmlns:a16="http://schemas.microsoft.com/office/drawing/2014/main" id="{BBF22B15-5337-2C41-BA32-57CACF1D956C}"/>
              </a:ext>
            </a:extLst>
          </p:cNvPr>
          <p:cNvSpPr txBox="1"/>
          <p:nvPr/>
        </p:nvSpPr>
        <p:spPr>
          <a:xfrm rot="16200000">
            <a:off x="-620576" y="6015467"/>
            <a:ext cx="25928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/>
              <a:t>CHL</a:t>
            </a:r>
          </a:p>
        </p:txBody>
      </p:sp>
      <p:sp>
        <p:nvSpPr>
          <p:cNvPr id="71" name="CasellaDiTesto 70">
            <a:extLst>
              <a:ext uri="{FF2B5EF4-FFF2-40B4-BE49-F238E27FC236}">
                <a16:creationId xmlns:a16="http://schemas.microsoft.com/office/drawing/2014/main" id="{68030F6C-E51A-FA46-B401-9309A84DBB3F}"/>
              </a:ext>
            </a:extLst>
          </p:cNvPr>
          <p:cNvSpPr txBox="1"/>
          <p:nvPr/>
        </p:nvSpPr>
        <p:spPr>
          <a:xfrm rot="16200000">
            <a:off x="266375" y="7760354"/>
            <a:ext cx="8189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/>
              <a:t>TOC</a:t>
            </a:r>
          </a:p>
        </p:txBody>
      </p:sp>
      <p:sp>
        <p:nvSpPr>
          <p:cNvPr id="72" name="CasellaDiTesto 71">
            <a:extLst>
              <a:ext uri="{FF2B5EF4-FFF2-40B4-BE49-F238E27FC236}">
                <a16:creationId xmlns:a16="http://schemas.microsoft.com/office/drawing/2014/main" id="{4B1480A7-FBF0-B44F-B813-825245739B98}"/>
              </a:ext>
            </a:extLst>
          </p:cNvPr>
          <p:cNvSpPr txBox="1"/>
          <p:nvPr/>
        </p:nvSpPr>
        <p:spPr>
          <a:xfrm rot="16200000">
            <a:off x="297551" y="8506162"/>
            <a:ext cx="7565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/>
              <a:t>QUI</a:t>
            </a:r>
          </a:p>
        </p:txBody>
      </p:sp>
      <p:sp>
        <p:nvSpPr>
          <p:cNvPr id="6" name="Rettangolo 5">
            <a:extLst>
              <a:ext uri="{FF2B5EF4-FFF2-40B4-BE49-F238E27FC236}">
                <a16:creationId xmlns:a16="http://schemas.microsoft.com/office/drawing/2014/main" id="{5E70B9F7-FC55-82F9-448B-9E58DCAC80BA}"/>
              </a:ext>
            </a:extLst>
          </p:cNvPr>
          <p:cNvSpPr/>
          <p:nvPr/>
        </p:nvSpPr>
        <p:spPr>
          <a:xfrm>
            <a:off x="796952" y="1042989"/>
            <a:ext cx="45720" cy="2082888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9CA8E55B-8B2A-F7F3-2D61-AA26FB5A8E9B}"/>
              </a:ext>
            </a:extLst>
          </p:cNvPr>
          <p:cNvSpPr txBox="1"/>
          <p:nvPr/>
        </p:nvSpPr>
        <p:spPr>
          <a:xfrm rot="16200000">
            <a:off x="-318666" y="2009319"/>
            <a:ext cx="19890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/>
              <a:t>CAR</a:t>
            </a:r>
          </a:p>
        </p:txBody>
      </p: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E31121D9-3846-86B4-D56B-7D7962124C67}"/>
              </a:ext>
            </a:extLst>
          </p:cNvPr>
          <p:cNvSpPr txBox="1"/>
          <p:nvPr/>
        </p:nvSpPr>
        <p:spPr>
          <a:xfrm>
            <a:off x="3907166" y="1315984"/>
            <a:ext cx="2784345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200" b="1" dirty="0">
                <a:latin typeface="Calibri" panose="020F0502020204030204" pitchFamily="34" charset="0"/>
                <a:cs typeface="Calibri" panose="020F0502020204030204" pitchFamily="34" charset="0"/>
              </a:rPr>
              <a:t>Figure S5. </a:t>
            </a:r>
            <a:r>
              <a:rPr lang="it-IT" sz="1200" dirty="0" err="1"/>
              <a:t>Hierarchical</a:t>
            </a:r>
            <a:r>
              <a:rPr lang="it-IT" sz="1200" dirty="0"/>
              <a:t> clustering of </a:t>
            </a:r>
            <a:r>
              <a:rPr lang="it-IT" sz="1200" dirty="0" err="1"/>
              <a:t>carotenoid</a:t>
            </a:r>
            <a:r>
              <a:rPr lang="it-IT" sz="1200" dirty="0"/>
              <a:t>- and </a:t>
            </a:r>
            <a:r>
              <a:rPr lang="it-IT" sz="1200" dirty="0" err="1"/>
              <a:t>isoprenoid-related</a:t>
            </a:r>
            <a:r>
              <a:rPr lang="it-IT" sz="1200" dirty="0"/>
              <a:t> </a:t>
            </a:r>
            <a:r>
              <a:rPr lang="it-IT" sz="1200" dirty="0" err="1"/>
              <a:t>transcript</a:t>
            </a:r>
            <a:r>
              <a:rPr lang="it-IT" sz="1200" dirty="0"/>
              <a:t>/</a:t>
            </a:r>
            <a:r>
              <a:rPr lang="it-IT" sz="1200" dirty="0" err="1"/>
              <a:t>metabolite</a:t>
            </a:r>
            <a:r>
              <a:rPr lang="it-IT" sz="1200" dirty="0"/>
              <a:t> </a:t>
            </a:r>
            <a:r>
              <a:rPr lang="it-IT" sz="1200" dirty="0" err="1"/>
              <a:t>changes</a:t>
            </a:r>
            <a:r>
              <a:rPr lang="it-IT" sz="1200" dirty="0"/>
              <a:t> in tomato </a:t>
            </a:r>
            <a:r>
              <a:rPr lang="it-IT" sz="1200" dirty="0" err="1"/>
              <a:t>mutants</a:t>
            </a:r>
            <a:r>
              <a:rPr lang="it-IT" sz="1200" dirty="0"/>
              <a:t> </a:t>
            </a:r>
            <a:r>
              <a:rPr lang="it-IT" sz="1200" dirty="0" err="1"/>
              <a:t>during</a:t>
            </a:r>
            <a:r>
              <a:rPr lang="it-IT" sz="1200" dirty="0"/>
              <a:t> </a:t>
            </a:r>
            <a:r>
              <a:rPr lang="it-IT" sz="1200" dirty="0" err="1"/>
              <a:t>ripening</a:t>
            </a:r>
            <a:r>
              <a:rPr lang="it-IT" sz="1200" dirty="0"/>
              <a:t>. </a:t>
            </a:r>
            <a:r>
              <a:rPr lang="it-IT" sz="1200" dirty="0" err="1"/>
              <a:t>Integrated</a:t>
            </a:r>
            <a:r>
              <a:rPr lang="it-IT" sz="1200" dirty="0"/>
              <a:t> </a:t>
            </a:r>
            <a:r>
              <a:rPr lang="it-IT" sz="1200" dirty="0" err="1"/>
              <a:t>transcript</a:t>
            </a:r>
            <a:r>
              <a:rPr lang="it-IT" sz="1200" dirty="0"/>
              <a:t> and </a:t>
            </a:r>
            <a:r>
              <a:rPr lang="it-IT" sz="1200" dirty="0" err="1"/>
              <a:t>metabolite</a:t>
            </a:r>
            <a:r>
              <a:rPr lang="it-IT" sz="1200" dirty="0"/>
              <a:t> </a:t>
            </a:r>
            <a:r>
              <a:rPr lang="it-IT" sz="1200" dirty="0" err="1"/>
              <a:t>profiles</a:t>
            </a:r>
            <a:r>
              <a:rPr lang="it-IT" sz="1200" dirty="0"/>
              <a:t> are </a:t>
            </a:r>
            <a:r>
              <a:rPr lang="it-IT" sz="1200" dirty="0" err="1"/>
              <a:t>shown</a:t>
            </a:r>
            <a:r>
              <a:rPr lang="it-IT" sz="1200" dirty="0"/>
              <a:t> </a:t>
            </a:r>
            <a:r>
              <a:rPr lang="it-IT" sz="1200" dirty="0" err="1"/>
              <a:t>as</a:t>
            </a:r>
            <a:r>
              <a:rPr lang="it-IT" sz="1200" dirty="0"/>
              <a:t> </a:t>
            </a:r>
            <a:r>
              <a:rPr lang="it-IT" sz="1200" dirty="0" err="1"/>
              <a:t>heatmaps</a:t>
            </a:r>
            <a:r>
              <a:rPr lang="it-IT" sz="1200" dirty="0"/>
              <a:t>. Carotenoid-</a:t>
            </a:r>
            <a:r>
              <a:rPr lang="it-IT" sz="1200" dirty="0" err="1"/>
              <a:t>related</a:t>
            </a:r>
            <a:r>
              <a:rPr lang="it-IT" sz="1200" dirty="0"/>
              <a:t> </a:t>
            </a:r>
            <a:r>
              <a:rPr lang="it-IT" sz="1200" dirty="0" err="1"/>
              <a:t>transcripts</a:t>
            </a:r>
            <a:r>
              <a:rPr lang="it-IT" sz="1200" dirty="0"/>
              <a:t> </a:t>
            </a:r>
            <a:r>
              <a:rPr lang="it-IT" sz="1200" dirty="0" err="1"/>
              <a:t>were</a:t>
            </a:r>
            <a:r>
              <a:rPr lang="it-IT" sz="1200" dirty="0"/>
              <a:t> </a:t>
            </a:r>
            <a:r>
              <a:rPr lang="it-IT" sz="1200" dirty="0" err="1"/>
              <a:t>quantified</a:t>
            </a:r>
            <a:r>
              <a:rPr lang="it-IT" sz="1200" dirty="0"/>
              <a:t> by </a:t>
            </a:r>
            <a:r>
              <a:rPr lang="it-IT" sz="1200" dirty="0" err="1"/>
              <a:t>qRT</a:t>
            </a:r>
            <a:r>
              <a:rPr lang="it-IT" sz="1200" dirty="0"/>
              <a:t>–PCR, </a:t>
            </a:r>
            <a:r>
              <a:rPr lang="it-IT" sz="1200" dirty="0" err="1"/>
              <a:t>isoprenoid-related</a:t>
            </a:r>
            <a:r>
              <a:rPr lang="it-IT" sz="1200" dirty="0"/>
              <a:t> </a:t>
            </a:r>
            <a:r>
              <a:rPr lang="it-IT" sz="1200" dirty="0" err="1"/>
              <a:t>transcripts</a:t>
            </a:r>
            <a:r>
              <a:rPr lang="it-IT" sz="1200" dirty="0"/>
              <a:t> by </a:t>
            </a:r>
            <a:r>
              <a:rPr lang="it-IT" sz="1200" dirty="0" err="1"/>
              <a:t>Affymetrix</a:t>
            </a:r>
            <a:r>
              <a:rPr lang="it-IT" sz="1200" dirty="0"/>
              <a:t> EU-TOM3 microarrays, and </a:t>
            </a:r>
            <a:r>
              <a:rPr lang="it-IT" sz="1200" dirty="0" err="1"/>
              <a:t>metabolites</a:t>
            </a:r>
            <a:r>
              <a:rPr lang="it-IT" sz="1200" dirty="0"/>
              <a:t> by LC-DAD–APCI–MS. </a:t>
            </a:r>
            <a:r>
              <a:rPr lang="it-IT" sz="1200" dirty="0" err="1"/>
              <a:t>Values</a:t>
            </a:r>
            <a:r>
              <a:rPr lang="it-IT" sz="1200" dirty="0"/>
              <a:t> are </a:t>
            </a:r>
            <a:r>
              <a:rPr lang="it-IT" sz="1200" dirty="0" err="1"/>
              <a:t>expressed</a:t>
            </a:r>
            <a:r>
              <a:rPr lang="it-IT" sz="1200" dirty="0"/>
              <a:t> </a:t>
            </a:r>
            <a:r>
              <a:rPr lang="it-IT" sz="1200" dirty="0" err="1"/>
              <a:t>as</a:t>
            </a:r>
            <a:r>
              <a:rPr lang="it-IT" sz="1200" dirty="0"/>
              <a:t> log2 </a:t>
            </a:r>
            <a:r>
              <a:rPr lang="it-IT" sz="1200" dirty="0" err="1"/>
              <a:t>fold</a:t>
            </a:r>
            <a:r>
              <a:rPr lang="it-IT" sz="1200" dirty="0"/>
              <a:t> </a:t>
            </a:r>
            <a:r>
              <a:rPr lang="it-IT" sz="1200" dirty="0" err="1"/>
              <a:t>change</a:t>
            </a:r>
            <a:r>
              <a:rPr lang="it-IT" sz="1200" dirty="0"/>
              <a:t> relative to the </a:t>
            </a:r>
            <a:r>
              <a:rPr lang="it-IT" sz="1200" dirty="0" err="1"/>
              <a:t>corresponding</a:t>
            </a:r>
            <a:r>
              <a:rPr lang="it-IT" sz="1200" dirty="0"/>
              <a:t> wild </a:t>
            </a:r>
            <a:r>
              <a:rPr lang="it-IT" sz="1200" dirty="0" err="1"/>
              <a:t>type</a:t>
            </a:r>
            <a:r>
              <a:rPr lang="it-IT" sz="1200" dirty="0"/>
              <a:t> (AC for </a:t>
            </a:r>
            <a:r>
              <a:rPr lang="it-IT" sz="1200" dirty="0" err="1"/>
              <a:t>at</a:t>
            </a:r>
            <a:r>
              <a:rPr lang="it-IT" sz="1200" dirty="0"/>
              <a:t>, </a:t>
            </a:r>
            <a:r>
              <a:rPr lang="it-IT" sz="1200" dirty="0" err="1"/>
              <a:t>r</a:t>
            </a:r>
            <a:r>
              <a:rPr lang="it-IT" sz="1200" dirty="0"/>
              <a:t>, t and B; M82 for Del). Red and blue indicate </a:t>
            </a:r>
            <a:r>
              <a:rPr lang="it-IT" sz="1200" dirty="0" err="1"/>
              <a:t>increased</a:t>
            </a:r>
            <a:r>
              <a:rPr lang="it-IT" sz="1200" dirty="0"/>
              <a:t> and </a:t>
            </a:r>
            <a:r>
              <a:rPr lang="it-IT" sz="1200" dirty="0" err="1"/>
              <a:t>decreased</a:t>
            </a:r>
            <a:r>
              <a:rPr lang="it-IT" sz="1200" dirty="0"/>
              <a:t> </a:t>
            </a:r>
            <a:r>
              <a:rPr lang="it-IT" sz="1200" dirty="0" err="1"/>
              <a:t>levels</a:t>
            </a:r>
            <a:r>
              <a:rPr lang="it-IT" sz="1200" dirty="0"/>
              <a:t> vs wild </a:t>
            </a:r>
            <a:r>
              <a:rPr lang="it-IT" sz="1200" dirty="0" err="1"/>
              <a:t>type</a:t>
            </a:r>
            <a:r>
              <a:rPr lang="it-IT" sz="1200" dirty="0"/>
              <a:t>, </a:t>
            </a:r>
            <a:r>
              <a:rPr lang="it-IT" sz="1200" dirty="0" err="1"/>
              <a:t>respectively</a:t>
            </a:r>
            <a:r>
              <a:rPr lang="it-IT" sz="1200" dirty="0"/>
              <a:t>; white </a:t>
            </a:r>
            <a:r>
              <a:rPr lang="it-IT" sz="1200" dirty="0" err="1"/>
              <a:t>indicates</a:t>
            </a:r>
            <a:r>
              <a:rPr lang="it-IT" sz="1200" dirty="0"/>
              <a:t> no </a:t>
            </a:r>
            <a:r>
              <a:rPr lang="it-IT" sz="1200" dirty="0" err="1"/>
              <a:t>change</a:t>
            </a:r>
            <a:r>
              <a:rPr lang="it-IT" sz="1200" dirty="0"/>
              <a:t>; gray </a:t>
            </a:r>
            <a:r>
              <a:rPr lang="it-IT" sz="1200" dirty="0" err="1"/>
              <a:t>indicates</a:t>
            </a:r>
            <a:r>
              <a:rPr lang="it-IT" sz="1200" dirty="0"/>
              <a:t> </a:t>
            </a:r>
            <a:r>
              <a:rPr lang="it-IT" sz="1200" dirty="0" err="1"/>
              <a:t>not</a:t>
            </a:r>
            <a:r>
              <a:rPr lang="it-IT" sz="1200" dirty="0"/>
              <a:t> </a:t>
            </a:r>
            <a:r>
              <a:rPr lang="it-IT" sz="1200" dirty="0" err="1"/>
              <a:t>detected</a:t>
            </a:r>
            <a:r>
              <a:rPr lang="it-IT" sz="1200" dirty="0"/>
              <a:t>. </a:t>
            </a:r>
            <a:r>
              <a:rPr lang="it-IT" sz="1200" dirty="0" err="1"/>
              <a:t>Hierarchical</a:t>
            </a:r>
            <a:r>
              <a:rPr lang="it-IT" sz="1200" dirty="0"/>
              <a:t> clustering </a:t>
            </a:r>
            <a:r>
              <a:rPr lang="it-IT" sz="1200" dirty="0" err="1"/>
              <a:t>was</a:t>
            </a:r>
            <a:r>
              <a:rPr lang="it-IT" sz="1200" dirty="0"/>
              <a:t> </a:t>
            </a:r>
            <a:r>
              <a:rPr lang="it-IT" sz="1200" dirty="0" err="1"/>
              <a:t>applied</a:t>
            </a:r>
            <a:r>
              <a:rPr lang="it-IT" sz="1200" dirty="0"/>
              <a:t> to </a:t>
            </a:r>
            <a:r>
              <a:rPr lang="it-IT" sz="1200" dirty="0" err="1"/>
              <a:t>columns</a:t>
            </a:r>
            <a:r>
              <a:rPr lang="it-IT" sz="1200" dirty="0"/>
              <a:t> </a:t>
            </a:r>
            <a:r>
              <a:rPr lang="it-IT" sz="1200" dirty="0" err="1"/>
              <a:t>using</a:t>
            </a:r>
            <a:r>
              <a:rPr lang="it-IT" sz="1200" dirty="0"/>
              <a:t> Pearson </a:t>
            </a:r>
            <a:r>
              <a:rPr lang="it-IT" sz="1200" dirty="0" err="1"/>
              <a:t>correlation</a:t>
            </a:r>
            <a:r>
              <a:rPr lang="it-IT" sz="1200" dirty="0"/>
              <a:t> and </a:t>
            </a:r>
            <a:r>
              <a:rPr lang="it-IT" sz="1200" dirty="0" err="1"/>
              <a:t>average</a:t>
            </a:r>
            <a:r>
              <a:rPr lang="it-IT" sz="1200" dirty="0"/>
              <a:t> linkage. See </a:t>
            </a:r>
            <a:r>
              <a:rPr lang="it-IT" sz="1200" dirty="0" err="1"/>
              <a:t>Materials</a:t>
            </a:r>
            <a:r>
              <a:rPr lang="it-IT" sz="1200" dirty="0"/>
              <a:t> and Methods for </a:t>
            </a:r>
            <a:r>
              <a:rPr lang="it-IT" sz="1200" dirty="0" err="1"/>
              <a:t>details</a:t>
            </a:r>
            <a:r>
              <a:rPr lang="it-IT" sz="1200" dirty="0"/>
              <a:t>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Immagine 36">
            <a:extLst>
              <a:ext uri="{FF2B5EF4-FFF2-40B4-BE49-F238E27FC236}">
                <a16:creationId xmlns:a16="http://schemas.microsoft.com/office/drawing/2014/main" id="{ECDC6177-EB40-886A-409D-B9CF89B7BC0A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t="29" b="-1"/>
          <a:stretch>
            <a:fillRect/>
          </a:stretch>
        </p:blipFill>
        <p:spPr>
          <a:xfrm>
            <a:off x="1832118" y="369671"/>
            <a:ext cx="1004305" cy="8630610"/>
          </a:xfrm>
          <a:prstGeom prst="rect">
            <a:avLst/>
          </a:prstGeom>
        </p:spPr>
      </p:pic>
      <p:sp>
        <p:nvSpPr>
          <p:cNvPr id="39" name="Rettangolo 38">
            <a:extLst>
              <a:ext uri="{FF2B5EF4-FFF2-40B4-BE49-F238E27FC236}">
                <a16:creationId xmlns:a16="http://schemas.microsoft.com/office/drawing/2014/main" id="{F173B896-75FB-3E1B-D937-C5D25C8F7A2C}"/>
              </a:ext>
            </a:extLst>
          </p:cNvPr>
          <p:cNvSpPr/>
          <p:nvPr/>
        </p:nvSpPr>
        <p:spPr>
          <a:xfrm>
            <a:off x="1807812" y="3849128"/>
            <a:ext cx="45719" cy="956281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9488271B-A211-48EF-747C-6A2CFD40A507}"/>
              </a:ext>
            </a:extLst>
          </p:cNvPr>
          <p:cNvSpPr txBox="1"/>
          <p:nvPr/>
        </p:nvSpPr>
        <p:spPr>
          <a:xfrm rot="16200000">
            <a:off x="1208556" y="4216056"/>
            <a:ext cx="9562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/>
              <a:t>MVA</a:t>
            </a:r>
          </a:p>
        </p:txBody>
      </p:sp>
      <p:sp>
        <p:nvSpPr>
          <p:cNvPr id="43" name="Rettangolo 42">
            <a:extLst>
              <a:ext uri="{FF2B5EF4-FFF2-40B4-BE49-F238E27FC236}">
                <a16:creationId xmlns:a16="http://schemas.microsoft.com/office/drawing/2014/main" id="{FFB5E2A1-B44D-2F21-D7C7-3C6EE30B79DD}"/>
              </a:ext>
            </a:extLst>
          </p:cNvPr>
          <p:cNvSpPr/>
          <p:nvPr/>
        </p:nvSpPr>
        <p:spPr>
          <a:xfrm>
            <a:off x="1807812" y="3112522"/>
            <a:ext cx="45719" cy="733116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4" name="CasellaDiTesto 43">
            <a:extLst>
              <a:ext uri="{FF2B5EF4-FFF2-40B4-BE49-F238E27FC236}">
                <a16:creationId xmlns:a16="http://schemas.microsoft.com/office/drawing/2014/main" id="{464684DD-D697-80DE-481D-8F5C3F161284}"/>
              </a:ext>
            </a:extLst>
          </p:cNvPr>
          <p:cNvSpPr txBox="1"/>
          <p:nvPr/>
        </p:nvSpPr>
        <p:spPr>
          <a:xfrm rot="16200000">
            <a:off x="1320139" y="3371357"/>
            <a:ext cx="7331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/>
              <a:t>MEP</a:t>
            </a:r>
          </a:p>
        </p:txBody>
      </p:sp>
      <p:sp>
        <p:nvSpPr>
          <p:cNvPr id="45" name="Rettangolo 44">
            <a:extLst>
              <a:ext uri="{FF2B5EF4-FFF2-40B4-BE49-F238E27FC236}">
                <a16:creationId xmlns:a16="http://schemas.microsoft.com/office/drawing/2014/main" id="{8D19C4A1-6190-B594-3E7A-367EADA96A53}"/>
              </a:ext>
            </a:extLst>
          </p:cNvPr>
          <p:cNvSpPr/>
          <p:nvPr/>
        </p:nvSpPr>
        <p:spPr>
          <a:xfrm>
            <a:off x="1807812" y="4805408"/>
            <a:ext cx="45719" cy="2592083"/>
          </a:xfrm>
          <a:prstGeom prst="rect">
            <a:avLst/>
          </a:prstGeom>
          <a:solidFill>
            <a:srgbClr val="00B05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8" name="Rettangolo 47">
            <a:extLst>
              <a:ext uri="{FF2B5EF4-FFF2-40B4-BE49-F238E27FC236}">
                <a16:creationId xmlns:a16="http://schemas.microsoft.com/office/drawing/2014/main" id="{03895640-5843-3B8B-FD1C-4279DAD6D97F}"/>
              </a:ext>
            </a:extLst>
          </p:cNvPr>
          <p:cNvSpPr/>
          <p:nvPr/>
        </p:nvSpPr>
        <p:spPr>
          <a:xfrm>
            <a:off x="1807812" y="7397779"/>
            <a:ext cx="45719" cy="864568"/>
          </a:xfrm>
          <a:prstGeom prst="rect">
            <a:avLst/>
          </a:prstGeom>
          <a:solidFill>
            <a:srgbClr val="7030A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9" name="Rettangolo 48">
            <a:extLst>
              <a:ext uri="{FF2B5EF4-FFF2-40B4-BE49-F238E27FC236}">
                <a16:creationId xmlns:a16="http://schemas.microsoft.com/office/drawing/2014/main" id="{E27C4F0C-8380-1E9F-9058-36EF0A79763B}"/>
              </a:ext>
            </a:extLst>
          </p:cNvPr>
          <p:cNvSpPr/>
          <p:nvPr/>
        </p:nvSpPr>
        <p:spPr>
          <a:xfrm>
            <a:off x="1807812" y="8265759"/>
            <a:ext cx="45719" cy="729064"/>
          </a:xfrm>
          <a:prstGeom prst="rect">
            <a:avLst/>
          </a:prstGeom>
          <a:solidFill>
            <a:srgbClr val="CA40B8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4B023257-7E60-FFAD-C873-F0994F795CE1}"/>
              </a:ext>
            </a:extLst>
          </p:cNvPr>
          <p:cNvSpPr txBox="1"/>
          <p:nvPr/>
        </p:nvSpPr>
        <p:spPr>
          <a:xfrm rot="16200000">
            <a:off x="390284" y="5994100"/>
            <a:ext cx="25928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/>
              <a:t>CHL</a:t>
            </a:r>
          </a:p>
        </p:txBody>
      </p:sp>
      <p:sp>
        <p:nvSpPr>
          <p:cNvPr id="64" name="CasellaDiTesto 63">
            <a:extLst>
              <a:ext uri="{FF2B5EF4-FFF2-40B4-BE49-F238E27FC236}">
                <a16:creationId xmlns:a16="http://schemas.microsoft.com/office/drawing/2014/main" id="{E958AC97-5AE0-D60B-9CE5-B049EA0F3755}"/>
              </a:ext>
            </a:extLst>
          </p:cNvPr>
          <p:cNvSpPr txBox="1"/>
          <p:nvPr/>
        </p:nvSpPr>
        <p:spPr>
          <a:xfrm rot="16200000">
            <a:off x="1277235" y="7738987"/>
            <a:ext cx="8189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/>
              <a:t>TOC</a:t>
            </a:r>
          </a:p>
        </p:txBody>
      </p:sp>
      <p:sp>
        <p:nvSpPr>
          <p:cNvPr id="65" name="CasellaDiTesto 64">
            <a:extLst>
              <a:ext uri="{FF2B5EF4-FFF2-40B4-BE49-F238E27FC236}">
                <a16:creationId xmlns:a16="http://schemas.microsoft.com/office/drawing/2014/main" id="{72BA87BB-AB95-796C-0F14-452B6E9AB5B1}"/>
              </a:ext>
            </a:extLst>
          </p:cNvPr>
          <p:cNvSpPr txBox="1"/>
          <p:nvPr/>
        </p:nvSpPr>
        <p:spPr>
          <a:xfrm rot="16200000">
            <a:off x="1308411" y="8484795"/>
            <a:ext cx="7565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/>
              <a:t>QUI</a:t>
            </a:r>
          </a:p>
        </p:txBody>
      </p:sp>
      <p:sp>
        <p:nvSpPr>
          <p:cNvPr id="73" name="Rettangolo 72">
            <a:extLst>
              <a:ext uri="{FF2B5EF4-FFF2-40B4-BE49-F238E27FC236}">
                <a16:creationId xmlns:a16="http://schemas.microsoft.com/office/drawing/2014/main" id="{C625A1D3-C063-8A8A-C811-F329DBA61B8C}"/>
              </a:ext>
            </a:extLst>
          </p:cNvPr>
          <p:cNvSpPr/>
          <p:nvPr/>
        </p:nvSpPr>
        <p:spPr>
          <a:xfrm>
            <a:off x="1807812" y="1042988"/>
            <a:ext cx="45719" cy="2061521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4" name="CasellaDiTesto 73">
            <a:extLst>
              <a:ext uri="{FF2B5EF4-FFF2-40B4-BE49-F238E27FC236}">
                <a16:creationId xmlns:a16="http://schemas.microsoft.com/office/drawing/2014/main" id="{C6BA5657-4D42-CB5E-1EF6-4381A5CEB5CE}"/>
              </a:ext>
            </a:extLst>
          </p:cNvPr>
          <p:cNvSpPr txBox="1"/>
          <p:nvPr/>
        </p:nvSpPr>
        <p:spPr>
          <a:xfrm rot="16200000">
            <a:off x="692194" y="1987952"/>
            <a:ext cx="19890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/>
              <a:t>CAR</a:t>
            </a:r>
          </a:p>
        </p:txBody>
      </p:sp>
      <p:sp>
        <p:nvSpPr>
          <p:cNvPr id="89" name="Rettangolo 88">
            <a:extLst>
              <a:ext uri="{FF2B5EF4-FFF2-40B4-BE49-F238E27FC236}">
                <a16:creationId xmlns:a16="http://schemas.microsoft.com/office/drawing/2014/main" id="{EE774F1A-C8F7-788E-2185-ED31804E1B9C}"/>
              </a:ext>
            </a:extLst>
          </p:cNvPr>
          <p:cNvSpPr/>
          <p:nvPr/>
        </p:nvSpPr>
        <p:spPr>
          <a:xfrm>
            <a:off x="2873611" y="3849128"/>
            <a:ext cx="45719" cy="956281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0" name="CasellaDiTesto 89">
            <a:extLst>
              <a:ext uri="{FF2B5EF4-FFF2-40B4-BE49-F238E27FC236}">
                <a16:creationId xmlns:a16="http://schemas.microsoft.com/office/drawing/2014/main" id="{4C8A1509-C898-A843-5E9A-97B89C50C4C8}"/>
              </a:ext>
            </a:extLst>
          </p:cNvPr>
          <p:cNvSpPr txBox="1"/>
          <p:nvPr/>
        </p:nvSpPr>
        <p:spPr>
          <a:xfrm rot="16200000">
            <a:off x="2274355" y="4216056"/>
            <a:ext cx="9562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/>
              <a:t>MVA</a:t>
            </a:r>
          </a:p>
        </p:txBody>
      </p:sp>
      <p:sp>
        <p:nvSpPr>
          <p:cNvPr id="91" name="Rettangolo 90">
            <a:extLst>
              <a:ext uri="{FF2B5EF4-FFF2-40B4-BE49-F238E27FC236}">
                <a16:creationId xmlns:a16="http://schemas.microsoft.com/office/drawing/2014/main" id="{83113141-FF20-D3F6-45F5-D54724A136BE}"/>
              </a:ext>
            </a:extLst>
          </p:cNvPr>
          <p:cNvSpPr/>
          <p:nvPr/>
        </p:nvSpPr>
        <p:spPr>
          <a:xfrm>
            <a:off x="2873611" y="3112522"/>
            <a:ext cx="45719" cy="733116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2" name="CasellaDiTesto 91">
            <a:extLst>
              <a:ext uri="{FF2B5EF4-FFF2-40B4-BE49-F238E27FC236}">
                <a16:creationId xmlns:a16="http://schemas.microsoft.com/office/drawing/2014/main" id="{ED89A797-14A6-61A3-D59D-1B6C31F0F8E3}"/>
              </a:ext>
            </a:extLst>
          </p:cNvPr>
          <p:cNvSpPr txBox="1"/>
          <p:nvPr/>
        </p:nvSpPr>
        <p:spPr>
          <a:xfrm rot="16200000">
            <a:off x="2385938" y="3371357"/>
            <a:ext cx="7331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/>
              <a:t>MEP</a:t>
            </a:r>
          </a:p>
        </p:txBody>
      </p:sp>
      <p:sp>
        <p:nvSpPr>
          <p:cNvPr id="93" name="Rettangolo 92">
            <a:extLst>
              <a:ext uri="{FF2B5EF4-FFF2-40B4-BE49-F238E27FC236}">
                <a16:creationId xmlns:a16="http://schemas.microsoft.com/office/drawing/2014/main" id="{C08FFABE-9BE3-E620-49C6-2B052A39AA4C}"/>
              </a:ext>
            </a:extLst>
          </p:cNvPr>
          <p:cNvSpPr/>
          <p:nvPr/>
        </p:nvSpPr>
        <p:spPr>
          <a:xfrm>
            <a:off x="2873611" y="4805408"/>
            <a:ext cx="45719" cy="2592083"/>
          </a:xfrm>
          <a:prstGeom prst="rect">
            <a:avLst/>
          </a:prstGeom>
          <a:solidFill>
            <a:srgbClr val="00B05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4" name="Rettangolo 93">
            <a:extLst>
              <a:ext uri="{FF2B5EF4-FFF2-40B4-BE49-F238E27FC236}">
                <a16:creationId xmlns:a16="http://schemas.microsoft.com/office/drawing/2014/main" id="{B5A9E694-F859-FD1E-0D9F-615703E0C2E7}"/>
              </a:ext>
            </a:extLst>
          </p:cNvPr>
          <p:cNvSpPr/>
          <p:nvPr/>
        </p:nvSpPr>
        <p:spPr>
          <a:xfrm>
            <a:off x="2873611" y="7397779"/>
            <a:ext cx="45719" cy="864568"/>
          </a:xfrm>
          <a:prstGeom prst="rect">
            <a:avLst/>
          </a:prstGeom>
          <a:solidFill>
            <a:srgbClr val="7030A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5" name="Rettangolo 94">
            <a:extLst>
              <a:ext uri="{FF2B5EF4-FFF2-40B4-BE49-F238E27FC236}">
                <a16:creationId xmlns:a16="http://schemas.microsoft.com/office/drawing/2014/main" id="{FB183ACB-ECAC-D001-9120-E83FEB4F367B}"/>
              </a:ext>
            </a:extLst>
          </p:cNvPr>
          <p:cNvSpPr/>
          <p:nvPr/>
        </p:nvSpPr>
        <p:spPr>
          <a:xfrm>
            <a:off x="2873611" y="8265759"/>
            <a:ext cx="45719" cy="729064"/>
          </a:xfrm>
          <a:prstGeom prst="rect">
            <a:avLst/>
          </a:prstGeom>
          <a:solidFill>
            <a:srgbClr val="CA40B8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6" name="CasellaDiTesto 95">
            <a:extLst>
              <a:ext uri="{FF2B5EF4-FFF2-40B4-BE49-F238E27FC236}">
                <a16:creationId xmlns:a16="http://schemas.microsoft.com/office/drawing/2014/main" id="{E7160BC6-19D1-8442-9C72-2AD498348CC0}"/>
              </a:ext>
            </a:extLst>
          </p:cNvPr>
          <p:cNvSpPr txBox="1"/>
          <p:nvPr/>
        </p:nvSpPr>
        <p:spPr>
          <a:xfrm rot="16200000">
            <a:off x="1456083" y="5994100"/>
            <a:ext cx="25928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/>
              <a:t>CHL</a:t>
            </a:r>
          </a:p>
        </p:txBody>
      </p:sp>
      <p:sp>
        <p:nvSpPr>
          <p:cNvPr id="97" name="CasellaDiTesto 96">
            <a:extLst>
              <a:ext uri="{FF2B5EF4-FFF2-40B4-BE49-F238E27FC236}">
                <a16:creationId xmlns:a16="http://schemas.microsoft.com/office/drawing/2014/main" id="{29F65DE9-10A2-3513-B2B0-A3A585876AB7}"/>
              </a:ext>
            </a:extLst>
          </p:cNvPr>
          <p:cNvSpPr txBox="1"/>
          <p:nvPr/>
        </p:nvSpPr>
        <p:spPr>
          <a:xfrm rot="16200000">
            <a:off x="2343034" y="7738987"/>
            <a:ext cx="8189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/>
              <a:t>TOC</a:t>
            </a:r>
          </a:p>
        </p:txBody>
      </p:sp>
      <p:sp>
        <p:nvSpPr>
          <p:cNvPr id="98" name="CasellaDiTesto 97">
            <a:extLst>
              <a:ext uri="{FF2B5EF4-FFF2-40B4-BE49-F238E27FC236}">
                <a16:creationId xmlns:a16="http://schemas.microsoft.com/office/drawing/2014/main" id="{527D1478-AEA9-60AB-78A0-3DBFBA9ABB36}"/>
              </a:ext>
            </a:extLst>
          </p:cNvPr>
          <p:cNvSpPr txBox="1"/>
          <p:nvPr/>
        </p:nvSpPr>
        <p:spPr>
          <a:xfrm rot="16200000">
            <a:off x="2374210" y="8484795"/>
            <a:ext cx="7565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/>
              <a:t>QUI</a:t>
            </a:r>
          </a:p>
        </p:txBody>
      </p:sp>
      <p:sp>
        <p:nvSpPr>
          <p:cNvPr id="99" name="Rettangolo 98">
            <a:extLst>
              <a:ext uri="{FF2B5EF4-FFF2-40B4-BE49-F238E27FC236}">
                <a16:creationId xmlns:a16="http://schemas.microsoft.com/office/drawing/2014/main" id="{7DE3A146-0C76-2A63-96A1-4B083C250B8A}"/>
              </a:ext>
            </a:extLst>
          </p:cNvPr>
          <p:cNvSpPr/>
          <p:nvPr/>
        </p:nvSpPr>
        <p:spPr>
          <a:xfrm>
            <a:off x="2873611" y="1042988"/>
            <a:ext cx="45719" cy="2061521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00" name="CasellaDiTesto 99">
            <a:extLst>
              <a:ext uri="{FF2B5EF4-FFF2-40B4-BE49-F238E27FC236}">
                <a16:creationId xmlns:a16="http://schemas.microsoft.com/office/drawing/2014/main" id="{EF9C497F-90D0-EB99-396A-69D805F19C4C}"/>
              </a:ext>
            </a:extLst>
          </p:cNvPr>
          <p:cNvSpPr txBox="1"/>
          <p:nvPr/>
        </p:nvSpPr>
        <p:spPr>
          <a:xfrm rot="16200000">
            <a:off x="1757993" y="1987952"/>
            <a:ext cx="19890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/>
              <a:t>CAR</a:t>
            </a:r>
          </a:p>
        </p:txBody>
      </p:sp>
    </p:spTree>
    <p:extLst>
      <p:ext uri="{BB962C8B-B14F-4D97-AF65-F5344CB8AC3E}">
        <p14:creationId xmlns:p14="http://schemas.microsoft.com/office/powerpoint/2010/main" val="91712978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2592</TotalTime>
  <Words>1030</Words>
  <Application>Microsoft Macintosh PowerPoint</Application>
  <PresentationFormat>Presentazione su schermo (4:3)</PresentationFormat>
  <Paragraphs>188</Paragraphs>
  <Slides>5</Slides>
  <Notes>3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9" baseType="lpstr">
      <vt:lpstr>American Typewriter</vt:lpstr>
      <vt:lpstr>Arial</vt:lpstr>
      <vt:lpstr>Calibri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Sarah Frusciante</dc:creator>
  <cp:lastModifiedBy>sarah frusciante</cp:lastModifiedBy>
  <cp:revision>501</cp:revision>
  <dcterms:created xsi:type="dcterms:W3CDTF">2014-08-29T16:05:41Z</dcterms:created>
  <dcterms:modified xsi:type="dcterms:W3CDTF">2026-03-25T13:17:43Z</dcterms:modified>
</cp:coreProperties>
</file>